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7"/>
  </p:notesMasterIdLst>
  <p:sldIdLst>
    <p:sldId id="262" r:id="rId2"/>
    <p:sldId id="256" r:id="rId3"/>
    <p:sldId id="257" r:id="rId4"/>
    <p:sldId id="263" r:id="rId5"/>
    <p:sldId id="264" r:id="rId6"/>
    <p:sldId id="265" r:id="rId7"/>
    <p:sldId id="266" r:id="rId8"/>
    <p:sldId id="267" r:id="rId9"/>
    <p:sldId id="268" r:id="rId10"/>
    <p:sldId id="269" r:id="rId11"/>
    <p:sldId id="270" r:id="rId12"/>
    <p:sldId id="271" r:id="rId13"/>
    <p:sldId id="272" r:id="rId14"/>
    <p:sldId id="273" r:id="rId15"/>
    <p:sldId id="274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E2AC092-3BA5-4E00-A94D-19F3A4DF3C5B}" v="191" dt="2024-12-22T08:39:16.36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20" d="100"/>
          <a:sy n="120" d="100"/>
        </p:scale>
        <p:origin x="19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microsoft.com/office/2015/10/relationships/revisionInfo" Target="revisionInfo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-Karin Hardie Olsen" userId="e320bee9-3c44-4263-bfad-c0288f2c0ec5" providerId="ADAL" clId="{2E2AC092-3BA5-4E00-A94D-19F3A4DF3C5B}"/>
    <pc:docChg chg="custSel modSld">
      <pc:chgData name="Ann-Karin Hardie Olsen" userId="e320bee9-3c44-4263-bfad-c0288f2c0ec5" providerId="ADAL" clId="{2E2AC092-3BA5-4E00-A94D-19F3A4DF3C5B}" dt="2024-12-22T09:07:04.166" v="1026" actId="20577"/>
      <pc:docMkLst>
        <pc:docMk/>
      </pc:docMkLst>
      <pc:sldChg chg="addSp delSp modSp mod">
        <pc:chgData name="Ann-Karin Hardie Olsen" userId="e320bee9-3c44-4263-bfad-c0288f2c0ec5" providerId="ADAL" clId="{2E2AC092-3BA5-4E00-A94D-19F3A4DF3C5B}" dt="2024-12-22T09:07:04.166" v="1026" actId="20577"/>
        <pc:sldMkLst>
          <pc:docMk/>
          <pc:sldMk cId="4225952153" sldId="256"/>
        </pc:sldMkLst>
        <pc:spChg chg="add mod">
          <ac:chgData name="Ann-Karin Hardie Olsen" userId="e320bee9-3c44-4263-bfad-c0288f2c0ec5" providerId="ADAL" clId="{2E2AC092-3BA5-4E00-A94D-19F3A4DF3C5B}" dt="2024-12-22T09:07:04.166" v="1026" actId="20577"/>
          <ac:spMkLst>
            <pc:docMk/>
            <pc:sldMk cId="4225952153" sldId="256"/>
            <ac:spMk id="2" creationId="{6C21E296-5A5C-DCF8-CF3B-E65BE009DD67}"/>
          </ac:spMkLst>
        </pc:spChg>
        <pc:spChg chg="add mod">
          <ac:chgData name="Ann-Karin Hardie Olsen" userId="e320bee9-3c44-4263-bfad-c0288f2c0ec5" providerId="ADAL" clId="{2E2AC092-3BA5-4E00-A94D-19F3A4DF3C5B}" dt="2024-12-22T07:43:05.590" v="54" actId="207"/>
          <ac:spMkLst>
            <pc:docMk/>
            <pc:sldMk cId="4225952153" sldId="256"/>
            <ac:spMk id="3" creationId="{C7D504F2-A136-02D5-A423-51A34E6D4BC9}"/>
          </ac:spMkLst>
        </pc:spChg>
        <pc:spChg chg="del">
          <ac:chgData name="Ann-Karin Hardie Olsen" userId="e320bee9-3c44-4263-bfad-c0288f2c0ec5" providerId="ADAL" clId="{2E2AC092-3BA5-4E00-A94D-19F3A4DF3C5B}" dt="2024-12-22T07:42:35.162" v="51" actId="478"/>
          <ac:spMkLst>
            <pc:docMk/>
            <pc:sldMk cId="4225952153" sldId="256"/>
            <ac:spMk id="5" creationId="{C6E597D9-D255-D61C-515B-2030D28926E0}"/>
          </ac:spMkLst>
        </pc:spChg>
        <pc:spChg chg="mod">
          <ac:chgData name="Ann-Karin Hardie Olsen" userId="e320bee9-3c44-4263-bfad-c0288f2c0ec5" providerId="ADAL" clId="{2E2AC092-3BA5-4E00-A94D-19F3A4DF3C5B}" dt="2024-12-22T07:41:42.127" v="48" actId="20577"/>
          <ac:spMkLst>
            <pc:docMk/>
            <pc:sldMk cId="4225952153" sldId="256"/>
            <ac:spMk id="6" creationId="{7ECC5CA3-38FE-85B3-E77A-622D5E2D2088}"/>
          </ac:spMkLst>
        </pc:spChg>
        <pc:spChg chg="add mod">
          <ac:chgData name="Ann-Karin Hardie Olsen" userId="e320bee9-3c44-4263-bfad-c0288f2c0ec5" providerId="ADAL" clId="{2E2AC092-3BA5-4E00-A94D-19F3A4DF3C5B}" dt="2024-12-22T07:43:20.987" v="56" actId="1076"/>
          <ac:spMkLst>
            <pc:docMk/>
            <pc:sldMk cId="4225952153" sldId="256"/>
            <ac:spMk id="7" creationId="{EC0C9142-DA3B-1671-02F1-F13892DEEF13}"/>
          </ac:spMkLst>
        </pc:spChg>
        <pc:spChg chg="add mod">
          <ac:chgData name="Ann-Karin Hardie Olsen" userId="e320bee9-3c44-4263-bfad-c0288f2c0ec5" providerId="ADAL" clId="{2E2AC092-3BA5-4E00-A94D-19F3A4DF3C5B}" dt="2024-12-22T07:43:29.051" v="58" actId="1076"/>
          <ac:spMkLst>
            <pc:docMk/>
            <pc:sldMk cId="4225952153" sldId="256"/>
            <ac:spMk id="9" creationId="{0C23A8EA-C4DE-6D64-E548-41542E98DCE9}"/>
          </ac:spMkLst>
        </pc:spChg>
        <pc:spChg chg="mod">
          <ac:chgData name="Ann-Karin Hardie Olsen" userId="e320bee9-3c44-4263-bfad-c0288f2c0ec5" providerId="ADAL" clId="{2E2AC092-3BA5-4E00-A94D-19F3A4DF3C5B}" dt="2024-12-22T07:46:44.863" v="162"/>
          <ac:spMkLst>
            <pc:docMk/>
            <pc:sldMk cId="4225952153" sldId="256"/>
            <ac:spMk id="38" creationId="{77099841-A197-450E-9468-1DB527C5D8F9}"/>
          </ac:spMkLst>
        </pc:spChg>
      </pc:sldChg>
      <pc:sldChg chg="addSp modSp mod">
        <pc:chgData name="Ann-Karin Hardie Olsen" userId="e320bee9-3c44-4263-bfad-c0288f2c0ec5" providerId="ADAL" clId="{2E2AC092-3BA5-4E00-A94D-19F3A4DF3C5B}" dt="2024-12-22T08:09:00.081" v="457" actId="207"/>
        <pc:sldMkLst>
          <pc:docMk/>
          <pc:sldMk cId="25147243" sldId="257"/>
        </pc:sldMkLst>
        <pc:spChg chg="add mod">
          <ac:chgData name="Ann-Karin Hardie Olsen" userId="e320bee9-3c44-4263-bfad-c0288f2c0ec5" providerId="ADAL" clId="{2E2AC092-3BA5-4E00-A94D-19F3A4DF3C5B}" dt="2024-12-22T08:09:00.081" v="457" actId="207"/>
          <ac:spMkLst>
            <pc:docMk/>
            <pc:sldMk cId="25147243" sldId="257"/>
            <ac:spMk id="8" creationId="{44C6B3E2-17F2-4BBE-F8DD-781434706FCC}"/>
          </ac:spMkLst>
        </pc:spChg>
        <pc:spChg chg="add mod">
          <ac:chgData name="Ann-Karin Hardie Olsen" userId="e320bee9-3c44-4263-bfad-c0288f2c0ec5" providerId="ADAL" clId="{2E2AC092-3BA5-4E00-A94D-19F3A4DF3C5B}" dt="2024-12-22T08:04:17.157" v="412" actId="20577"/>
          <ac:spMkLst>
            <pc:docMk/>
            <pc:sldMk cId="25147243" sldId="257"/>
            <ac:spMk id="12" creationId="{631AE128-B824-6A55-B485-8AF9529980B1}"/>
          </ac:spMkLst>
        </pc:spChg>
        <pc:spChg chg="add mod">
          <ac:chgData name="Ann-Karin Hardie Olsen" userId="e320bee9-3c44-4263-bfad-c0288f2c0ec5" providerId="ADAL" clId="{2E2AC092-3BA5-4E00-A94D-19F3A4DF3C5B}" dt="2024-12-22T08:00:47.462" v="377" actId="1036"/>
          <ac:spMkLst>
            <pc:docMk/>
            <pc:sldMk cId="25147243" sldId="257"/>
            <ac:spMk id="13" creationId="{64A6C2B8-E8F2-5B9C-6903-9097F78CBBA0}"/>
          </ac:spMkLst>
        </pc:spChg>
        <pc:cxnChg chg="mod">
          <ac:chgData name="Ann-Karin Hardie Olsen" userId="e320bee9-3c44-4263-bfad-c0288f2c0ec5" providerId="ADAL" clId="{2E2AC092-3BA5-4E00-A94D-19F3A4DF3C5B}" dt="2024-12-22T08:08:43.569" v="450" actId="208"/>
          <ac:cxnSpMkLst>
            <pc:docMk/>
            <pc:sldMk cId="25147243" sldId="257"/>
            <ac:cxnSpMk id="2" creationId="{0A500ACE-200B-DBB0-2588-5C61AD62CD41}"/>
          </ac:cxnSpMkLst>
        </pc:cxnChg>
        <pc:cxnChg chg="mod">
          <ac:chgData name="Ann-Karin Hardie Olsen" userId="e320bee9-3c44-4263-bfad-c0288f2c0ec5" providerId="ADAL" clId="{2E2AC092-3BA5-4E00-A94D-19F3A4DF3C5B}" dt="2024-12-22T08:08:43.569" v="450" actId="208"/>
          <ac:cxnSpMkLst>
            <pc:docMk/>
            <pc:sldMk cId="25147243" sldId="257"/>
            <ac:cxnSpMk id="3" creationId="{8BC5AFF7-F75D-86E9-77D9-656BE28CAF48}"/>
          </ac:cxnSpMkLst>
        </pc:cxnChg>
        <pc:cxnChg chg="mod">
          <ac:chgData name="Ann-Karin Hardie Olsen" userId="e320bee9-3c44-4263-bfad-c0288f2c0ec5" providerId="ADAL" clId="{2E2AC092-3BA5-4E00-A94D-19F3A4DF3C5B}" dt="2024-12-22T08:08:43.569" v="450" actId="208"/>
          <ac:cxnSpMkLst>
            <pc:docMk/>
            <pc:sldMk cId="25147243" sldId="257"/>
            <ac:cxnSpMk id="4" creationId="{3ED11DAE-2D5E-38A1-A039-E23AC7E9EF8B}"/>
          </ac:cxnSpMkLst>
        </pc:cxnChg>
        <pc:cxnChg chg="mod">
          <ac:chgData name="Ann-Karin Hardie Olsen" userId="e320bee9-3c44-4263-bfad-c0288f2c0ec5" providerId="ADAL" clId="{2E2AC092-3BA5-4E00-A94D-19F3A4DF3C5B}" dt="2024-12-22T08:08:43.569" v="450" actId="208"/>
          <ac:cxnSpMkLst>
            <pc:docMk/>
            <pc:sldMk cId="25147243" sldId="257"/>
            <ac:cxnSpMk id="7" creationId="{659DC89E-F6BE-7499-C181-ED6E5F4EC8CF}"/>
          </ac:cxnSpMkLst>
        </pc:cxnChg>
        <pc:cxnChg chg="add mod">
          <ac:chgData name="Ann-Karin Hardie Olsen" userId="e320bee9-3c44-4263-bfad-c0288f2c0ec5" providerId="ADAL" clId="{2E2AC092-3BA5-4E00-A94D-19F3A4DF3C5B}" dt="2024-12-22T07:57:10.243" v="270"/>
          <ac:cxnSpMkLst>
            <pc:docMk/>
            <pc:sldMk cId="25147243" sldId="257"/>
            <ac:cxnSpMk id="9" creationId="{74E2897D-47A8-7D53-F9F6-B600014842CA}"/>
          </ac:cxnSpMkLst>
        </pc:cxnChg>
        <pc:cxnChg chg="add mod">
          <ac:chgData name="Ann-Karin Hardie Olsen" userId="e320bee9-3c44-4263-bfad-c0288f2c0ec5" providerId="ADAL" clId="{2E2AC092-3BA5-4E00-A94D-19F3A4DF3C5B}" dt="2024-12-22T07:58:00.794" v="276" actId="1076"/>
          <ac:cxnSpMkLst>
            <pc:docMk/>
            <pc:sldMk cId="25147243" sldId="257"/>
            <ac:cxnSpMk id="10" creationId="{08B52B65-3521-2458-F8FE-CC01C3067A97}"/>
          </ac:cxnSpMkLst>
        </pc:cxnChg>
        <pc:cxnChg chg="add mod">
          <ac:chgData name="Ann-Karin Hardie Olsen" userId="e320bee9-3c44-4263-bfad-c0288f2c0ec5" providerId="ADAL" clId="{2E2AC092-3BA5-4E00-A94D-19F3A4DF3C5B}" dt="2024-12-22T08:00:47.462" v="377" actId="1036"/>
          <ac:cxnSpMkLst>
            <pc:docMk/>
            <pc:sldMk cId="25147243" sldId="257"/>
            <ac:cxnSpMk id="14" creationId="{B0EC6BB0-EA07-280D-1E9F-7075998894D4}"/>
          </ac:cxnSpMkLst>
        </pc:cxnChg>
        <pc:cxnChg chg="add mod">
          <ac:chgData name="Ann-Karin Hardie Olsen" userId="e320bee9-3c44-4263-bfad-c0288f2c0ec5" providerId="ADAL" clId="{2E2AC092-3BA5-4E00-A94D-19F3A4DF3C5B}" dt="2024-12-22T08:00:27.730" v="373" actId="14100"/>
          <ac:cxnSpMkLst>
            <pc:docMk/>
            <pc:sldMk cId="25147243" sldId="257"/>
            <ac:cxnSpMk id="17" creationId="{44132A9C-789F-32EB-EE04-1ADE7641DDE2}"/>
          </ac:cxnSpMkLst>
        </pc:cxnChg>
      </pc:sldChg>
      <pc:sldChg chg="modSp mod">
        <pc:chgData name="Ann-Karin Hardie Olsen" userId="e320bee9-3c44-4263-bfad-c0288f2c0ec5" providerId="ADAL" clId="{2E2AC092-3BA5-4E00-A94D-19F3A4DF3C5B}" dt="2024-12-22T07:39:47.840" v="3" actId="20577"/>
        <pc:sldMkLst>
          <pc:docMk/>
          <pc:sldMk cId="3796257797" sldId="262"/>
        </pc:sldMkLst>
        <pc:spChg chg="mod">
          <ac:chgData name="Ann-Karin Hardie Olsen" userId="e320bee9-3c44-4263-bfad-c0288f2c0ec5" providerId="ADAL" clId="{2E2AC092-3BA5-4E00-A94D-19F3A4DF3C5B}" dt="2024-12-22T07:39:47.840" v="3" actId="20577"/>
          <ac:spMkLst>
            <pc:docMk/>
            <pc:sldMk cId="3796257797" sldId="262"/>
            <ac:spMk id="2" creationId="{E1C6E756-B19F-40C5-2E2C-15C32AF2D2AF}"/>
          </ac:spMkLst>
        </pc:spChg>
      </pc:sldChg>
      <pc:sldChg chg="addSp delSp modSp mod">
        <pc:chgData name="Ann-Karin Hardie Olsen" userId="e320bee9-3c44-4263-bfad-c0288f2c0ec5" providerId="ADAL" clId="{2E2AC092-3BA5-4E00-A94D-19F3A4DF3C5B}" dt="2024-12-22T08:10:12.393" v="473" actId="208"/>
        <pc:sldMkLst>
          <pc:docMk/>
          <pc:sldMk cId="780794616" sldId="263"/>
        </pc:sldMkLst>
        <pc:spChg chg="add del mod">
          <ac:chgData name="Ann-Karin Hardie Olsen" userId="e320bee9-3c44-4263-bfad-c0288f2c0ec5" providerId="ADAL" clId="{2E2AC092-3BA5-4E00-A94D-19F3A4DF3C5B}" dt="2024-12-22T08:09:11.425" v="459" actId="478"/>
          <ac:spMkLst>
            <pc:docMk/>
            <pc:sldMk cId="780794616" sldId="263"/>
            <ac:spMk id="11" creationId="{4CBABD97-E3C6-D982-0C3D-00C27332C193}"/>
          </ac:spMkLst>
        </pc:spChg>
        <pc:spChg chg="add mod">
          <ac:chgData name="Ann-Karin Hardie Olsen" userId="e320bee9-3c44-4263-bfad-c0288f2c0ec5" providerId="ADAL" clId="{2E2AC092-3BA5-4E00-A94D-19F3A4DF3C5B}" dt="2024-12-22T08:03:31.140" v="400" actId="1076"/>
          <ac:spMkLst>
            <pc:docMk/>
            <pc:sldMk cId="780794616" sldId="263"/>
            <ac:spMk id="14" creationId="{740A6FD8-EA06-7921-7A0E-FBE1E374BC56}"/>
          </ac:spMkLst>
        </pc:spChg>
        <pc:spChg chg="add mod">
          <ac:chgData name="Ann-Karin Hardie Olsen" userId="e320bee9-3c44-4263-bfad-c0288f2c0ec5" providerId="ADAL" clId="{2E2AC092-3BA5-4E00-A94D-19F3A4DF3C5B}" dt="2024-12-22T08:04:06.675" v="409" actId="6549"/>
          <ac:spMkLst>
            <pc:docMk/>
            <pc:sldMk cId="780794616" sldId="263"/>
            <ac:spMk id="15" creationId="{16F94796-5AF2-C186-7C66-C6F986ADD5BE}"/>
          </ac:spMkLst>
        </pc:spChg>
        <pc:spChg chg="add mod">
          <ac:chgData name="Ann-Karin Hardie Olsen" userId="e320bee9-3c44-4263-bfad-c0288f2c0ec5" providerId="ADAL" clId="{2E2AC092-3BA5-4E00-A94D-19F3A4DF3C5B}" dt="2024-12-22T08:02:48.556" v="393" actId="1076"/>
          <ac:spMkLst>
            <pc:docMk/>
            <pc:sldMk cId="780794616" sldId="263"/>
            <ac:spMk id="18" creationId="{6181CBE9-64E5-EC95-EB22-A7372F312E84}"/>
          </ac:spMkLst>
        </pc:spChg>
        <pc:spChg chg="add mod">
          <ac:chgData name="Ann-Karin Hardie Olsen" userId="e320bee9-3c44-4263-bfad-c0288f2c0ec5" providerId="ADAL" clId="{2E2AC092-3BA5-4E00-A94D-19F3A4DF3C5B}" dt="2024-12-22T08:09:06.914" v="458"/>
          <ac:spMkLst>
            <pc:docMk/>
            <pc:sldMk cId="780794616" sldId="263"/>
            <ac:spMk id="26" creationId="{6723D157-6540-FE36-BBA1-62A582286A40}"/>
          </ac:spMkLst>
        </pc:spChg>
        <pc:spChg chg="add mod">
          <ac:chgData name="Ann-Karin Hardie Olsen" userId="e320bee9-3c44-4263-bfad-c0288f2c0ec5" providerId="ADAL" clId="{2E2AC092-3BA5-4E00-A94D-19F3A4DF3C5B}" dt="2024-12-22T08:09:12.425" v="460"/>
          <ac:spMkLst>
            <pc:docMk/>
            <pc:sldMk cId="780794616" sldId="263"/>
            <ac:spMk id="27" creationId="{E060D945-FC2C-C391-3732-D463AE3B742F}"/>
          </ac:spMkLst>
        </pc:spChg>
        <pc:cxnChg chg="mod">
          <ac:chgData name="Ann-Karin Hardie Olsen" userId="e320bee9-3c44-4263-bfad-c0288f2c0ec5" providerId="ADAL" clId="{2E2AC092-3BA5-4E00-A94D-19F3A4DF3C5B}" dt="2024-12-22T08:10:12.393" v="473" actId="208"/>
          <ac:cxnSpMkLst>
            <pc:docMk/>
            <pc:sldMk cId="780794616" sldId="263"/>
            <ac:cxnSpMk id="3" creationId="{B6D2C0EA-6C7C-7304-2FB7-2410C32547EA}"/>
          </ac:cxnSpMkLst>
        </pc:cxnChg>
        <pc:cxnChg chg="mod">
          <ac:chgData name="Ann-Karin Hardie Olsen" userId="e320bee9-3c44-4263-bfad-c0288f2c0ec5" providerId="ADAL" clId="{2E2AC092-3BA5-4E00-A94D-19F3A4DF3C5B}" dt="2024-12-22T08:10:12.393" v="473" actId="208"/>
          <ac:cxnSpMkLst>
            <pc:docMk/>
            <pc:sldMk cId="780794616" sldId="263"/>
            <ac:cxnSpMk id="4" creationId="{25BC948F-FE15-70FC-C74A-E15351FE00C3}"/>
          </ac:cxnSpMkLst>
        </pc:cxnChg>
        <pc:cxnChg chg="mod">
          <ac:chgData name="Ann-Karin Hardie Olsen" userId="e320bee9-3c44-4263-bfad-c0288f2c0ec5" providerId="ADAL" clId="{2E2AC092-3BA5-4E00-A94D-19F3A4DF3C5B}" dt="2024-12-22T08:10:12.393" v="473" actId="208"/>
          <ac:cxnSpMkLst>
            <pc:docMk/>
            <pc:sldMk cId="780794616" sldId="263"/>
            <ac:cxnSpMk id="6" creationId="{2EE6CFD3-08CB-D262-7ED5-54416BB57B69}"/>
          </ac:cxnSpMkLst>
        </pc:cxnChg>
        <pc:cxnChg chg="mod">
          <ac:chgData name="Ann-Karin Hardie Olsen" userId="e320bee9-3c44-4263-bfad-c0288f2c0ec5" providerId="ADAL" clId="{2E2AC092-3BA5-4E00-A94D-19F3A4DF3C5B}" dt="2024-12-22T08:10:12.393" v="473" actId="208"/>
          <ac:cxnSpMkLst>
            <pc:docMk/>
            <pc:sldMk cId="780794616" sldId="263"/>
            <ac:cxnSpMk id="7" creationId="{C2669E5D-32DE-52F5-23D0-BDA82A2939EB}"/>
          </ac:cxnSpMkLst>
        </pc:cxnChg>
        <pc:cxnChg chg="mod">
          <ac:chgData name="Ann-Karin Hardie Olsen" userId="e320bee9-3c44-4263-bfad-c0288f2c0ec5" providerId="ADAL" clId="{2E2AC092-3BA5-4E00-A94D-19F3A4DF3C5B}" dt="2024-12-22T08:10:12.393" v="473" actId="208"/>
          <ac:cxnSpMkLst>
            <pc:docMk/>
            <pc:sldMk cId="780794616" sldId="263"/>
            <ac:cxnSpMk id="8" creationId="{C10C5C62-71B7-7463-4A91-FFF88D4A2373}"/>
          </ac:cxnSpMkLst>
        </pc:cxnChg>
        <pc:cxnChg chg="mod">
          <ac:chgData name="Ann-Karin Hardie Olsen" userId="e320bee9-3c44-4263-bfad-c0288f2c0ec5" providerId="ADAL" clId="{2E2AC092-3BA5-4E00-A94D-19F3A4DF3C5B}" dt="2024-12-22T08:10:12.393" v="473" actId="208"/>
          <ac:cxnSpMkLst>
            <pc:docMk/>
            <pc:sldMk cId="780794616" sldId="263"/>
            <ac:cxnSpMk id="9" creationId="{27E92E11-D752-4206-2C40-CF237BEB9920}"/>
          </ac:cxnSpMkLst>
        </pc:cxnChg>
        <pc:cxnChg chg="mod">
          <ac:chgData name="Ann-Karin Hardie Olsen" userId="e320bee9-3c44-4263-bfad-c0288f2c0ec5" providerId="ADAL" clId="{2E2AC092-3BA5-4E00-A94D-19F3A4DF3C5B}" dt="2024-12-22T08:10:12.393" v="473" actId="208"/>
          <ac:cxnSpMkLst>
            <pc:docMk/>
            <pc:sldMk cId="780794616" sldId="263"/>
            <ac:cxnSpMk id="10" creationId="{16EBB680-E7C5-B4F8-DDB6-B39644C3DECF}"/>
          </ac:cxnSpMkLst>
        </pc:cxnChg>
        <pc:cxnChg chg="add mod">
          <ac:chgData name="Ann-Karin Hardie Olsen" userId="e320bee9-3c44-4263-bfad-c0288f2c0ec5" providerId="ADAL" clId="{2E2AC092-3BA5-4E00-A94D-19F3A4DF3C5B}" dt="2024-12-22T08:03:26.475" v="399" actId="14100"/>
          <ac:cxnSpMkLst>
            <pc:docMk/>
            <pc:sldMk cId="780794616" sldId="263"/>
            <ac:cxnSpMk id="12" creationId="{526F8041-E242-C593-4E01-44D2A8EFF802}"/>
          </ac:cxnSpMkLst>
        </pc:cxnChg>
        <pc:cxnChg chg="add mod">
          <ac:chgData name="Ann-Karin Hardie Olsen" userId="e320bee9-3c44-4263-bfad-c0288f2c0ec5" providerId="ADAL" clId="{2E2AC092-3BA5-4E00-A94D-19F3A4DF3C5B}" dt="2024-12-22T08:03:43.261" v="402" actId="14100"/>
          <ac:cxnSpMkLst>
            <pc:docMk/>
            <pc:sldMk cId="780794616" sldId="263"/>
            <ac:cxnSpMk id="13" creationId="{17B44379-B32F-D74B-3222-8AFCDFF615EE}"/>
          </ac:cxnSpMkLst>
        </pc:cxnChg>
        <pc:cxnChg chg="add mod">
          <ac:chgData name="Ann-Karin Hardie Olsen" userId="e320bee9-3c44-4263-bfad-c0288f2c0ec5" providerId="ADAL" clId="{2E2AC092-3BA5-4E00-A94D-19F3A4DF3C5B}" dt="2024-12-22T08:02:34.115" v="391" actId="14100"/>
          <ac:cxnSpMkLst>
            <pc:docMk/>
            <pc:sldMk cId="780794616" sldId="263"/>
            <ac:cxnSpMk id="16" creationId="{8C96A97A-8D3A-1A16-E4EF-01D7C8179C01}"/>
          </ac:cxnSpMkLst>
        </pc:cxnChg>
        <pc:cxnChg chg="add mod">
          <ac:chgData name="Ann-Karin Hardie Olsen" userId="e320bee9-3c44-4263-bfad-c0288f2c0ec5" providerId="ADAL" clId="{2E2AC092-3BA5-4E00-A94D-19F3A4DF3C5B}" dt="2024-12-22T08:03:12.869" v="398" actId="14100"/>
          <ac:cxnSpMkLst>
            <pc:docMk/>
            <pc:sldMk cId="780794616" sldId="263"/>
            <ac:cxnSpMk id="20" creationId="{D79DBA88-95E5-E49E-02E1-86EBAF53A24C}"/>
          </ac:cxnSpMkLst>
        </pc:cxnChg>
        <pc:cxnChg chg="add mod">
          <ac:chgData name="Ann-Karin Hardie Olsen" userId="e320bee9-3c44-4263-bfad-c0288f2c0ec5" providerId="ADAL" clId="{2E2AC092-3BA5-4E00-A94D-19F3A4DF3C5B}" dt="2024-12-22T08:03:58.786" v="406" actId="14100"/>
          <ac:cxnSpMkLst>
            <pc:docMk/>
            <pc:sldMk cId="780794616" sldId="263"/>
            <ac:cxnSpMk id="24" creationId="{8181860C-191B-BFC4-1D28-F69769EDA43A}"/>
          </ac:cxnSpMkLst>
        </pc:cxnChg>
      </pc:sldChg>
      <pc:sldChg chg="addSp delSp modSp mod">
        <pc:chgData name="Ann-Karin Hardie Olsen" userId="e320bee9-3c44-4263-bfad-c0288f2c0ec5" providerId="ADAL" clId="{2E2AC092-3BA5-4E00-A94D-19F3A4DF3C5B}" dt="2024-12-22T08:17:29.548" v="600" actId="1076"/>
        <pc:sldMkLst>
          <pc:docMk/>
          <pc:sldMk cId="2962040409" sldId="264"/>
        </pc:sldMkLst>
        <pc:spChg chg="mod">
          <ac:chgData name="Ann-Karin Hardie Olsen" userId="e320bee9-3c44-4263-bfad-c0288f2c0ec5" providerId="ADAL" clId="{2E2AC092-3BA5-4E00-A94D-19F3A4DF3C5B}" dt="2024-12-22T07:49:07.158" v="172" actId="404"/>
          <ac:spMkLst>
            <pc:docMk/>
            <pc:sldMk cId="2962040409" sldId="264"/>
            <ac:spMk id="5" creationId="{2C84C151-CBD3-5CF4-021B-B2C0E7F40DAA}"/>
          </ac:spMkLst>
        </pc:spChg>
        <pc:spChg chg="add del mod">
          <ac:chgData name="Ann-Karin Hardie Olsen" userId="e320bee9-3c44-4263-bfad-c0288f2c0ec5" providerId="ADAL" clId="{2E2AC092-3BA5-4E00-A94D-19F3A4DF3C5B}" dt="2024-12-22T08:09:17.666" v="461" actId="478"/>
          <ac:spMkLst>
            <pc:docMk/>
            <pc:sldMk cId="2962040409" sldId="264"/>
            <ac:spMk id="9" creationId="{E7C7C121-5A5C-2CDA-D4CE-AE60BDD0F6D9}"/>
          </ac:spMkLst>
        </pc:spChg>
        <pc:spChg chg="add del mod">
          <ac:chgData name="Ann-Karin Hardie Olsen" userId="e320bee9-3c44-4263-bfad-c0288f2c0ec5" providerId="ADAL" clId="{2E2AC092-3BA5-4E00-A94D-19F3A4DF3C5B}" dt="2024-12-22T08:06:18.639" v="432" actId="478"/>
          <ac:spMkLst>
            <pc:docMk/>
            <pc:sldMk cId="2962040409" sldId="264"/>
            <ac:spMk id="10" creationId="{F981FB62-B783-590B-6B1E-036E4500B054}"/>
          </ac:spMkLst>
        </pc:spChg>
        <pc:spChg chg="add del mod">
          <ac:chgData name="Ann-Karin Hardie Olsen" userId="e320bee9-3c44-4263-bfad-c0288f2c0ec5" providerId="ADAL" clId="{2E2AC092-3BA5-4E00-A94D-19F3A4DF3C5B}" dt="2024-12-22T08:06:04.851" v="428" actId="478"/>
          <ac:spMkLst>
            <pc:docMk/>
            <pc:sldMk cId="2962040409" sldId="264"/>
            <ac:spMk id="11" creationId="{375F9DE3-E97C-8E5F-2DEA-9A32E0DB12E5}"/>
          </ac:spMkLst>
        </pc:spChg>
        <pc:spChg chg="add del mod">
          <ac:chgData name="Ann-Karin Hardie Olsen" userId="e320bee9-3c44-4263-bfad-c0288f2c0ec5" providerId="ADAL" clId="{2E2AC092-3BA5-4E00-A94D-19F3A4DF3C5B}" dt="2024-12-22T08:06:14.998" v="430" actId="478"/>
          <ac:spMkLst>
            <pc:docMk/>
            <pc:sldMk cId="2962040409" sldId="264"/>
            <ac:spMk id="13" creationId="{EE111DC2-EBFD-C0B9-D06F-6818992ADFFC}"/>
          </ac:spMkLst>
        </pc:spChg>
        <pc:spChg chg="add mod">
          <ac:chgData name="Ann-Karin Hardie Olsen" userId="e320bee9-3c44-4263-bfad-c0288f2c0ec5" providerId="ADAL" clId="{2E2AC092-3BA5-4E00-A94D-19F3A4DF3C5B}" dt="2024-12-22T08:05:10.675" v="415"/>
          <ac:spMkLst>
            <pc:docMk/>
            <pc:sldMk cId="2962040409" sldId="264"/>
            <ac:spMk id="14" creationId="{F68CCA7B-57F7-6C8C-19D9-00635EB0CAED}"/>
          </ac:spMkLst>
        </pc:spChg>
        <pc:spChg chg="add del mod">
          <ac:chgData name="Ann-Karin Hardie Olsen" userId="e320bee9-3c44-4263-bfad-c0288f2c0ec5" providerId="ADAL" clId="{2E2AC092-3BA5-4E00-A94D-19F3A4DF3C5B}" dt="2024-12-22T08:06:16.925" v="431" actId="478"/>
          <ac:spMkLst>
            <pc:docMk/>
            <pc:sldMk cId="2962040409" sldId="264"/>
            <ac:spMk id="16" creationId="{181DA275-F4E3-DE29-A420-F424B644C06F}"/>
          </ac:spMkLst>
        </pc:spChg>
        <pc:spChg chg="add del mod">
          <ac:chgData name="Ann-Karin Hardie Olsen" userId="e320bee9-3c44-4263-bfad-c0288f2c0ec5" providerId="ADAL" clId="{2E2AC092-3BA5-4E00-A94D-19F3A4DF3C5B}" dt="2024-12-22T08:06:02.987" v="427" actId="478"/>
          <ac:spMkLst>
            <pc:docMk/>
            <pc:sldMk cId="2962040409" sldId="264"/>
            <ac:spMk id="17" creationId="{91F47E5B-6DFD-748B-AC83-A3ACD10A1C47}"/>
          </ac:spMkLst>
        </pc:spChg>
        <pc:spChg chg="add del mod">
          <ac:chgData name="Ann-Karin Hardie Olsen" userId="e320bee9-3c44-4263-bfad-c0288f2c0ec5" providerId="ADAL" clId="{2E2AC092-3BA5-4E00-A94D-19F3A4DF3C5B}" dt="2024-12-22T08:06:23.957" v="433" actId="478"/>
          <ac:spMkLst>
            <pc:docMk/>
            <pc:sldMk cId="2962040409" sldId="264"/>
            <ac:spMk id="19" creationId="{6440A86D-0FE7-0D3D-C2D0-E2AC5CA7897D}"/>
          </ac:spMkLst>
        </pc:spChg>
        <pc:spChg chg="add mod">
          <ac:chgData name="Ann-Karin Hardie Olsen" userId="e320bee9-3c44-4263-bfad-c0288f2c0ec5" providerId="ADAL" clId="{2E2AC092-3BA5-4E00-A94D-19F3A4DF3C5B}" dt="2024-12-22T08:05:29.610" v="420" actId="1076"/>
          <ac:spMkLst>
            <pc:docMk/>
            <pc:sldMk cId="2962040409" sldId="264"/>
            <ac:spMk id="20" creationId="{EEE44A4D-EAFF-DF24-0FBD-7CB229353D24}"/>
          </ac:spMkLst>
        </pc:spChg>
        <pc:spChg chg="add mod">
          <ac:chgData name="Ann-Karin Hardie Olsen" userId="e320bee9-3c44-4263-bfad-c0288f2c0ec5" providerId="ADAL" clId="{2E2AC092-3BA5-4E00-A94D-19F3A4DF3C5B}" dt="2024-12-22T08:06:58.203" v="440" actId="1076"/>
          <ac:spMkLst>
            <pc:docMk/>
            <pc:sldMk cId="2962040409" sldId="264"/>
            <ac:spMk id="29" creationId="{B3286F22-1409-262E-A2FD-DA23856F4CC5}"/>
          </ac:spMkLst>
        </pc:spChg>
        <pc:spChg chg="add mod">
          <ac:chgData name="Ann-Karin Hardie Olsen" userId="e320bee9-3c44-4263-bfad-c0288f2c0ec5" providerId="ADAL" clId="{2E2AC092-3BA5-4E00-A94D-19F3A4DF3C5B}" dt="2024-12-22T08:09:18.258" v="462"/>
          <ac:spMkLst>
            <pc:docMk/>
            <pc:sldMk cId="2962040409" sldId="264"/>
            <ac:spMk id="31" creationId="{EABD1E2E-8F16-449E-F8D5-FA1B5BE082C0}"/>
          </ac:spMkLst>
        </pc:spChg>
        <pc:cxnChg chg="mod">
          <ac:chgData name="Ann-Karin Hardie Olsen" userId="e320bee9-3c44-4263-bfad-c0288f2c0ec5" providerId="ADAL" clId="{2E2AC092-3BA5-4E00-A94D-19F3A4DF3C5B}" dt="2024-12-22T08:10:27.788" v="474" actId="208"/>
          <ac:cxnSpMkLst>
            <pc:docMk/>
            <pc:sldMk cId="2962040409" sldId="264"/>
            <ac:cxnSpMk id="3" creationId="{25A747DD-12FC-19F6-B0E9-FD4EEEC8C121}"/>
          </ac:cxnSpMkLst>
        </pc:cxnChg>
        <pc:cxnChg chg="mod">
          <ac:chgData name="Ann-Karin Hardie Olsen" userId="e320bee9-3c44-4263-bfad-c0288f2c0ec5" providerId="ADAL" clId="{2E2AC092-3BA5-4E00-A94D-19F3A4DF3C5B}" dt="2024-12-22T08:17:29.548" v="600" actId="1076"/>
          <ac:cxnSpMkLst>
            <pc:docMk/>
            <pc:sldMk cId="2962040409" sldId="264"/>
            <ac:cxnSpMk id="4" creationId="{6CBCCB34-8185-1576-0503-79CEF9808F06}"/>
          </ac:cxnSpMkLst>
        </pc:cxnChg>
        <pc:cxnChg chg="mod">
          <ac:chgData name="Ann-Karin Hardie Olsen" userId="e320bee9-3c44-4263-bfad-c0288f2c0ec5" providerId="ADAL" clId="{2E2AC092-3BA5-4E00-A94D-19F3A4DF3C5B}" dt="2024-12-22T08:10:27.788" v="474" actId="208"/>
          <ac:cxnSpMkLst>
            <pc:docMk/>
            <pc:sldMk cId="2962040409" sldId="264"/>
            <ac:cxnSpMk id="6" creationId="{826A6DAA-9F2F-6273-9CF1-592785134EEF}"/>
          </ac:cxnSpMkLst>
        </pc:cxnChg>
        <pc:cxnChg chg="mod">
          <ac:chgData name="Ann-Karin Hardie Olsen" userId="e320bee9-3c44-4263-bfad-c0288f2c0ec5" providerId="ADAL" clId="{2E2AC092-3BA5-4E00-A94D-19F3A4DF3C5B}" dt="2024-12-22T08:10:27.788" v="474" actId="208"/>
          <ac:cxnSpMkLst>
            <pc:docMk/>
            <pc:sldMk cId="2962040409" sldId="264"/>
            <ac:cxnSpMk id="7" creationId="{A4E6092C-D08B-1CAF-F051-CE69E3205405}"/>
          </ac:cxnSpMkLst>
        </pc:cxnChg>
        <pc:cxnChg chg="mod">
          <ac:chgData name="Ann-Karin Hardie Olsen" userId="e320bee9-3c44-4263-bfad-c0288f2c0ec5" providerId="ADAL" clId="{2E2AC092-3BA5-4E00-A94D-19F3A4DF3C5B}" dt="2024-12-22T08:10:27.788" v="474" actId="208"/>
          <ac:cxnSpMkLst>
            <pc:docMk/>
            <pc:sldMk cId="2962040409" sldId="264"/>
            <ac:cxnSpMk id="8" creationId="{5199E2EF-C57C-1126-1DCD-BDD83EFCADD5}"/>
          </ac:cxnSpMkLst>
        </pc:cxnChg>
        <pc:cxnChg chg="add mod">
          <ac:chgData name="Ann-Karin Hardie Olsen" userId="e320bee9-3c44-4263-bfad-c0288f2c0ec5" providerId="ADAL" clId="{2E2AC092-3BA5-4E00-A94D-19F3A4DF3C5B}" dt="2024-12-22T08:05:40.832" v="422" actId="14100"/>
          <ac:cxnSpMkLst>
            <pc:docMk/>
            <pc:sldMk cId="2962040409" sldId="264"/>
            <ac:cxnSpMk id="12" creationId="{2835CAA3-EFBD-07C7-3805-291D99A77ACC}"/>
          </ac:cxnSpMkLst>
        </pc:cxnChg>
        <pc:cxnChg chg="add mod">
          <ac:chgData name="Ann-Karin Hardie Olsen" userId="e320bee9-3c44-4263-bfad-c0288f2c0ec5" providerId="ADAL" clId="{2E2AC092-3BA5-4E00-A94D-19F3A4DF3C5B}" dt="2024-12-22T08:05:57.827" v="426" actId="14100"/>
          <ac:cxnSpMkLst>
            <pc:docMk/>
            <pc:sldMk cId="2962040409" sldId="264"/>
            <ac:cxnSpMk id="15" creationId="{E565092D-B126-42FC-5044-6EB372148E62}"/>
          </ac:cxnSpMkLst>
        </pc:cxnChg>
        <pc:cxnChg chg="add mod">
          <ac:chgData name="Ann-Karin Hardie Olsen" userId="e320bee9-3c44-4263-bfad-c0288f2c0ec5" providerId="ADAL" clId="{2E2AC092-3BA5-4E00-A94D-19F3A4DF3C5B}" dt="2024-12-22T08:05:49.405" v="424" actId="14100"/>
          <ac:cxnSpMkLst>
            <pc:docMk/>
            <pc:sldMk cId="2962040409" sldId="264"/>
            <ac:cxnSpMk id="18" creationId="{35AA4A48-A578-B8F7-3D0C-FEF6C1D316CF}"/>
          </ac:cxnSpMkLst>
        </pc:cxnChg>
        <pc:cxnChg chg="add mod">
          <ac:chgData name="Ann-Karin Hardie Olsen" userId="e320bee9-3c44-4263-bfad-c0288f2c0ec5" providerId="ADAL" clId="{2E2AC092-3BA5-4E00-A94D-19F3A4DF3C5B}" dt="2024-12-22T08:05:29.610" v="420" actId="1076"/>
          <ac:cxnSpMkLst>
            <pc:docMk/>
            <pc:sldMk cId="2962040409" sldId="264"/>
            <ac:cxnSpMk id="21" creationId="{32E47DD6-E701-4BEF-81F6-C1EEEC8C33CA}"/>
          </ac:cxnSpMkLst>
        </pc:cxnChg>
        <pc:cxnChg chg="add mod">
          <ac:chgData name="Ann-Karin Hardie Olsen" userId="e320bee9-3c44-4263-bfad-c0288f2c0ec5" providerId="ADAL" clId="{2E2AC092-3BA5-4E00-A94D-19F3A4DF3C5B}" dt="2024-12-22T08:06:48.157" v="438" actId="14100"/>
          <ac:cxnSpMkLst>
            <pc:docMk/>
            <pc:sldMk cId="2962040409" sldId="264"/>
            <ac:cxnSpMk id="26" creationId="{464FCEC5-9637-2ABD-99A8-6F358AFFBFEE}"/>
          </ac:cxnSpMkLst>
        </pc:cxnChg>
        <pc:cxnChg chg="add mod">
          <ac:chgData name="Ann-Karin Hardie Olsen" userId="e320bee9-3c44-4263-bfad-c0288f2c0ec5" providerId="ADAL" clId="{2E2AC092-3BA5-4E00-A94D-19F3A4DF3C5B}" dt="2024-12-22T08:10:27.788" v="474" actId="208"/>
          <ac:cxnSpMkLst>
            <pc:docMk/>
            <pc:sldMk cId="2962040409" sldId="264"/>
            <ac:cxnSpMk id="30" creationId="{6ACE0CB0-D694-467F-39CD-DBCCB45DA053}"/>
          </ac:cxnSpMkLst>
        </pc:cxnChg>
      </pc:sldChg>
      <pc:sldChg chg="addSp delSp modSp mod">
        <pc:chgData name="Ann-Karin Hardie Olsen" userId="e320bee9-3c44-4263-bfad-c0288f2c0ec5" providerId="ADAL" clId="{2E2AC092-3BA5-4E00-A94D-19F3A4DF3C5B}" dt="2024-12-22T08:17:59" v="604" actId="1076"/>
        <pc:sldMkLst>
          <pc:docMk/>
          <pc:sldMk cId="1186788983" sldId="265"/>
        </pc:sldMkLst>
        <pc:spChg chg="del">
          <ac:chgData name="Ann-Karin Hardie Olsen" userId="e320bee9-3c44-4263-bfad-c0288f2c0ec5" providerId="ADAL" clId="{2E2AC092-3BA5-4E00-A94D-19F3A4DF3C5B}" dt="2024-12-22T07:50:50.525" v="175" actId="478"/>
          <ac:spMkLst>
            <pc:docMk/>
            <pc:sldMk cId="1186788983" sldId="265"/>
            <ac:spMk id="5" creationId="{2C84C151-CBD3-5CF4-021B-B2C0E7F40DAA}"/>
          </ac:spMkLst>
        </pc:spChg>
        <pc:spChg chg="add del mod">
          <ac:chgData name="Ann-Karin Hardie Olsen" userId="e320bee9-3c44-4263-bfad-c0288f2c0ec5" providerId="ADAL" clId="{2E2AC092-3BA5-4E00-A94D-19F3A4DF3C5B}" dt="2024-12-22T07:50:46.381" v="174" actId="478"/>
          <ac:spMkLst>
            <pc:docMk/>
            <pc:sldMk cId="1186788983" sldId="265"/>
            <ac:spMk id="8" creationId="{3B310E76-3ADD-9973-87A0-DC8E26B64B29}"/>
          </ac:spMkLst>
        </pc:spChg>
        <pc:spChg chg="add mod">
          <ac:chgData name="Ann-Karin Hardie Olsen" userId="e320bee9-3c44-4263-bfad-c0288f2c0ec5" providerId="ADAL" clId="{2E2AC092-3BA5-4E00-A94D-19F3A4DF3C5B}" dt="2024-12-22T07:50:51.228" v="176"/>
          <ac:spMkLst>
            <pc:docMk/>
            <pc:sldMk cId="1186788983" sldId="265"/>
            <ac:spMk id="9" creationId="{4A4AC419-7889-2E82-D27C-1359813FF55B}"/>
          </ac:spMkLst>
        </pc:spChg>
        <pc:spChg chg="add del mod">
          <ac:chgData name="Ann-Karin Hardie Olsen" userId="e320bee9-3c44-4263-bfad-c0288f2c0ec5" providerId="ADAL" clId="{2E2AC092-3BA5-4E00-A94D-19F3A4DF3C5B}" dt="2024-12-22T08:09:23.162" v="463" actId="478"/>
          <ac:spMkLst>
            <pc:docMk/>
            <pc:sldMk cId="1186788983" sldId="265"/>
            <ac:spMk id="10" creationId="{7465123D-30E4-5157-E9A2-B5779EE0B9FF}"/>
          </ac:spMkLst>
        </pc:spChg>
        <pc:spChg chg="add mod">
          <ac:chgData name="Ann-Karin Hardie Olsen" userId="e320bee9-3c44-4263-bfad-c0288f2c0ec5" providerId="ADAL" clId="{2E2AC092-3BA5-4E00-A94D-19F3A4DF3C5B}" dt="2024-12-22T08:13:34.879" v="490" actId="1076"/>
          <ac:spMkLst>
            <pc:docMk/>
            <pc:sldMk cId="1186788983" sldId="265"/>
            <ac:spMk id="11" creationId="{F15659B0-C9EB-78FB-FF0A-8B7859570E41}"/>
          </ac:spMkLst>
        </pc:spChg>
        <pc:spChg chg="add mod">
          <ac:chgData name="Ann-Karin Hardie Olsen" userId="e320bee9-3c44-4263-bfad-c0288f2c0ec5" providerId="ADAL" clId="{2E2AC092-3BA5-4E00-A94D-19F3A4DF3C5B}" dt="2024-12-22T08:14:26.924" v="498" actId="1076"/>
          <ac:spMkLst>
            <pc:docMk/>
            <pc:sldMk cId="1186788983" sldId="265"/>
            <ac:spMk id="12" creationId="{4CC747DD-078C-27CF-E22E-618A92C41BC6}"/>
          </ac:spMkLst>
        </pc:spChg>
        <pc:spChg chg="add mod">
          <ac:chgData name="Ann-Karin Hardie Olsen" userId="e320bee9-3c44-4263-bfad-c0288f2c0ec5" providerId="ADAL" clId="{2E2AC092-3BA5-4E00-A94D-19F3A4DF3C5B}" dt="2024-12-22T08:09:23.605" v="464"/>
          <ac:spMkLst>
            <pc:docMk/>
            <pc:sldMk cId="1186788983" sldId="265"/>
            <ac:spMk id="14" creationId="{31205C76-D215-4096-3E5E-CA4E75335B37}"/>
          </ac:spMkLst>
        </pc:spChg>
        <pc:spChg chg="add mod">
          <ac:chgData name="Ann-Karin Hardie Olsen" userId="e320bee9-3c44-4263-bfad-c0288f2c0ec5" providerId="ADAL" clId="{2E2AC092-3BA5-4E00-A94D-19F3A4DF3C5B}" dt="2024-12-22T08:13:10.265" v="484"/>
          <ac:spMkLst>
            <pc:docMk/>
            <pc:sldMk cId="1186788983" sldId="265"/>
            <ac:spMk id="15" creationId="{0ACBE58B-4FDC-E05C-2D14-58311CF63E62}"/>
          </ac:spMkLst>
        </pc:spChg>
        <pc:spChg chg="add mod">
          <ac:chgData name="Ann-Karin Hardie Olsen" userId="e320bee9-3c44-4263-bfad-c0288f2c0ec5" providerId="ADAL" clId="{2E2AC092-3BA5-4E00-A94D-19F3A4DF3C5B}" dt="2024-12-22T08:13:10.816" v="485"/>
          <ac:spMkLst>
            <pc:docMk/>
            <pc:sldMk cId="1186788983" sldId="265"/>
            <ac:spMk id="16" creationId="{0D977DFE-30C7-7F9F-C03F-9624942E755B}"/>
          </ac:spMkLst>
        </pc:spChg>
        <pc:spChg chg="add mod">
          <ac:chgData name="Ann-Karin Hardie Olsen" userId="e320bee9-3c44-4263-bfad-c0288f2c0ec5" providerId="ADAL" clId="{2E2AC092-3BA5-4E00-A94D-19F3A4DF3C5B}" dt="2024-12-22T08:16:20.985" v="593" actId="1076"/>
          <ac:spMkLst>
            <pc:docMk/>
            <pc:sldMk cId="1186788983" sldId="265"/>
            <ac:spMk id="28" creationId="{1732C616-2F55-A0AC-7913-43DAF30A71D3}"/>
          </ac:spMkLst>
        </pc:spChg>
        <pc:picChg chg="mod">
          <ac:chgData name="Ann-Karin Hardie Olsen" userId="e320bee9-3c44-4263-bfad-c0288f2c0ec5" providerId="ADAL" clId="{2E2AC092-3BA5-4E00-A94D-19F3A4DF3C5B}" dt="2024-12-22T07:51:24.826" v="177" actId="1076"/>
          <ac:picMkLst>
            <pc:docMk/>
            <pc:sldMk cId="1186788983" sldId="265"/>
            <ac:picMk id="3" creationId="{B9AA0672-07E9-7BA5-8320-9C3D9634DC15}"/>
          </ac:picMkLst>
        </pc:picChg>
        <pc:cxnChg chg="mod">
          <ac:chgData name="Ann-Karin Hardie Olsen" userId="e320bee9-3c44-4263-bfad-c0288f2c0ec5" providerId="ADAL" clId="{2E2AC092-3BA5-4E00-A94D-19F3A4DF3C5B}" dt="2024-12-22T08:10:42.912" v="475" actId="208"/>
          <ac:cxnSpMkLst>
            <pc:docMk/>
            <pc:sldMk cId="1186788983" sldId="265"/>
            <ac:cxnSpMk id="2" creationId="{F232B626-AE71-9336-0CAD-A4AD5BE34A4C}"/>
          </ac:cxnSpMkLst>
        </pc:cxnChg>
        <pc:cxnChg chg="mod">
          <ac:chgData name="Ann-Karin Hardie Olsen" userId="e320bee9-3c44-4263-bfad-c0288f2c0ec5" providerId="ADAL" clId="{2E2AC092-3BA5-4E00-A94D-19F3A4DF3C5B}" dt="2024-12-22T08:10:42.912" v="475" actId="208"/>
          <ac:cxnSpMkLst>
            <pc:docMk/>
            <pc:sldMk cId="1186788983" sldId="265"/>
            <ac:cxnSpMk id="4" creationId="{42267BB1-D40D-0A74-AA32-2FAD1B2E8EF5}"/>
          </ac:cxnSpMkLst>
        </pc:cxnChg>
        <pc:cxnChg chg="mod">
          <ac:chgData name="Ann-Karin Hardie Olsen" userId="e320bee9-3c44-4263-bfad-c0288f2c0ec5" providerId="ADAL" clId="{2E2AC092-3BA5-4E00-A94D-19F3A4DF3C5B}" dt="2024-12-22T08:10:42.912" v="475" actId="208"/>
          <ac:cxnSpMkLst>
            <pc:docMk/>
            <pc:sldMk cId="1186788983" sldId="265"/>
            <ac:cxnSpMk id="6" creationId="{4B228ADC-FACE-B002-0148-85626EAA4D93}"/>
          </ac:cxnSpMkLst>
        </pc:cxnChg>
        <pc:cxnChg chg="mod">
          <ac:chgData name="Ann-Karin Hardie Olsen" userId="e320bee9-3c44-4263-bfad-c0288f2c0ec5" providerId="ADAL" clId="{2E2AC092-3BA5-4E00-A94D-19F3A4DF3C5B}" dt="2024-12-22T08:10:42.912" v="475" actId="208"/>
          <ac:cxnSpMkLst>
            <pc:docMk/>
            <pc:sldMk cId="1186788983" sldId="265"/>
            <ac:cxnSpMk id="7" creationId="{8B7FFCBF-A590-E8F8-B6B8-63ED05B5DFDC}"/>
          </ac:cxnSpMkLst>
        </pc:cxnChg>
        <pc:cxnChg chg="add mod">
          <ac:chgData name="Ann-Karin Hardie Olsen" userId="e320bee9-3c44-4263-bfad-c0288f2c0ec5" providerId="ADAL" clId="{2E2AC092-3BA5-4E00-A94D-19F3A4DF3C5B}" dt="2024-12-22T08:14:03.487" v="497" actId="14100"/>
          <ac:cxnSpMkLst>
            <pc:docMk/>
            <pc:sldMk cId="1186788983" sldId="265"/>
            <ac:cxnSpMk id="13" creationId="{8EEDB214-7959-CC6F-80C4-6A70DE040F60}"/>
          </ac:cxnSpMkLst>
        </pc:cxnChg>
        <pc:cxnChg chg="add mod">
          <ac:chgData name="Ann-Karin Hardie Olsen" userId="e320bee9-3c44-4263-bfad-c0288f2c0ec5" providerId="ADAL" clId="{2E2AC092-3BA5-4E00-A94D-19F3A4DF3C5B}" dt="2024-12-22T08:13:43.189" v="493" actId="14100"/>
          <ac:cxnSpMkLst>
            <pc:docMk/>
            <pc:sldMk cId="1186788983" sldId="265"/>
            <ac:cxnSpMk id="17" creationId="{9A9C0B94-BA4E-8532-E880-01877B874BE1}"/>
          </ac:cxnSpMkLst>
        </pc:cxnChg>
        <pc:cxnChg chg="add mod">
          <ac:chgData name="Ann-Karin Hardie Olsen" userId="e320bee9-3c44-4263-bfad-c0288f2c0ec5" providerId="ADAL" clId="{2E2AC092-3BA5-4E00-A94D-19F3A4DF3C5B}" dt="2024-12-22T08:14:50.960" v="506" actId="1035"/>
          <ac:cxnSpMkLst>
            <pc:docMk/>
            <pc:sldMk cId="1186788983" sldId="265"/>
            <ac:cxnSpMk id="25" creationId="{05B972C7-2BE0-2855-76AD-0EF71D348A02}"/>
          </ac:cxnSpMkLst>
        </pc:cxnChg>
        <pc:cxnChg chg="add mod">
          <ac:chgData name="Ann-Karin Hardie Olsen" userId="e320bee9-3c44-4263-bfad-c0288f2c0ec5" providerId="ADAL" clId="{2E2AC092-3BA5-4E00-A94D-19F3A4DF3C5B}" dt="2024-12-22T08:17:39.658" v="601" actId="14100"/>
          <ac:cxnSpMkLst>
            <pc:docMk/>
            <pc:sldMk cId="1186788983" sldId="265"/>
            <ac:cxnSpMk id="29" creationId="{1C5E15BF-FD1F-9492-20CD-8FCFD8C7CD2B}"/>
          </ac:cxnSpMkLst>
        </pc:cxnChg>
        <pc:cxnChg chg="add del mod">
          <ac:chgData name="Ann-Karin Hardie Olsen" userId="e320bee9-3c44-4263-bfad-c0288f2c0ec5" providerId="ADAL" clId="{2E2AC092-3BA5-4E00-A94D-19F3A4DF3C5B}" dt="2024-12-22T08:17:45.252" v="602" actId="478"/>
          <ac:cxnSpMkLst>
            <pc:docMk/>
            <pc:sldMk cId="1186788983" sldId="265"/>
            <ac:cxnSpMk id="32" creationId="{C260E9F4-D427-ED13-F3F4-8D05EFED821A}"/>
          </ac:cxnSpMkLst>
        </pc:cxnChg>
        <pc:cxnChg chg="add mod">
          <ac:chgData name="Ann-Karin Hardie Olsen" userId="e320bee9-3c44-4263-bfad-c0288f2c0ec5" providerId="ADAL" clId="{2E2AC092-3BA5-4E00-A94D-19F3A4DF3C5B}" dt="2024-12-22T08:17:59" v="604" actId="1076"/>
          <ac:cxnSpMkLst>
            <pc:docMk/>
            <pc:sldMk cId="1186788983" sldId="265"/>
            <ac:cxnSpMk id="37" creationId="{2EFFED49-350B-0922-8128-17F631DC4EEE}"/>
          </ac:cxnSpMkLst>
        </pc:cxnChg>
      </pc:sldChg>
      <pc:sldChg chg="addSp delSp modSp mod">
        <pc:chgData name="Ann-Karin Hardie Olsen" userId="e320bee9-3c44-4263-bfad-c0288f2c0ec5" providerId="ADAL" clId="{2E2AC092-3BA5-4E00-A94D-19F3A4DF3C5B}" dt="2024-12-22T08:21:47.874" v="678" actId="14100"/>
        <pc:sldMkLst>
          <pc:docMk/>
          <pc:sldMk cId="1941740904" sldId="266"/>
        </pc:sldMkLst>
        <pc:spChg chg="del">
          <ac:chgData name="Ann-Karin Hardie Olsen" userId="e320bee9-3c44-4263-bfad-c0288f2c0ec5" providerId="ADAL" clId="{2E2AC092-3BA5-4E00-A94D-19F3A4DF3C5B}" dt="2024-12-22T07:52:50.828" v="188" actId="478"/>
          <ac:spMkLst>
            <pc:docMk/>
            <pc:sldMk cId="1941740904" sldId="266"/>
            <ac:spMk id="5" creationId="{2C84C151-CBD3-5CF4-021B-B2C0E7F40DAA}"/>
          </ac:spMkLst>
        </pc:spChg>
        <pc:spChg chg="add mod">
          <ac:chgData name="Ann-Karin Hardie Olsen" userId="e320bee9-3c44-4263-bfad-c0288f2c0ec5" providerId="ADAL" clId="{2E2AC092-3BA5-4E00-A94D-19F3A4DF3C5B}" dt="2024-12-22T07:52:54.277" v="191" actId="20577"/>
          <ac:spMkLst>
            <pc:docMk/>
            <pc:sldMk cId="1941740904" sldId="266"/>
            <ac:spMk id="10" creationId="{C2FF1584-BB45-C738-08B6-F64052D10D19}"/>
          </ac:spMkLst>
        </pc:spChg>
        <pc:spChg chg="add mod">
          <ac:chgData name="Ann-Karin Hardie Olsen" userId="e320bee9-3c44-4263-bfad-c0288f2c0ec5" providerId="ADAL" clId="{2E2AC092-3BA5-4E00-A94D-19F3A4DF3C5B}" dt="2024-12-22T08:09:26.165" v="465"/>
          <ac:spMkLst>
            <pc:docMk/>
            <pc:sldMk cId="1941740904" sldId="266"/>
            <ac:spMk id="13" creationId="{2CD14473-3AC9-FF2A-F838-6044A2C8CD95}"/>
          </ac:spMkLst>
        </pc:spChg>
        <pc:spChg chg="add mod">
          <ac:chgData name="Ann-Karin Hardie Olsen" userId="e320bee9-3c44-4263-bfad-c0288f2c0ec5" providerId="ADAL" clId="{2E2AC092-3BA5-4E00-A94D-19F3A4DF3C5B}" dt="2024-12-22T08:19:47.549" v="654" actId="1035"/>
          <ac:spMkLst>
            <pc:docMk/>
            <pc:sldMk cId="1941740904" sldId="266"/>
            <ac:spMk id="14" creationId="{D1E7810B-8B51-35C4-A8D4-4BD06AD60525}"/>
          </ac:spMkLst>
        </pc:spChg>
        <pc:spChg chg="add mod">
          <ac:chgData name="Ann-Karin Hardie Olsen" userId="e320bee9-3c44-4263-bfad-c0288f2c0ec5" providerId="ADAL" clId="{2E2AC092-3BA5-4E00-A94D-19F3A4DF3C5B}" dt="2024-12-22T08:20:08.832" v="656" actId="1076"/>
          <ac:spMkLst>
            <pc:docMk/>
            <pc:sldMk cId="1941740904" sldId="266"/>
            <ac:spMk id="18" creationId="{A13B7EE5-9C59-F6FF-1306-E4941B9175EF}"/>
          </ac:spMkLst>
        </pc:spChg>
        <pc:spChg chg="add del mod">
          <ac:chgData name="Ann-Karin Hardie Olsen" userId="e320bee9-3c44-4263-bfad-c0288f2c0ec5" providerId="ADAL" clId="{2E2AC092-3BA5-4E00-A94D-19F3A4DF3C5B}" dt="2024-12-22T08:21:35.079" v="675" actId="478"/>
          <ac:spMkLst>
            <pc:docMk/>
            <pc:sldMk cId="1941740904" sldId="266"/>
            <ac:spMk id="24" creationId="{34511F6C-199C-14E1-1B2E-7A2A7B106FD1}"/>
          </ac:spMkLst>
        </pc:spChg>
        <pc:cxnChg chg="mod">
          <ac:chgData name="Ann-Karin Hardie Olsen" userId="e320bee9-3c44-4263-bfad-c0288f2c0ec5" providerId="ADAL" clId="{2E2AC092-3BA5-4E00-A94D-19F3A4DF3C5B}" dt="2024-12-22T08:11:10.258" v="476" actId="208"/>
          <ac:cxnSpMkLst>
            <pc:docMk/>
            <pc:sldMk cId="1941740904" sldId="266"/>
            <ac:cxnSpMk id="3" creationId="{63D1A29E-8D25-3523-F210-CD46BD9C0027}"/>
          </ac:cxnSpMkLst>
        </pc:cxnChg>
        <pc:cxnChg chg="mod">
          <ac:chgData name="Ann-Karin Hardie Olsen" userId="e320bee9-3c44-4263-bfad-c0288f2c0ec5" providerId="ADAL" clId="{2E2AC092-3BA5-4E00-A94D-19F3A4DF3C5B}" dt="2024-12-22T08:11:10.258" v="476" actId="208"/>
          <ac:cxnSpMkLst>
            <pc:docMk/>
            <pc:sldMk cId="1941740904" sldId="266"/>
            <ac:cxnSpMk id="4" creationId="{19AF75ED-6B27-BC1E-C49B-E971ED291B82}"/>
          </ac:cxnSpMkLst>
        </pc:cxnChg>
        <pc:cxnChg chg="mod">
          <ac:chgData name="Ann-Karin Hardie Olsen" userId="e320bee9-3c44-4263-bfad-c0288f2c0ec5" providerId="ADAL" clId="{2E2AC092-3BA5-4E00-A94D-19F3A4DF3C5B}" dt="2024-12-22T08:11:10.258" v="476" actId="208"/>
          <ac:cxnSpMkLst>
            <pc:docMk/>
            <pc:sldMk cId="1941740904" sldId="266"/>
            <ac:cxnSpMk id="6" creationId="{B9AEA240-5DD1-6705-5C51-21326417623A}"/>
          </ac:cxnSpMkLst>
        </pc:cxnChg>
        <pc:cxnChg chg="mod">
          <ac:chgData name="Ann-Karin Hardie Olsen" userId="e320bee9-3c44-4263-bfad-c0288f2c0ec5" providerId="ADAL" clId="{2E2AC092-3BA5-4E00-A94D-19F3A4DF3C5B}" dt="2024-12-22T08:11:10.258" v="476" actId="208"/>
          <ac:cxnSpMkLst>
            <pc:docMk/>
            <pc:sldMk cId="1941740904" sldId="266"/>
            <ac:cxnSpMk id="7" creationId="{03E839F1-6F7B-4EA1-DC56-94733D6B8574}"/>
          </ac:cxnSpMkLst>
        </pc:cxnChg>
        <pc:cxnChg chg="mod">
          <ac:chgData name="Ann-Karin Hardie Olsen" userId="e320bee9-3c44-4263-bfad-c0288f2c0ec5" providerId="ADAL" clId="{2E2AC092-3BA5-4E00-A94D-19F3A4DF3C5B}" dt="2024-12-22T08:11:10.258" v="476" actId="208"/>
          <ac:cxnSpMkLst>
            <pc:docMk/>
            <pc:sldMk cId="1941740904" sldId="266"/>
            <ac:cxnSpMk id="8" creationId="{D47CD758-E68A-E4CE-B789-63F0C79A3AEC}"/>
          </ac:cxnSpMkLst>
        </pc:cxnChg>
        <pc:cxnChg chg="mod">
          <ac:chgData name="Ann-Karin Hardie Olsen" userId="e320bee9-3c44-4263-bfad-c0288f2c0ec5" providerId="ADAL" clId="{2E2AC092-3BA5-4E00-A94D-19F3A4DF3C5B}" dt="2024-12-22T08:11:10.258" v="476" actId="208"/>
          <ac:cxnSpMkLst>
            <pc:docMk/>
            <pc:sldMk cId="1941740904" sldId="266"/>
            <ac:cxnSpMk id="9" creationId="{6BBA8295-39CF-0950-03AC-21302CE02649}"/>
          </ac:cxnSpMkLst>
        </pc:cxnChg>
        <pc:cxnChg chg="mod">
          <ac:chgData name="Ann-Karin Hardie Olsen" userId="e320bee9-3c44-4263-bfad-c0288f2c0ec5" providerId="ADAL" clId="{2E2AC092-3BA5-4E00-A94D-19F3A4DF3C5B}" dt="2024-12-22T08:11:10.258" v="476" actId="208"/>
          <ac:cxnSpMkLst>
            <pc:docMk/>
            <pc:sldMk cId="1941740904" sldId="266"/>
            <ac:cxnSpMk id="11" creationId="{D6B546CB-1F8F-4898-822C-9B0F7D3A17C9}"/>
          </ac:cxnSpMkLst>
        </pc:cxnChg>
        <pc:cxnChg chg="mod">
          <ac:chgData name="Ann-Karin Hardie Olsen" userId="e320bee9-3c44-4263-bfad-c0288f2c0ec5" providerId="ADAL" clId="{2E2AC092-3BA5-4E00-A94D-19F3A4DF3C5B}" dt="2024-12-22T08:11:10.258" v="476" actId="208"/>
          <ac:cxnSpMkLst>
            <pc:docMk/>
            <pc:sldMk cId="1941740904" sldId="266"/>
            <ac:cxnSpMk id="12" creationId="{FA93A584-3EB3-3D7F-1781-DE0C651DF55B}"/>
          </ac:cxnSpMkLst>
        </pc:cxnChg>
        <pc:cxnChg chg="add mod">
          <ac:chgData name="Ann-Karin Hardie Olsen" userId="e320bee9-3c44-4263-bfad-c0288f2c0ec5" providerId="ADAL" clId="{2E2AC092-3BA5-4E00-A94D-19F3A4DF3C5B}" dt="2024-12-22T08:20:29.664" v="660" actId="14100"/>
          <ac:cxnSpMkLst>
            <pc:docMk/>
            <pc:sldMk cId="1941740904" sldId="266"/>
            <ac:cxnSpMk id="15" creationId="{99D295D9-73EF-8F87-2E96-BC8B1F87698A}"/>
          </ac:cxnSpMkLst>
        </pc:cxnChg>
        <pc:cxnChg chg="add mod">
          <ac:chgData name="Ann-Karin Hardie Olsen" userId="e320bee9-3c44-4263-bfad-c0288f2c0ec5" providerId="ADAL" clId="{2E2AC092-3BA5-4E00-A94D-19F3A4DF3C5B}" dt="2024-12-22T08:20:43.378" v="662" actId="14100"/>
          <ac:cxnSpMkLst>
            <pc:docMk/>
            <pc:sldMk cId="1941740904" sldId="266"/>
            <ac:cxnSpMk id="19" creationId="{EF087DE5-52DA-9F4C-CE81-A20E63B08016}"/>
          </ac:cxnSpMkLst>
        </pc:cxnChg>
        <pc:cxnChg chg="add mod">
          <ac:chgData name="Ann-Karin Hardie Olsen" userId="e320bee9-3c44-4263-bfad-c0288f2c0ec5" providerId="ADAL" clId="{2E2AC092-3BA5-4E00-A94D-19F3A4DF3C5B}" dt="2024-12-22T08:20:59.105" v="664" actId="1076"/>
          <ac:cxnSpMkLst>
            <pc:docMk/>
            <pc:sldMk cId="1941740904" sldId="266"/>
            <ac:cxnSpMk id="23" creationId="{FFE3FF29-CFAD-9AA6-1EB2-A854AD34335A}"/>
          </ac:cxnSpMkLst>
        </pc:cxnChg>
        <pc:cxnChg chg="add mod">
          <ac:chgData name="Ann-Karin Hardie Olsen" userId="e320bee9-3c44-4263-bfad-c0288f2c0ec5" providerId="ADAL" clId="{2E2AC092-3BA5-4E00-A94D-19F3A4DF3C5B}" dt="2024-12-22T08:21:47.874" v="678" actId="14100"/>
          <ac:cxnSpMkLst>
            <pc:docMk/>
            <pc:sldMk cId="1941740904" sldId="266"/>
            <ac:cxnSpMk id="25" creationId="{A836B1C6-26D8-40DC-903D-7D37F92501AA}"/>
          </ac:cxnSpMkLst>
        </pc:cxnChg>
      </pc:sldChg>
      <pc:sldChg chg="addSp delSp modSp mod">
        <pc:chgData name="Ann-Karin Hardie Olsen" userId="e320bee9-3c44-4263-bfad-c0288f2c0ec5" providerId="ADAL" clId="{2E2AC092-3BA5-4E00-A94D-19F3A4DF3C5B}" dt="2024-12-22T08:23:44.348" v="697" actId="14100"/>
        <pc:sldMkLst>
          <pc:docMk/>
          <pc:sldMk cId="2735378109" sldId="267"/>
        </pc:sldMkLst>
        <pc:spChg chg="del">
          <ac:chgData name="Ann-Karin Hardie Olsen" userId="e320bee9-3c44-4263-bfad-c0288f2c0ec5" providerId="ADAL" clId="{2E2AC092-3BA5-4E00-A94D-19F3A4DF3C5B}" dt="2024-12-22T07:53:40.864" v="192" actId="478"/>
          <ac:spMkLst>
            <pc:docMk/>
            <pc:sldMk cId="2735378109" sldId="267"/>
            <ac:spMk id="5" creationId="{2C84C151-CBD3-5CF4-021B-B2C0E7F40DAA}"/>
          </ac:spMkLst>
        </pc:spChg>
        <pc:spChg chg="add mod">
          <ac:chgData name="Ann-Karin Hardie Olsen" userId="e320bee9-3c44-4263-bfad-c0288f2c0ec5" providerId="ADAL" clId="{2E2AC092-3BA5-4E00-A94D-19F3A4DF3C5B}" dt="2024-12-22T07:53:41.400" v="193"/>
          <ac:spMkLst>
            <pc:docMk/>
            <pc:sldMk cId="2735378109" sldId="267"/>
            <ac:spMk id="10" creationId="{624902DE-CB30-2CA3-9CAA-C8DD6F11DD5F}"/>
          </ac:spMkLst>
        </pc:spChg>
        <pc:spChg chg="add mod">
          <ac:chgData name="Ann-Karin Hardie Olsen" userId="e320bee9-3c44-4263-bfad-c0288f2c0ec5" providerId="ADAL" clId="{2E2AC092-3BA5-4E00-A94D-19F3A4DF3C5B}" dt="2024-12-22T08:09:31.383" v="466"/>
          <ac:spMkLst>
            <pc:docMk/>
            <pc:sldMk cId="2735378109" sldId="267"/>
            <ac:spMk id="11" creationId="{570485B7-A055-091F-55AC-AD4B5B4FFCAE}"/>
          </ac:spMkLst>
        </pc:spChg>
        <pc:spChg chg="add mod">
          <ac:chgData name="Ann-Karin Hardie Olsen" userId="e320bee9-3c44-4263-bfad-c0288f2c0ec5" providerId="ADAL" clId="{2E2AC092-3BA5-4E00-A94D-19F3A4DF3C5B}" dt="2024-12-22T08:22:17.098" v="679"/>
          <ac:spMkLst>
            <pc:docMk/>
            <pc:sldMk cId="2735378109" sldId="267"/>
            <ac:spMk id="12" creationId="{A71572DA-6238-0223-1760-46E720FAAE9F}"/>
          </ac:spMkLst>
        </pc:spChg>
        <pc:picChg chg="mod">
          <ac:chgData name="Ann-Karin Hardie Olsen" userId="e320bee9-3c44-4263-bfad-c0288f2c0ec5" providerId="ADAL" clId="{2E2AC092-3BA5-4E00-A94D-19F3A4DF3C5B}" dt="2024-12-22T07:53:59.314" v="195" actId="1076"/>
          <ac:picMkLst>
            <pc:docMk/>
            <pc:sldMk cId="2735378109" sldId="267"/>
            <ac:picMk id="2" creationId="{119A14BE-7F68-17CC-A711-4B8FE157B2C8}"/>
          </ac:picMkLst>
        </pc:picChg>
        <pc:cxnChg chg="mod">
          <ac:chgData name="Ann-Karin Hardie Olsen" userId="e320bee9-3c44-4263-bfad-c0288f2c0ec5" providerId="ADAL" clId="{2E2AC092-3BA5-4E00-A94D-19F3A4DF3C5B}" dt="2024-12-22T08:11:20.813" v="477" actId="208"/>
          <ac:cxnSpMkLst>
            <pc:docMk/>
            <pc:sldMk cId="2735378109" sldId="267"/>
            <ac:cxnSpMk id="3" creationId="{C6EE94CF-728C-0F4C-7142-3EC7A776D448}"/>
          </ac:cxnSpMkLst>
        </pc:cxnChg>
        <pc:cxnChg chg="mod">
          <ac:chgData name="Ann-Karin Hardie Olsen" userId="e320bee9-3c44-4263-bfad-c0288f2c0ec5" providerId="ADAL" clId="{2E2AC092-3BA5-4E00-A94D-19F3A4DF3C5B}" dt="2024-12-22T08:11:20.813" v="477" actId="208"/>
          <ac:cxnSpMkLst>
            <pc:docMk/>
            <pc:sldMk cId="2735378109" sldId="267"/>
            <ac:cxnSpMk id="4" creationId="{572D39FE-C43A-B9FB-2478-FD9A2394FF96}"/>
          </ac:cxnSpMkLst>
        </pc:cxnChg>
        <pc:cxnChg chg="mod">
          <ac:chgData name="Ann-Karin Hardie Olsen" userId="e320bee9-3c44-4263-bfad-c0288f2c0ec5" providerId="ADAL" clId="{2E2AC092-3BA5-4E00-A94D-19F3A4DF3C5B}" dt="2024-12-22T08:11:20.813" v="477" actId="208"/>
          <ac:cxnSpMkLst>
            <pc:docMk/>
            <pc:sldMk cId="2735378109" sldId="267"/>
            <ac:cxnSpMk id="6" creationId="{49A9DD30-C1E5-B3CA-C8BE-D4B11376D84F}"/>
          </ac:cxnSpMkLst>
        </pc:cxnChg>
        <pc:cxnChg chg="mod">
          <ac:chgData name="Ann-Karin Hardie Olsen" userId="e320bee9-3c44-4263-bfad-c0288f2c0ec5" providerId="ADAL" clId="{2E2AC092-3BA5-4E00-A94D-19F3A4DF3C5B}" dt="2024-12-22T08:11:20.813" v="477" actId="208"/>
          <ac:cxnSpMkLst>
            <pc:docMk/>
            <pc:sldMk cId="2735378109" sldId="267"/>
            <ac:cxnSpMk id="7" creationId="{5B813329-D45D-44DD-04F5-2FAFD8091CA4}"/>
          </ac:cxnSpMkLst>
        </pc:cxnChg>
        <pc:cxnChg chg="mod">
          <ac:chgData name="Ann-Karin Hardie Olsen" userId="e320bee9-3c44-4263-bfad-c0288f2c0ec5" providerId="ADAL" clId="{2E2AC092-3BA5-4E00-A94D-19F3A4DF3C5B}" dt="2024-12-22T08:11:20.813" v="477" actId="208"/>
          <ac:cxnSpMkLst>
            <pc:docMk/>
            <pc:sldMk cId="2735378109" sldId="267"/>
            <ac:cxnSpMk id="8" creationId="{04053D32-A876-05F2-E433-A68B0FC544A1}"/>
          </ac:cxnSpMkLst>
        </pc:cxnChg>
        <pc:cxnChg chg="mod">
          <ac:chgData name="Ann-Karin Hardie Olsen" userId="e320bee9-3c44-4263-bfad-c0288f2c0ec5" providerId="ADAL" clId="{2E2AC092-3BA5-4E00-A94D-19F3A4DF3C5B}" dt="2024-12-22T08:11:20.813" v="477" actId="208"/>
          <ac:cxnSpMkLst>
            <pc:docMk/>
            <pc:sldMk cId="2735378109" sldId="267"/>
            <ac:cxnSpMk id="9" creationId="{B16901BA-ABB6-7BFD-1845-44B1BC4D5D76}"/>
          </ac:cxnSpMkLst>
        </pc:cxnChg>
        <pc:cxnChg chg="add mod">
          <ac:chgData name="Ann-Karin Hardie Olsen" userId="e320bee9-3c44-4263-bfad-c0288f2c0ec5" providerId="ADAL" clId="{2E2AC092-3BA5-4E00-A94D-19F3A4DF3C5B}" dt="2024-12-22T08:22:44.749" v="684" actId="14100"/>
          <ac:cxnSpMkLst>
            <pc:docMk/>
            <pc:sldMk cId="2735378109" sldId="267"/>
            <ac:cxnSpMk id="13" creationId="{7B8FF335-6F50-019A-BE95-8351BAEA8ACB}"/>
          </ac:cxnSpMkLst>
        </pc:cxnChg>
        <pc:cxnChg chg="add mod">
          <ac:chgData name="Ann-Karin Hardie Olsen" userId="e320bee9-3c44-4263-bfad-c0288f2c0ec5" providerId="ADAL" clId="{2E2AC092-3BA5-4E00-A94D-19F3A4DF3C5B}" dt="2024-12-22T08:22:52.887" v="686" actId="14100"/>
          <ac:cxnSpMkLst>
            <pc:docMk/>
            <pc:sldMk cId="2735378109" sldId="267"/>
            <ac:cxnSpMk id="14" creationId="{43B08221-405B-1AAA-00DB-B03BBAA5BC4F}"/>
          </ac:cxnSpMkLst>
        </pc:cxnChg>
        <pc:cxnChg chg="add mod">
          <ac:chgData name="Ann-Karin Hardie Olsen" userId="e320bee9-3c44-4263-bfad-c0288f2c0ec5" providerId="ADAL" clId="{2E2AC092-3BA5-4E00-A94D-19F3A4DF3C5B}" dt="2024-12-22T08:22:58.925" v="688" actId="14100"/>
          <ac:cxnSpMkLst>
            <pc:docMk/>
            <pc:sldMk cId="2735378109" sldId="267"/>
            <ac:cxnSpMk id="15" creationId="{7D72F2F9-C5E1-25F5-AEEA-9BBD9B0B992E}"/>
          </ac:cxnSpMkLst>
        </pc:cxnChg>
        <pc:cxnChg chg="add mod">
          <ac:chgData name="Ann-Karin Hardie Olsen" userId="e320bee9-3c44-4263-bfad-c0288f2c0ec5" providerId="ADAL" clId="{2E2AC092-3BA5-4E00-A94D-19F3A4DF3C5B}" dt="2024-12-22T08:23:44.348" v="697" actId="14100"/>
          <ac:cxnSpMkLst>
            <pc:docMk/>
            <pc:sldMk cId="2735378109" sldId="267"/>
            <ac:cxnSpMk id="20" creationId="{F348DD65-8632-0F0D-2C43-8E3D78AE99E8}"/>
          </ac:cxnSpMkLst>
        </pc:cxnChg>
      </pc:sldChg>
      <pc:sldChg chg="addSp delSp modSp mod">
        <pc:chgData name="Ann-Karin Hardie Olsen" userId="e320bee9-3c44-4263-bfad-c0288f2c0ec5" providerId="ADAL" clId="{2E2AC092-3BA5-4E00-A94D-19F3A4DF3C5B}" dt="2024-12-22T08:26:19.161" v="750" actId="1036"/>
        <pc:sldMkLst>
          <pc:docMk/>
          <pc:sldMk cId="1704879246" sldId="268"/>
        </pc:sldMkLst>
        <pc:spChg chg="add mod">
          <ac:chgData name="Ann-Karin Hardie Olsen" userId="e320bee9-3c44-4263-bfad-c0288f2c0ec5" providerId="ADAL" clId="{2E2AC092-3BA5-4E00-A94D-19F3A4DF3C5B}" dt="2024-12-22T08:24:25.705" v="731" actId="20577"/>
          <ac:spMkLst>
            <pc:docMk/>
            <pc:sldMk cId="1704879246" sldId="268"/>
            <ac:spMk id="3" creationId="{60C9ED75-5526-F871-634C-4AFC160FC079}"/>
          </ac:spMkLst>
        </pc:spChg>
        <pc:spChg chg="mod">
          <ac:chgData name="Ann-Karin Hardie Olsen" userId="e320bee9-3c44-4263-bfad-c0288f2c0ec5" providerId="ADAL" clId="{2E2AC092-3BA5-4E00-A94D-19F3A4DF3C5B}" dt="2024-12-22T08:26:19.161" v="750" actId="1036"/>
          <ac:spMkLst>
            <pc:docMk/>
            <pc:sldMk cId="1704879246" sldId="268"/>
            <ac:spMk id="4" creationId="{1E473976-37DD-73A6-C305-A08443EFA22A}"/>
          </ac:spMkLst>
        </pc:spChg>
        <pc:spChg chg="del">
          <ac:chgData name="Ann-Karin Hardie Olsen" userId="e320bee9-3c44-4263-bfad-c0288f2c0ec5" providerId="ADAL" clId="{2E2AC092-3BA5-4E00-A94D-19F3A4DF3C5B}" dt="2024-12-22T08:24:51.666" v="732" actId="478"/>
          <ac:spMkLst>
            <pc:docMk/>
            <pc:sldMk cId="1704879246" sldId="268"/>
            <ac:spMk id="5" creationId="{C6E597D9-D255-D61C-515B-2030D28926E0}"/>
          </ac:spMkLst>
        </pc:spChg>
        <pc:spChg chg="del">
          <ac:chgData name="Ann-Karin Hardie Olsen" userId="e320bee9-3c44-4263-bfad-c0288f2c0ec5" providerId="ADAL" clId="{2E2AC092-3BA5-4E00-A94D-19F3A4DF3C5B}" dt="2024-12-22T08:24:53.835" v="733" actId="478"/>
          <ac:spMkLst>
            <pc:docMk/>
            <pc:sldMk cId="1704879246" sldId="268"/>
            <ac:spMk id="6" creationId="{7ECC5CA3-38FE-85B3-E77A-622D5E2D2088}"/>
          </ac:spMkLst>
        </pc:spChg>
        <pc:spChg chg="add mod">
          <ac:chgData name="Ann-Karin Hardie Olsen" userId="e320bee9-3c44-4263-bfad-c0288f2c0ec5" providerId="ADAL" clId="{2E2AC092-3BA5-4E00-A94D-19F3A4DF3C5B}" dt="2024-12-22T08:26:14.449" v="747" actId="1036"/>
          <ac:spMkLst>
            <pc:docMk/>
            <pc:sldMk cId="1704879246" sldId="268"/>
            <ac:spMk id="7" creationId="{2082B54C-974C-B8DD-C0C2-86BCB12BDB40}"/>
          </ac:spMkLst>
        </pc:spChg>
        <pc:spChg chg="add mod">
          <ac:chgData name="Ann-Karin Hardie Olsen" userId="e320bee9-3c44-4263-bfad-c0288f2c0ec5" providerId="ADAL" clId="{2E2AC092-3BA5-4E00-A94D-19F3A4DF3C5B}" dt="2024-12-22T08:26:09.216" v="744" actId="1036"/>
          <ac:spMkLst>
            <pc:docMk/>
            <pc:sldMk cId="1704879246" sldId="268"/>
            <ac:spMk id="8" creationId="{D5B1E0FA-FDB3-BA54-9B0D-107641607020}"/>
          </ac:spMkLst>
        </pc:spChg>
        <pc:spChg chg="add mod">
          <ac:chgData name="Ann-Karin Hardie Olsen" userId="e320bee9-3c44-4263-bfad-c0288f2c0ec5" providerId="ADAL" clId="{2E2AC092-3BA5-4E00-A94D-19F3A4DF3C5B}" dt="2024-12-22T08:25:42.552" v="736" actId="1076"/>
          <ac:spMkLst>
            <pc:docMk/>
            <pc:sldMk cId="1704879246" sldId="268"/>
            <ac:spMk id="9" creationId="{E0937644-BCE8-290B-19D3-4F32566054DC}"/>
          </ac:spMkLst>
        </pc:spChg>
        <pc:spChg chg="add mod">
          <ac:chgData name="Ann-Karin Hardie Olsen" userId="e320bee9-3c44-4263-bfad-c0288f2c0ec5" providerId="ADAL" clId="{2E2AC092-3BA5-4E00-A94D-19F3A4DF3C5B}" dt="2024-12-22T08:25:50.300" v="738" actId="1076"/>
          <ac:spMkLst>
            <pc:docMk/>
            <pc:sldMk cId="1704879246" sldId="268"/>
            <ac:spMk id="10" creationId="{DFACFA11-CFC5-F062-8D06-30B1AF853E13}"/>
          </ac:spMkLst>
        </pc:spChg>
        <pc:spChg chg="add mod">
          <ac:chgData name="Ann-Karin Hardie Olsen" userId="e320bee9-3c44-4263-bfad-c0288f2c0ec5" providerId="ADAL" clId="{2E2AC092-3BA5-4E00-A94D-19F3A4DF3C5B}" dt="2024-12-22T08:26:04.335" v="740" actId="1076"/>
          <ac:spMkLst>
            <pc:docMk/>
            <pc:sldMk cId="1704879246" sldId="268"/>
            <ac:spMk id="11" creationId="{0E84237E-2E15-7AE9-1D85-A654314886FF}"/>
          </ac:spMkLst>
        </pc:spChg>
        <pc:spChg chg="del">
          <ac:chgData name="Ann-Karin Hardie Olsen" userId="e320bee9-3c44-4263-bfad-c0288f2c0ec5" providerId="ADAL" clId="{2E2AC092-3BA5-4E00-A94D-19F3A4DF3C5B}" dt="2024-12-22T08:24:08.304" v="698" actId="478"/>
          <ac:spMkLst>
            <pc:docMk/>
            <pc:sldMk cId="1704879246" sldId="268"/>
            <ac:spMk id="38" creationId="{77099841-A197-450E-9468-1DB527C5D8F9}"/>
          </ac:spMkLst>
        </pc:spChg>
      </pc:sldChg>
      <pc:sldChg chg="addSp modSp mod">
        <pc:chgData name="Ann-Karin Hardie Olsen" userId="e320bee9-3c44-4263-bfad-c0288f2c0ec5" providerId="ADAL" clId="{2E2AC092-3BA5-4E00-A94D-19F3A4DF3C5B}" dt="2024-12-22T08:37:05.300" v="1013" actId="6549"/>
        <pc:sldMkLst>
          <pc:docMk/>
          <pc:sldMk cId="2330566342" sldId="269"/>
        </pc:sldMkLst>
        <pc:spChg chg="add mod">
          <ac:chgData name="Ann-Karin Hardie Olsen" userId="e320bee9-3c44-4263-bfad-c0288f2c0ec5" providerId="ADAL" clId="{2E2AC092-3BA5-4E00-A94D-19F3A4DF3C5B}" dt="2024-12-22T08:37:05.300" v="1013" actId="6549"/>
          <ac:spMkLst>
            <pc:docMk/>
            <pc:sldMk cId="2330566342" sldId="269"/>
            <ac:spMk id="4" creationId="{73B84F19-426D-F322-550D-B1B887DB0E3E}"/>
          </ac:spMkLst>
        </pc:spChg>
        <pc:cxnChg chg="mod">
          <ac:chgData name="Ann-Karin Hardie Olsen" userId="e320bee9-3c44-4263-bfad-c0288f2c0ec5" providerId="ADAL" clId="{2E2AC092-3BA5-4E00-A94D-19F3A4DF3C5B}" dt="2024-12-22T08:11:37.161" v="478" actId="208"/>
          <ac:cxnSpMkLst>
            <pc:docMk/>
            <pc:sldMk cId="2330566342" sldId="269"/>
            <ac:cxnSpMk id="2" creationId="{B2717746-1EAA-3A45-8D11-272C7E2BD3C5}"/>
          </ac:cxnSpMkLst>
        </pc:cxnChg>
        <pc:cxnChg chg="mod">
          <ac:chgData name="Ann-Karin Hardie Olsen" userId="e320bee9-3c44-4263-bfad-c0288f2c0ec5" providerId="ADAL" clId="{2E2AC092-3BA5-4E00-A94D-19F3A4DF3C5B}" dt="2024-12-22T08:11:37.161" v="478" actId="208"/>
          <ac:cxnSpMkLst>
            <pc:docMk/>
            <pc:sldMk cId="2330566342" sldId="269"/>
            <ac:cxnSpMk id="6" creationId="{FBF80486-7B2D-262D-B145-78799F069086}"/>
          </ac:cxnSpMkLst>
        </pc:cxnChg>
        <pc:cxnChg chg="mod">
          <ac:chgData name="Ann-Karin Hardie Olsen" userId="e320bee9-3c44-4263-bfad-c0288f2c0ec5" providerId="ADAL" clId="{2E2AC092-3BA5-4E00-A94D-19F3A4DF3C5B}" dt="2024-12-22T08:11:37.161" v="478" actId="208"/>
          <ac:cxnSpMkLst>
            <pc:docMk/>
            <pc:sldMk cId="2330566342" sldId="269"/>
            <ac:cxnSpMk id="7" creationId="{AC077FFF-E6F7-3DEC-4B9F-340415D92B29}"/>
          </ac:cxnSpMkLst>
        </pc:cxnChg>
        <pc:cxnChg chg="mod">
          <ac:chgData name="Ann-Karin Hardie Olsen" userId="e320bee9-3c44-4263-bfad-c0288f2c0ec5" providerId="ADAL" clId="{2E2AC092-3BA5-4E00-A94D-19F3A4DF3C5B}" dt="2024-12-22T08:11:37.161" v="478" actId="208"/>
          <ac:cxnSpMkLst>
            <pc:docMk/>
            <pc:sldMk cId="2330566342" sldId="269"/>
            <ac:cxnSpMk id="8" creationId="{E945A3E1-0C80-96F0-53A8-52239DDB4FCA}"/>
          </ac:cxnSpMkLst>
        </pc:cxnChg>
        <pc:cxnChg chg="mod">
          <ac:chgData name="Ann-Karin Hardie Olsen" userId="e320bee9-3c44-4263-bfad-c0288f2c0ec5" providerId="ADAL" clId="{2E2AC092-3BA5-4E00-A94D-19F3A4DF3C5B}" dt="2024-12-22T08:11:37.161" v="478" actId="208"/>
          <ac:cxnSpMkLst>
            <pc:docMk/>
            <pc:sldMk cId="2330566342" sldId="269"/>
            <ac:cxnSpMk id="9" creationId="{AC983EBF-FF4C-B4E5-946E-FB9EC8DC4A3B}"/>
          </ac:cxnSpMkLst>
        </pc:cxnChg>
      </pc:sldChg>
      <pc:sldChg chg="addSp delSp modSp mod">
        <pc:chgData name="Ann-Karin Hardie Olsen" userId="e320bee9-3c44-4263-bfad-c0288f2c0ec5" providerId="ADAL" clId="{2E2AC092-3BA5-4E00-A94D-19F3A4DF3C5B}" dt="2024-12-22T08:36:55.325" v="1011" actId="6549"/>
        <pc:sldMkLst>
          <pc:docMk/>
          <pc:sldMk cId="3356265034" sldId="270"/>
        </pc:sldMkLst>
        <pc:spChg chg="add del mod">
          <ac:chgData name="Ann-Karin Hardie Olsen" userId="e320bee9-3c44-4263-bfad-c0288f2c0ec5" providerId="ADAL" clId="{2E2AC092-3BA5-4E00-A94D-19F3A4DF3C5B}" dt="2024-12-22T08:29:43.905" v="957" actId="478"/>
          <ac:spMkLst>
            <pc:docMk/>
            <pc:sldMk cId="3356265034" sldId="270"/>
            <ac:spMk id="2" creationId="{3A912490-C90A-4F19-071B-7FC2E39330FB}"/>
          </ac:spMkLst>
        </pc:spChg>
        <pc:spChg chg="add mod">
          <ac:chgData name="Ann-Karin Hardie Olsen" userId="e320bee9-3c44-4263-bfad-c0288f2c0ec5" providerId="ADAL" clId="{2E2AC092-3BA5-4E00-A94D-19F3A4DF3C5B}" dt="2024-12-22T08:36:55.325" v="1011" actId="6549"/>
          <ac:spMkLst>
            <pc:docMk/>
            <pc:sldMk cId="3356265034" sldId="270"/>
            <ac:spMk id="3" creationId="{B73B52E5-D676-3BAF-6F20-B03DA40EB4C9}"/>
          </ac:spMkLst>
        </pc:spChg>
        <pc:cxnChg chg="mod">
          <ac:chgData name="Ann-Karin Hardie Olsen" userId="e320bee9-3c44-4263-bfad-c0288f2c0ec5" providerId="ADAL" clId="{2E2AC092-3BA5-4E00-A94D-19F3A4DF3C5B}" dt="2024-12-22T08:11:46.464" v="479" actId="208"/>
          <ac:cxnSpMkLst>
            <pc:docMk/>
            <pc:sldMk cId="3356265034" sldId="270"/>
            <ac:cxnSpMk id="12" creationId="{4884DE11-DE8B-2090-BC89-D6A7351D47BE}"/>
          </ac:cxnSpMkLst>
        </pc:cxnChg>
        <pc:cxnChg chg="mod">
          <ac:chgData name="Ann-Karin Hardie Olsen" userId="e320bee9-3c44-4263-bfad-c0288f2c0ec5" providerId="ADAL" clId="{2E2AC092-3BA5-4E00-A94D-19F3A4DF3C5B}" dt="2024-12-22T08:11:46.464" v="479" actId="208"/>
          <ac:cxnSpMkLst>
            <pc:docMk/>
            <pc:sldMk cId="3356265034" sldId="270"/>
            <ac:cxnSpMk id="13" creationId="{C8C4AA55-7203-17BA-D828-E38D17B247C7}"/>
          </ac:cxnSpMkLst>
        </pc:cxnChg>
        <pc:cxnChg chg="mod">
          <ac:chgData name="Ann-Karin Hardie Olsen" userId="e320bee9-3c44-4263-bfad-c0288f2c0ec5" providerId="ADAL" clId="{2E2AC092-3BA5-4E00-A94D-19F3A4DF3C5B}" dt="2024-12-22T08:11:46.464" v="479" actId="208"/>
          <ac:cxnSpMkLst>
            <pc:docMk/>
            <pc:sldMk cId="3356265034" sldId="270"/>
            <ac:cxnSpMk id="14" creationId="{D3165F8E-7BB7-F525-0AB5-58ACB853728F}"/>
          </ac:cxnSpMkLst>
        </pc:cxnChg>
        <pc:cxnChg chg="mod">
          <ac:chgData name="Ann-Karin Hardie Olsen" userId="e320bee9-3c44-4263-bfad-c0288f2c0ec5" providerId="ADAL" clId="{2E2AC092-3BA5-4E00-A94D-19F3A4DF3C5B}" dt="2024-12-22T08:11:46.464" v="479" actId="208"/>
          <ac:cxnSpMkLst>
            <pc:docMk/>
            <pc:sldMk cId="3356265034" sldId="270"/>
            <ac:cxnSpMk id="15" creationId="{67899BC6-1EC3-004E-2EDD-A0ED759F1B97}"/>
          </ac:cxnSpMkLst>
        </pc:cxnChg>
      </pc:sldChg>
      <pc:sldChg chg="addSp delSp modSp mod">
        <pc:chgData name="Ann-Karin Hardie Olsen" userId="e320bee9-3c44-4263-bfad-c0288f2c0ec5" providerId="ADAL" clId="{2E2AC092-3BA5-4E00-A94D-19F3A4DF3C5B}" dt="2024-12-22T08:37:00.372" v="1012" actId="6549"/>
        <pc:sldMkLst>
          <pc:docMk/>
          <pc:sldMk cId="1128141415" sldId="271"/>
        </pc:sldMkLst>
        <pc:spChg chg="mod">
          <ac:chgData name="Ann-Karin Hardie Olsen" userId="e320bee9-3c44-4263-bfad-c0288f2c0ec5" providerId="ADAL" clId="{2E2AC092-3BA5-4E00-A94D-19F3A4DF3C5B}" dt="2024-12-22T08:33:55.922" v="968"/>
          <ac:spMkLst>
            <pc:docMk/>
            <pc:sldMk cId="1128141415" sldId="271"/>
            <ac:spMk id="5" creationId="{2C84C151-CBD3-5CF4-021B-B2C0E7F40DAA}"/>
          </ac:spMkLst>
        </pc:spChg>
        <pc:spChg chg="add del mod">
          <ac:chgData name="Ann-Karin Hardie Olsen" userId="e320bee9-3c44-4263-bfad-c0288f2c0ec5" providerId="ADAL" clId="{2E2AC092-3BA5-4E00-A94D-19F3A4DF3C5B}" dt="2024-12-22T08:29:56.418" v="960" actId="478"/>
          <ac:spMkLst>
            <pc:docMk/>
            <pc:sldMk cId="1128141415" sldId="271"/>
            <ac:spMk id="7" creationId="{B3497801-B659-0DBF-4300-249855581B97}"/>
          </ac:spMkLst>
        </pc:spChg>
        <pc:spChg chg="add mod">
          <ac:chgData name="Ann-Karin Hardie Olsen" userId="e320bee9-3c44-4263-bfad-c0288f2c0ec5" providerId="ADAL" clId="{2E2AC092-3BA5-4E00-A94D-19F3A4DF3C5B}" dt="2024-12-22T08:29:51.897" v="959"/>
          <ac:spMkLst>
            <pc:docMk/>
            <pc:sldMk cId="1128141415" sldId="271"/>
            <ac:spMk id="10" creationId="{E74A311C-936D-AD79-5412-0A5AB553B84A}"/>
          </ac:spMkLst>
        </pc:spChg>
        <pc:spChg chg="add mod">
          <ac:chgData name="Ann-Karin Hardie Olsen" userId="e320bee9-3c44-4263-bfad-c0288f2c0ec5" providerId="ADAL" clId="{2E2AC092-3BA5-4E00-A94D-19F3A4DF3C5B}" dt="2024-12-22T08:37:00.372" v="1012" actId="6549"/>
          <ac:spMkLst>
            <pc:docMk/>
            <pc:sldMk cId="1128141415" sldId="271"/>
            <ac:spMk id="11" creationId="{1038AC3C-A916-555B-6307-BDD20FDBE5D9}"/>
          </ac:spMkLst>
        </pc:spChg>
        <pc:cxnChg chg="mod">
          <ac:chgData name="Ann-Karin Hardie Olsen" userId="e320bee9-3c44-4263-bfad-c0288f2c0ec5" providerId="ADAL" clId="{2E2AC092-3BA5-4E00-A94D-19F3A4DF3C5B}" dt="2024-12-22T08:11:57.442" v="480" actId="208"/>
          <ac:cxnSpMkLst>
            <pc:docMk/>
            <pc:sldMk cId="1128141415" sldId="271"/>
            <ac:cxnSpMk id="2" creationId="{3FF2D6A1-8BF5-AA17-2527-4AB302EBC893}"/>
          </ac:cxnSpMkLst>
        </pc:cxnChg>
        <pc:cxnChg chg="mod">
          <ac:chgData name="Ann-Karin Hardie Olsen" userId="e320bee9-3c44-4263-bfad-c0288f2c0ec5" providerId="ADAL" clId="{2E2AC092-3BA5-4E00-A94D-19F3A4DF3C5B}" dt="2024-12-22T08:11:57.442" v="480" actId="208"/>
          <ac:cxnSpMkLst>
            <pc:docMk/>
            <pc:sldMk cId="1128141415" sldId="271"/>
            <ac:cxnSpMk id="4" creationId="{F7C1E8F4-9DDE-F03A-7CAA-13FAACC25E31}"/>
          </ac:cxnSpMkLst>
        </pc:cxnChg>
        <pc:cxnChg chg="mod">
          <ac:chgData name="Ann-Karin Hardie Olsen" userId="e320bee9-3c44-4263-bfad-c0288f2c0ec5" providerId="ADAL" clId="{2E2AC092-3BA5-4E00-A94D-19F3A4DF3C5B}" dt="2024-12-22T08:11:57.442" v="480" actId="208"/>
          <ac:cxnSpMkLst>
            <pc:docMk/>
            <pc:sldMk cId="1128141415" sldId="271"/>
            <ac:cxnSpMk id="6" creationId="{44B43130-A3D6-D7D6-A50C-CD7F52B858F8}"/>
          </ac:cxnSpMkLst>
        </pc:cxnChg>
        <pc:cxnChg chg="mod">
          <ac:chgData name="Ann-Karin Hardie Olsen" userId="e320bee9-3c44-4263-bfad-c0288f2c0ec5" providerId="ADAL" clId="{2E2AC092-3BA5-4E00-A94D-19F3A4DF3C5B}" dt="2024-12-22T08:11:57.442" v="480" actId="208"/>
          <ac:cxnSpMkLst>
            <pc:docMk/>
            <pc:sldMk cId="1128141415" sldId="271"/>
            <ac:cxnSpMk id="8" creationId="{20D44540-5685-2309-5FF5-A1DDFCC95ADB}"/>
          </ac:cxnSpMkLst>
        </pc:cxnChg>
        <pc:cxnChg chg="mod">
          <ac:chgData name="Ann-Karin Hardie Olsen" userId="e320bee9-3c44-4263-bfad-c0288f2c0ec5" providerId="ADAL" clId="{2E2AC092-3BA5-4E00-A94D-19F3A4DF3C5B}" dt="2024-12-22T08:11:57.442" v="480" actId="208"/>
          <ac:cxnSpMkLst>
            <pc:docMk/>
            <pc:sldMk cId="1128141415" sldId="271"/>
            <ac:cxnSpMk id="9" creationId="{9757D73F-C567-8DA3-DC48-955A526D2ADC}"/>
          </ac:cxnSpMkLst>
        </pc:cxnChg>
      </pc:sldChg>
      <pc:sldChg chg="addSp delSp modSp mod">
        <pc:chgData name="Ann-Karin Hardie Olsen" userId="e320bee9-3c44-4263-bfad-c0288f2c0ec5" providerId="ADAL" clId="{2E2AC092-3BA5-4E00-A94D-19F3A4DF3C5B}" dt="2024-12-22T08:33:43.972" v="965" actId="20577"/>
        <pc:sldMkLst>
          <pc:docMk/>
          <pc:sldMk cId="852268081" sldId="272"/>
        </pc:sldMkLst>
        <pc:spChg chg="mod">
          <ac:chgData name="Ann-Karin Hardie Olsen" userId="e320bee9-3c44-4263-bfad-c0288f2c0ec5" providerId="ADAL" clId="{2E2AC092-3BA5-4E00-A94D-19F3A4DF3C5B}" dt="2024-12-22T08:33:43.972" v="965" actId="20577"/>
          <ac:spMkLst>
            <pc:docMk/>
            <pc:sldMk cId="852268081" sldId="272"/>
            <ac:spMk id="5" creationId="{2C84C151-CBD3-5CF4-021B-B2C0E7F40DAA}"/>
          </ac:spMkLst>
        </pc:spChg>
        <pc:spChg chg="add del mod">
          <ac:chgData name="Ann-Karin Hardie Olsen" userId="e320bee9-3c44-4263-bfad-c0288f2c0ec5" providerId="ADAL" clId="{2E2AC092-3BA5-4E00-A94D-19F3A4DF3C5B}" dt="2024-12-22T08:30:05.666" v="962" actId="478"/>
          <ac:spMkLst>
            <pc:docMk/>
            <pc:sldMk cId="852268081" sldId="272"/>
            <ac:spMk id="7" creationId="{84304A6A-D546-FE36-38A4-FB48661A6530}"/>
          </ac:spMkLst>
        </pc:spChg>
        <pc:spChg chg="add mod">
          <ac:chgData name="Ann-Karin Hardie Olsen" userId="e320bee9-3c44-4263-bfad-c0288f2c0ec5" providerId="ADAL" clId="{2E2AC092-3BA5-4E00-A94D-19F3A4DF3C5B}" dt="2024-12-22T08:30:08.658" v="963"/>
          <ac:spMkLst>
            <pc:docMk/>
            <pc:sldMk cId="852268081" sldId="272"/>
            <ac:spMk id="8" creationId="{E488F139-FBEA-D12B-DADF-E448815DF387}"/>
          </ac:spMkLst>
        </pc:spChg>
        <pc:cxnChg chg="mod">
          <ac:chgData name="Ann-Karin Hardie Olsen" userId="e320bee9-3c44-4263-bfad-c0288f2c0ec5" providerId="ADAL" clId="{2E2AC092-3BA5-4E00-A94D-19F3A4DF3C5B}" dt="2024-12-22T08:12:09.009" v="481" actId="208"/>
          <ac:cxnSpMkLst>
            <pc:docMk/>
            <pc:sldMk cId="852268081" sldId="272"/>
            <ac:cxnSpMk id="3" creationId="{A90EBD89-90AA-6A14-8A31-252C0F94E34E}"/>
          </ac:cxnSpMkLst>
        </pc:cxnChg>
        <pc:cxnChg chg="mod">
          <ac:chgData name="Ann-Karin Hardie Olsen" userId="e320bee9-3c44-4263-bfad-c0288f2c0ec5" providerId="ADAL" clId="{2E2AC092-3BA5-4E00-A94D-19F3A4DF3C5B}" dt="2024-12-22T08:12:09.009" v="481" actId="208"/>
          <ac:cxnSpMkLst>
            <pc:docMk/>
            <pc:sldMk cId="852268081" sldId="272"/>
            <ac:cxnSpMk id="4" creationId="{ED7C363C-FFFE-52CC-7DC6-646C12AB0F0F}"/>
          </ac:cxnSpMkLst>
        </pc:cxnChg>
        <pc:cxnChg chg="mod">
          <ac:chgData name="Ann-Karin Hardie Olsen" userId="e320bee9-3c44-4263-bfad-c0288f2c0ec5" providerId="ADAL" clId="{2E2AC092-3BA5-4E00-A94D-19F3A4DF3C5B}" dt="2024-12-22T08:12:09.009" v="481" actId="208"/>
          <ac:cxnSpMkLst>
            <pc:docMk/>
            <pc:sldMk cId="852268081" sldId="272"/>
            <ac:cxnSpMk id="6" creationId="{EA0A41C6-1FA6-FA97-CD6E-D2325FEFD8EE}"/>
          </ac:cxnSpMkLst>
        </pc:cxnChg>
      </pc:sldChg>
      <pc:sldChg chg="addSp delSp modSp mod">
        <pc:chgData name="Ann-Karin Hardie Olsen" userId="e320bee9-3c44-4263-bfad-c0288f2c0ec5" providerId="ADAL" clId="{2E2AC092-3BA5-4E00-A94D-19F3A4DF3C5B}" dt="2024-12-22T08:39:16.365" v="1025" actId="20577"/>
        <pc:sldMkLst>
          <pc:docMk/>
          <pc:sldMk cId="3766932299" sldId="273"/>
        </pc:sldMkLst>
        <pc:spChg chg="mod">
          <ac:chgData name="Ann-Karin Hardie Olsen" userId="e320bee9-3c44-4263-bfad-c0288f2c0ec5" providerId="ADAL" clId="{2E2AC092-3BA5-4E00-A94D-19F3A4DF3C5B}" dt="2024-12-22T08:39:16.365" v="1025" actId="20577"/>
          <ac:spMkLst>
            <pc:docMk/>
            <pc:sldMk cId="3766932299" sldId="273"/>
            <ac:spMk id="5" creationId="{2C84C151-CBD3-5CF4-021B-B2C0E7F40DAA}"/>
          </ac:spMkLst>
        </pc:spChg>
        <pc:spChg chg="add del mod">
          <ac:chgData name="Ann-Karin Hardie Olsen" userId="e320bee9-3c44-4263-bfad-c0288f2c0ec5" providerId="ADAL" clId="{2E2AC092-3BA5-4E00-A94D-19F3A4DF3C5B}" dt="2024-12-22T08:35:43.800" v="977" actId="478"/>
          <ac:spMkLst>
            <pc:docMk/>
            <pc:sldMk cId="3766932299" sldId="273"/>
            <ac:spMk id="6" creationId="{E9E7130C-5D4B-6079-FD64-2FD7D18FAFE7}"/>
          </ac:spMkLst>
        </pc:spChg>
        <pc:spChg chg="add mod">
          <ac:chgData name="Ann-Karin Hardie Olsen" userId="e320bee9-3c44-4263-bfad-c0288f2c0ec5" providerId="ADAL" clId="{2E2AC092-3BA5-4E00-A94D-19F3A4DF3C5B}" dt="2024-12-22T08:35:45.656" v="978"/>
          <ac:spMkLst>
            <pc:docMk/>
            <pc:sldMk cId="3766932299" sldId="273"/>
            <ac:spMk id="7" creationId="{869F259E-E239-7774-78C3-90985077DBAD}"/>
          </ac:spMkLst>
        </pc:spChg>
        <pc:cxnChg chg="mod">
          <ac:chgData name="Ann-Karin Hardie Olsen" userId="e320bee9-3c44-4263-bfad-c0288f2c0ec5" providerId="ADAL" clId="{2E2AC092-3BA5-4E00-A94D-19F3A4DF3C5B}" dt="2024-12-22T08:35:30.516" v="976" actId="1076"/>
          <ac:cxnSpMkLst>
            <pc:docMk/>
            <pc:sldMk cId="3766932299" sldId="273"/>
            <ac:cxnSpMk id="2" creationId="{973161ED-FE6E-AFD6-E610-82A067B95CC8}"/>
          </ac:cxnSpMkLst>
        </pc:cxnChg>
        <pc:cxnChg chg="mod">
          <ac:chgData name="Ann-Karin Hardie Olsen" userId="e320bee9-3c44-4263-bfad-c0288f2c0ec5" providerId="ADAL" clId="{2E2AC092-3BA5-4E00-A94D-19F3A4DF3C5B}" dt="2024-12-22T08:12:17.999" v="482" actId="208"/>
          <ac:cxnSpMkLst>
            <pc:docMk/>
            <pc:sldMk cId="3766932299" sldId="273"/>
            <ac:cxnSpMk id="3" creationId="{0146D846-97EB-27FC-F328-7D2488CBBD9A}"/>
          </ac:cxnSpMkLst>
        </pc:cxnChg>
      </pc:sldChg>
      <pc:sldChg chg="addSp delSp modSp mod">
        <pc:chgData name="Ann-Karin Hardie Olsen" userId="e320bee9-3c44-4263-bfad-c0288f2c0ec5" providerId="ADAL" clId="{2E2AC092-3BA5-4E00-A94D-19F3A4DF3C5B}" dt="2024-12-22T08:39:12.324" v="1021" actId="20577"/>
        <pc:sldMkLst>
          <pc:docMk/>
          <pc:sldMk cId="3240163265" sldId="274"/>
        </pc:sldMkLst>
        <pc:spChg chg="mod">
          <ac:chgData name="Ann-Karin Hardie Olsen" userId="e320bee9-3c44-4263-bfad-c0288f2c0ec5" providerId="ADAL" clId="{2E2AC092-3BA5-4E00-A94D-19F3A4DF3C5B}" dt="2024-12-22T08:39:12.324" v="1021" actId="20577"/>
          <ac:spMkLst>
            <pc:docMk/>
            <pc:sldMk cId="3240163265" sldId="274"/>
            <ac:spMk id="5" creationId="{2C84C151-CBD3-5CF4-021B-B2C0E7F40DAA}"/>
          </ac:spMkLst>
        </pc:spChg>
        <pc:spChg chg="add del mod">
          <ac:chgData name="Ann-Karin Hardie Olsen" userId="e320bee9-3c44-4263-bfad-c0288f2c0ec5" providerId="ADAL" clId="{2E2AC092-3BA5-4E00-A94D-19F3A4DF3C5B}" dt="2024-12-22T08:35:50.586" v="979" actId="478"/>
          <ac:spMkLst>
            <pc:docMk/>
            <pc:sldMk cId="3240163265" sldId="274"/>
            <ac:spMk id="7" creationId="{9E475E73-1067-03AF-4E97-1FC0933BD605}"/>
          </ac:spMkLst>
        </pc:spChg>
        <pc:spChg chg="add mod">
          <ac:chgData name="Ann-Karin Hardie Olsen" userId="e320bee9-3c44-4263-bfad-c0288f2c0ec5" providerId="ADAL" clId="{2E2AC092-3BA5-4E00-A94D-19F3A4DF3C5B}" dt="2024-12-22T08:35:51.754" v="980"/>
          <ac:spMkLst>
            <pc:docMk/>
            <pc:sldMk cId="3240163265" sldId="274"/>
            <ac:spMk id="8" creationId="{90C681D1-3B50-CBA5-6CAF-FD2182AC4D9D}"/>
          </ac:spMkLst>
        </pc:spChg>
        <pc:cxnChg chg="mod">
          <ac:chgData name="Ann-Karin Hardie Olsen" userId="e320bee9-3c44-4263-bfad-c0288f2c0ec5" providerId="ADAL" clId="{2E2AC092-3BA5-4E00-A94D-19F3A4DF3C5B}" dt="2024-12-22T08:35:16.805" v="974" actId="1076"/>
          <ac:cxnSpMkLst>
            <pc:docMk/>
            <pc:sldMk cId="3240163265" sldId="274"/>
            <ac:cxnSpMk id="2" creationId="{11CEC525-EB0F-CB4A-0032-C87691CEB377}"/>
          </ac:cxnSpMkLst>
        </pc:cxnChg>
        <pc:cxnChg chg="mod">
          <ac:chgData name="Ann-Karin Hardie Olsen" userId="e320bee9-3c44-4263-bfad-c0288f2c0ec5" providerId="ADAL" clId="{2E2AC092-3BA5-4E00-A94D-19F3A4DF3C5B}" dt="2024-12-22T08:35:19.761" v="975" actId="1076"/>
          <ac:cxnSpMkLst>
            <pc:docMk/>
            <pc:sldMk cId="3240163265" sldId="274"/>
            <ac:cxnSpMk id="4" creationId="{F7781B47-DBFD-A9D7-BE45-938B27F2DDA5}"/>
          </ac:cxnSpMkLst>
        </pc:cxnChg>
        <pc:cxnChg chg="mod">
          <ac:chgData name="Ann-Karin Hardie Olsen" userId="e320bee9-3c44-4263-bfad-c0288f2c0ec5" providerId="ADAL" clId="{2E2AC092-3BA5-4E00-A94D-19F3A4DF3C5B}" dt="2024-12-22T08:35:14.959" v="973" actId="1076"/>
          <ac:cxnSpMkLst>
            <pc:docMk/>
            <pc:sldMk cId="3240163265" sldId="274"/>
            <ac:cxnSpMk id="6" creationId="{DF2D8246-54EC-2741-73E8-61ACED8CC4B5}"/>
          </ac:cxnSpMkLst>
        </pc:cxnChg>
      </pc:sldChg>
    </pc:docChg>
  </pc:docChgLst>
  <pc:docChgLst>
    <pc:chgData name="Ann-Karin Hardie Olsen" userId="S::anka@nilu.no::e320bee9-3c44-4263-bfad-c0288f2c0ec5" providerId="AD" clId="Web-{1D817D82-CD8C-778C-4BDA-21DFFE9F95E4}"/>
    <pc:docChg chg="modSld">
      <pc:chgData name="Ann-Karin Hardie Olsen" userId="S::anka@nilu.no::e320bee9-3c44-4263-bfad-c0288f2c0ec5" providerId="AD" clId="Web-{1D817D82-CD8C-778C-4BDA-21DFFE9F95E4}" dt="2024-11-01T15:10:29.706" v="6"/>
      <pc:docMkLst>
        <pc:docMk/>
      </pc:docMkLst>
      <pc:sldChg chg="addSp delSp modSp">
        <pc:chgData name="Ann-Karin Hardie Olsen" userId="S::anka@nilu.no::e320bee9-3c44-4263-bfad-c0288f2c0ec5" providerId="AD" clId="Web-{1D817D82-CD8C-778C-4BDA-21DFFE9F95E4}" dt="2024-11-01T15:10:29.706" v="6"/>
        <pc:sldMkLst>
          <pc:docMk/>
          <pc:sldMk cId="3796257797" sldId="262"/>
        </pc:sldMkLst>
        <pc:spChg chg="mod">
          <ac:chgData name="Ann-Karin Hardie Olsen" userId="S::anka@nilu.no::e320bee9-3c44-4263-bfad-c0288f2c0ec5" providerId="AD" clId="Web-{1D817D82-CD8C-778C-4BDA-21DFFE9F95E4}" dt="2024-11-01T15:10:26.393" v="5" actId="20577"/>
          <ac:spMkLst>
            <pc:docMk/>
            <pc:sldMk cId="3796257797" sldId="262"/>
            <ac:spMk id="2" creationId="{E1C6E756-B19F-40C5-2E2C-15C32AF2D2AF}"/>
          </ac:spMkLst>
        </pc:spChg>
        <pc:spChg chg="del">
          <ac:chgData name="Ann-Karin Hardie Olsen" userId="S::anka@nilu.no::e320bee9-3c44-4263-bfad-c0288f2c0ec5" providerId="AD" clId="Web-{1D817D82-CD8C-778C-4BDA-21DFFE9F95E4}" dt="2024-11-01T15:10:29.706" v="6"/>
          <ac:spMkLst>
            <pc:docMk/>
            <pc:sldMk cId="3796257797" sldId="262"/>
            <ac:spMk id="3" creationId="{85C30EE4-AF3D-26C6-8477-75006A80F132}"/>
          </ac:spMkLst>
        </pc:spChg>
        <pc:spChg chg="add mod">
          <ac:chgData name="Ann-Karin Hardie Olsen" userId="S::anka@nilu.no::e320bee9-3c44-4263-bfad-c0288f2c0ec5" providerId="AD" clId="Web-{1D817D82-CD8C-778C-4BDA-21DFFE9F95E4}" dt="2024-11-01T15:10:29.706" v="6"/>
          <ac:spMkLst>
            <pc:docMk/>
            <pc:sldMk cId="3796257797" sldId="262"/>
            <ac:spMk id="5" creationId="{F6CCA351-3624-F683-E6D4-6B5DEFE84A64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F46EF7-8453-48EF-AFBD-78508261851D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CDA110-455E-41DE-AD57-4227D5F5320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28303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1CDA110-455E-41DE-AD57-4227D5F53207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24742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1CDA110-455E-41DE-AD57-4227D5F53207}" type="slidenum">
              <a:rPr lang="en-GB" smtClean="0"/>
              <a:t>1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18280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8091F5-C81D-C585-65B1-A06347102C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9EF7B0-66EE-80EB-3648-ADABD18AF3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2228C1-398E-1AD2-80C5-F65CED73B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349FFC-B9CB-BBED-57B9-7969CF47F6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980E68-56ED-9FAE-27A4-E07FEEFAD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6041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4D17B5-64CD-F9BC-DFC7-36B2A6B8FC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39B326-1346-CEFF-0C48-524684921C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4467F5-F9CF-0650-26F1-A3F3E6151A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FA1BE0-BD8F-528B-ACF5-09684E647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1B8751-4AB0-61A3-7548-5EF858B44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35652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B221717-BB24-64A4-BF80-92E49849C5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D48F64-FD5C-F2AA-D9DF-9F3E20CC49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2F60BE-7121-E283-E80C-C697DF4627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37E766-1B3C-FECD-FB8C-128E428C53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9DF8B3-E613-274A-E615-A63591FF8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57490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DD047D-0DA7-2358-1957-808B8BAF11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BBCC27-8FC8-3618-3D4B-5FB1BD12F3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C3425A-C4DF-82CD-0FFD-CD912F6F5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22696B-5C71-8DDC-5EDB-9B23F38535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B87DA0-234B-D0C5-81BB-56408C9D0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8982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78B311-F21E-6456-6539-C2036D4BAF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6F9235-D75F-671B-36D9-84D71F59A8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AEACB2-68EB-4191-5B8F-62DF433D49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A482C7-65A5-135C-107C-740766DD7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550197-DC3F-64CC-D873-DAF93B6FF6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6128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556A8E-38F2-F816-E85D-C55E0BF461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E12792-1D80-DE63-0744-6BC9B3EF2F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A415AB-AB7E-FF9F-6C9A-A8F2D6E066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E5E991-2AD3-B637-ECA0-039163099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24B97F-A624-397E-58A0-1ABE90437B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650B6E-EA9B-71FF-8EE5-6FAC48A79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6592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4ADC9E-01F0-0F9B-B366-2F5FEA549D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0F2F7B-F8A7-A214-BAD8-EFE520BB49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7976B3-84E5-8D1E-1537-CD6CC53D9D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2FC9F05-31FC-62F9-D5A5-48F07D1920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68420AB-E9D2-F139-2D0E-6AC21C4502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1C594C4-49DB-DE7E-D6F0-1092AC9FC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9210BF-8C54-64C3-9FBD-B79AD1452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E4B13D-DE6B-9BAC-C8F8-6A8398D2AD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1362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E326D-615F-B095-7D27-52EC030504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00BB778-14DC-C59B-E03E-4F79908B9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A3E106-9EDA-9782-682F-EEB3D7F613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65FAEDE-63D6-0BB9-3B5E-D958107FA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48847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4B5C6C-22C5-17BC-D153-A1B27AC17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3A70FE5-A5B4-962A-0E19-E809AF78D9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06E63B6-75EE-B153-2A58-ABFA19DD40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6466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6E29DD-97FF-0699-C9B0-ADAC4F47E7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B8FA9E-BC37-8BFE-666D-A2CA3F9B62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CBDE41-A352-D79C-3667-5A909F2A5C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F1F22E-7382-C8E5-FF43-6B2383ECB7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F64906-4374-33A4-E902-8060462CBB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DBF41A-4113-AEAB-57EF-FBB627193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0157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9456B6-8D08-6764-B45A-90FA475AE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5011497-C44C-C0CC-3FA6-38316F3EF9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93E4CC-B151-D3F1-9822-2B6ACA0F91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BD9037-4F77-A628-F7BD-48D6A3A1E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E68C11-4888-B72A-FFCD-32E271A4C0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430583-5786-7D3D-973D-D600965CA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5998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D880D9A-D088-4071-7386-9AEE4A7FFD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7F3B87-B0C4-1015-02F0-ED21449DAF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1C2548-54E6-DE87-6245-10236911FA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602FF7-09DB-7198-2847-A9E9ECCAA1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9C0435-7778-0DCC-5419-F5A1B053369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3805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E1C6E756-B19F-40C5-2E2C-15C32AF2D2A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nb-NO" sz="5400"/>
              <a:t>Training to </a:t>
            </a:r>
            <a:r>
              <a:rPr lang="nb-NO" sz="5400" err="1"/>
              <a:t>select</a:t>
            </a:r>
            <a:r>
              <a:rPr lang="nb-NO" sz="5400"/>
              <a:t> </a:t>
            </a:r>
            <a:r>
              <a:rPr lang="nb-NO" sz="5400" err="1"/>
              <a:t>which</a:t>
            </a:r>
            <a:r>
              <a:rPr lang="nb-NO" sz="5400"/>
              <a:t> </a:t>
            </a:r>
            <a:r>
              <a:rPr lang="nb-NO" sz="5400" err="1"/>
              <a:t>testicular</a:t>
            </a:r>
            <a:r>
              <a:rPr lang="nb-NO" sz="5400"/>
              <a:t> </a:t>
            </a:r>
            <a:r>
              <a:rPr lang="nb-NO" sz="5400" err="1"/>
              <a:t>comets</a:t>
            </a:r>
            <a:r>
              <a:rPr lang="nb-NO" sz="5400"/>
              <a:t> to score</a:t>
            </a:r>
            <a:br>
              <a:rPr lang="nb-NO" sz="5400"/>
            </a:br>
            <a:r>
              <a:rPr lang="nb-NO" sz="5400"/>
              <a:t>- </a:t>
            </a:r>
            <a:r>
              <a:rPr lang="nb-NO" sz="5400" err="1"/>
              <a:t>with</a:t>
            </a:r>
            <a:r>
              <a:rPr lang="nb-NO" sz="5400"/>
              <a:t> </a:t>
            </a:r>
            <a:r>
              <a:rPr lang="nb-NO" sz="5400" err="1"/>
              <a:t>results</a:t>
            </a:r>
            <a:endParaRPr lang="en-US" err="1"/>
          </a:p>
        </p:txBody>
      </p:sp>
      <p:sp>
        <p:nvSpPr>
          <p:cNvPr id="5" name="Subtitle 4">
            <a:extLst>
              <a:ext uri="{FF2B5EF4-FFF2-40B4-BE49-F238E27FC236}">
                <a16:creationId xmlns:a16="http://schemas.microsoft.com/office/drawing/2014/main" id="{F6CCA351-3624-F683-E6D4-6B5DEFE84A64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25779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2C84C151-CBD3-5CF4-021B-B2C0E7F40DAA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/>
              <a:t>PS (untreated)</a:t>
            </a:r>
            <a:endParaRPr lang="en-GB" sz="4000"/>
          </a:p>
        </p:txBody>
      </p:sp>
      <p:pic>
        <p:nvPicPr>
          <p:cNvPr id="3" name="Picture 2" descr="A group of white dots in the sky with Gallery Arcturus in the background&#10;&#10;Description automatically generated">
            <a:extLst>
              <a:ext uri="{FF2B5EF4-FFF2-40B4-BE49-F238E27FC236}">
                <a16:creationId xmlns:a16="http://schemas.microsoft.com/office/drawing/2014/main" id="{8E7EFB5E-5E4C-FEC8-9B6D-606ACAB1FF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6213" y="895318"/>
            <a:ext cx="7727700" cy="5760000"/>
          </a:xfrm>
          <a:prstGeom prst="rect">
            <a:avLst/>
          </a:prstGeom>
        </p:spPr>
      </p:pic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B2717746-1EAA-3A45-8D11-272C7E2BD3C5}"/>
              </a:ext>
            </a:extLst>
          </p:cNvPr>
          <p:cNvCxnSpPr>
            <a:cxnSpLocks/>
          </p:cNvCxnSpPr>
          <p:nvPr/>
        </p:nvCxnSpPr>
        <p:spPr>
          <a:xfrm>
            <a:off x="5115320" y="3064398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FBF80486-7B2D-262D-B145-78799F069086}"/>
              </a:ext>
            </a:extLst>
          </p:cNvPr>
          <p:cNvCxnSpPr/>
          <p:nvPr/>
        </p:nvCxnSpPr>
        <p:spPr>
          <a:xfrm>
            <a:off x="3066602" y="5147841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AC077FFF-E6F7-3DEC-4B9F-340415D92B29}"/>
              </a:ext>
            </a:extLst>
          </p:cNvPr>
          <p:cNvCxnSpPr/>
          <p:nvPr/>
        </p:nvCxnSpPr>
        <p:spPr>
          <a:xfrm>
            <a:off x="7337660" y="2485663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E945A3E1-0C80-96F0-53A8-52239DDB4FCA}"/>
              </a:ext>
            </a:extLst>
          </p:cNvPr>
          <p:cNvCxnSpPr/>
          <p:nvPr/>
        </p:nvCxnSpPr>
        <p:spPr>
          <a:xfrm>
            <a:off x="8761346" y="1464785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AC983EBF-FF4C-B4E5-946E-FB9EC8DC4A3B}"/>
              </a:ext>
            </a:extLst>
          </p:cNvPr>
          <p:cNvCxnSpPr>
            <a:cxnSpLocks/>
          </p:cNvCxnSpPr>
          <p:nvPr/>
        </p:nvCxnSpPr>
        <p:spPr>
          <a:xfrm flipV="1">
            <a:off x="5497285" y="1917778"/>
            <a:ext cx="161354" cy="200976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4" name="TekstSylinder 3">
            <a:extLst>
              <a:ext uri="{FF2B5EF4-FFF2-40B4-BE49-F238E27FC236}">
                <a16:creationId xmlns:a16="http://schemas.microsoft.com/office/drawing/2014/main" id="{73B84F19-426D-F322-550D-B1B887DB0E3E}"/>
              </a:ext>
            </a:extLst>
          </p:cNvPr>
          <p:cNvSpPr txBox="1"/>
          <p:nvPr/>
        </p:nvSpPr>
        <p:spPr>
          <a:xfrm>
            <a:off x="114300" y="2233246"/>
            <a:ext cx="1749669" cy="3077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>
                <a:solidFill>
                  <a:srgbClr val="00B050"/>
                </a:solidFill>
              </a:rPr>
              <a:t>Green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 = </a:t>
            </a:r>
            <a:r>
              <a:rPr lang="nb-NO" err="1"/>
              <a:t>scored</a:t>
            </a:r>
            <a:br>
              <a:rPr lang="nb-NO"/>
            </a:br>
            <a:endParaRPr lang="nb-NO"/>
          </a:p>
          <a:p>
            <a:r>
              <a:rPr lang="nb-NO" sz="1400" err="1"/>
              <a:t>Confirm</a:t>
            </a:r>
            <a:r>
              <a:rPr lang="nb-NO" sz="1400"/>
              <a:t> </a:t>
            </a:r>
            <a:r>
              <a:rPr lang="nb-NO" sz="1400" err="1"/>
              <a:t>each</a:t>
            </a:r>
            <a:r>
              <a:rPr lang="nb-NO" sz="1400"/>
              <a:t> </a:t>
            </a:r>
            <a:r>
              <a:rPr lang="nb-NO" sz="1400" err="1"/>
              <a:t>comet</a:t>
            </a:r>
            <a:r>
              <a:rPr lang="nb-NO" sz="1400"/>
              <a:t> as PS at scoring by </a:t>
            </a:r>
            <a:r>
              <a:rPr lang="nb-NO" sz="1400" err="1"/>
              <a:t>evaluating</a:t>
            </a:r>
            <a:r>
              <a:rPr lang="nb-NO" sz="1400"/>
              <a:t> </a:t>
            </a:r>
            <a:r>
              <a:rPr lang="nb-NO" sz="1400" err="1"/>
              <a:t>the</a:t>
            </a:r>
            <a:r>
              <a:rPr lang="nb-NO" sz="1400"/>
              <a:t> Total </a:t>
            </a:r>
            <a:r>
              <a:rPr lang="nb-NO" sz="1400" err="1"/>
              <a:t>Intensity</a:t>
            </a:r>
            <a:r>
              <a:rPr lang="nb-NO" sz="1400"/>
              <a:t> </a:t>
            </a:r>
            <a:r>
              <a:rPr lang="nb-NO" sz="1400" err="1"/>
              <a:t>of</a:t>
            </a:r>
            <a:r>
              <a:rPr lang="nb-NO" sz="1400"/>
              <a:t> </a:t>
            </a:r>
            <a:r>
              <a:rPr lang="nb-NO" sz="1400" err="1"/>
              <a:t>each</a:t>
            </a:r>
            <a:r>
              <a:rPr lang="nb-NO" sz="1400"/>
              <a:t> </a:t>
            </a:r>
            <a:r>
              <a:rPr lang="nb-NO" sz="1400" err="1"/>
              <a:t>comet</a:t>
            </a:r>
            <a:r>
              <a:rPr lang="nb-NO" sz="1400"/>
              <a:t> </a:t>
            </a:r>
            <a:r>
              <a:rPr lang="nb-NO" sz="1400" err="1"/>
              <a:t>based</a:t>
            </a:r>
            <a:r>
              <a:rPr lang="nb-NO" sz="1400"/>
              <a:t> </a:t>
            </a:r>
            <a:r>
              <a:rPr lang="nb-NO" sz="1400" err="1"/>
              <a:t>on</a:t>
            </a:r>
            <a:r>
              <a:rPr lang="nb-NO" sz="1400"/>
              <a:t> </a:t>
            </a:r>
            <a:r>
              <a:rPr lang="nb-NO" sz="1400" err="1"/>
              <a:t>levels</a:t>
            </a:r>
            <a:r>
              <a:rPr lang="nb-NO" sz="1400"/>
              <a:t> </a:t>
            </a:r>
            <a:r>
              <a:rPr lang="nb-NO" sz="1400" err="1"/>
              <a:t>observed</a:t>
            </a:r>
            <a:r>
              <a:rPr lang="nb-NO" sz="1400"/>
              <a:t> during scoring </a:t>
            </a:r>
            <a:r>
              <a:rPr lang="nb-NO" sz="1400" err="1"/>
              <a:t>of</a:t>
            </a:r>
            <a:r>
              <a:rPr lang="nb-NO" sz="1400"/>
              <a:t> «all </a:t>
            </a:r>
            <a:r>
              <a:rPr lang="nb-NO" sz="1400" err="1"/>
              <a:t>round</a:t>
            </a:r>
            <a:r>
              <a:rPr lang="nb-NO" sz="1400"/>
              <a:t> </a:t>
            </a:r>
            <a:r>
              <a:rPr lang="nb-NO" sz="1400" err="1"/>
              <a:t>nucleoids</a:t>
            </a:r>
            <a:r>
              <a:rPr lang="nb-NO" sz="1400"/>
              <a:t>»</a:t>
            </a:r>
          </a:p>
        </p:txBody>
      </p:sp>
    </p:spTree>
    <p:extLst>
      <p:ext uri="{BB962C8B-B14F-4D97-AF65-F5344CB8AC3E}">
        <p14:creationId xmlns:p14="http://schemas.microsoft.com/office/powerpoint/2010/main" val="233056634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2C84C151-CBD3-5CF4-021B-B2C0E7F40DAA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/>
              <a:t>PS (untreated)</a:t>
            </a:r>
            <a:endParaRPr lang="en-GB" sz="4000"/>
          </a:p>
        </p:txBody>
      </p:sp>
      <p:pic>
        <p:nvPicPr>
          <p:cNvPr id="10" name="Picture 9" descr="A group of white dots in the sky&#10;&#10;Description automatically generated">
            <a:extLst>
              <a:ext uri="{FF2B5EF4-FFF2-40B4-BE49-F238E27FC236}">
                <a16:creationId xmlns:a16="http://schemas.microsoft.com/office/drawing/2014/main" id="{9F41859D-E49A-15C6-4C53-8B2DC1E8FC8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8589" y="821802"/>
            <a:ext cx="7727702" cy="5760000"/>
          </a:xfrm>
          <a:prstGeom prst="rect">
            <a:avLst/>
          </a:prstGeom>
        </p:spPr>
      </p:pic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4884DE11-DE8B-2090-BC89-D6A7351D47BE}"/>
              </a:ext>
            </a:extLst>
          </p:cNvPr>
          <p:cNvCxnSpPr>
            <a:cxnSpLocks/>
          </p:cNvCxnSpPr>
          <p:nvPr/>
        </p:nvCxnSpPr>
        <p:spPr>
          <a:xfrm>
            <a:off x="3547777" y="3429000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C8C4AA55-7203-17BA-D828-E38D17B247C7}"/>
              </a:ext>
            </a:extLst>
          </p:cNvPr>
          <p:cNvCxnSpPr>
            <a:cxnSpLocks/>
          </p:cNvCxnSpPr>
          <p:nvPr/>
        </p:nvCxnSpPr>
        <p:spPr>
          <a:xfrm>
            <a:off x="4307798" y="1051577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D3165F8E-7BB7-F525-0AB5-58ACB853728F}"/>
              </a:ext>
            </a:extLst>
          </p:cNvPr>
          <p:cNvCxnSpPr>
            <a:cxnSpLocks/>
          </p:cNvCxnSpPr>
          <p:nvPr/>
        </p:nvCxnSpPr>
        <p:spPr>
          <a:xfrm>
            <a:off x="7526011" y="2280626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67899BC6-1EC3-004E-2EDD-A0ED759F1B97}"/>
              </a:ext>
            </a:extLst>
          </p:cNvPr>
          <p:cNvCxnSpPr>
            <a:cxnSpLocks/>
          </p:cNvCxnSpPr>
          <p:nvPr/>
        </p:nvCxnSpPr>
        <p:spPr>
          <a:xfrm>
            <a:off x="6290977" y="3064398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3" name="TekstSylinder 2">
            <a:extLst>
              <a:ext uri="{FF2B5EF4-FFF2-40B4-BE49-F238E27FC236}">
                <a16:creationId xmlns:a16="http://schemas.microsoft.com/office/drawing/2014/main" id="{B73B52E5-D676-3BAF-6F20-B03DA40EB4C9}"/>
              </a:ext>
            </a:extLst>
          </p:cNvPr>
          <p:cNvSpPr txBox="1"/>
          <p:nvPr/>
        </p:nvSpPr>
        <p:spPr>
          <a:xfrm>
            <a:off x="114300" y="2233246"/>
            <a:ext cx="1749669" cy="3077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>
                <a:solidFill>
                  <a:srgbClr val="00B050"/>
                </a:solidFill>
              </a:rPr>
              <a:t>Green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 = </a:t>
            </a:r>
            <a:r>
              <a:rPr lang="nb-NO" err="1"/>
              <a:t>scored</a:t>
            </a:r>
            <a:br>
              <a:rPr lang="nb-NO"/>
            </a:br>
            <a:endParaRPr lang="nb-NO"/>
          </a:p>
          <a:p>
            <a:r>
              <a:rPr lang="nb-NO" sz="1400" err="1"/>
              <a:t>Confirm</a:t>
            </a:r>
            <a:r>
              <a:rPr lang="nb-NO" sz="1400"/>
              <a:t> </a:t>
            </a:r>
            <a:r>
              <a:rPr lang="nb-NO" sz="1400" err="1"/>
              <a:t>each</a:t>
            </a:r>
            <a:r>
              <a:rPr lang="nb-NO" sz="1400"/>
              <a:t> </a:t>
            </a:r>
            <a:r>
              <a:rPr lang="nb-NO" sz="1400" err="1"/>
              <a:t>comet</a:t>
            </a:r>
            <a:r>
              <a:rPr lang="nb-NO" sz="1400"/>
              <a:t> as PS at scoring by </a:t>
            </a:r>
            <a:r>
              <a:rPr lang="nb-NO" sz="1400" err="1"/>
              <a:t>evaluating</a:t>
            </a:r>
            <a:r>
              <a:rPr lang="nb-NO" sz="1400"/>
              <a:t> </a:t>
            </a:r>
            <a:r>
              <a:rPr lang="nb-NO" sz="1400" err="1"/>
              <a:t>the</a:t>
            </a:r>
            <a:r>
              <a:rPr lang="nb-NO" sz="1400"/>
              <a:t> Total </a:t>
            </a:r>
            <a:r>
              <a:rPr lang="nb-NO" sz="1400" err="1"/>
              <a:t>Intensity</a:t>
            </a:r>
            <a:r>
              <a:rPr lang="nb-NO" sz="1400"/>
              <a:t> </a:t>
            </a:r>
            <a:r>
              <a:rPr lang="nb-NO" sz="1400" err="1"/>
              <a:t>of</a:t>
            </a:r>
            <a:r>
              <a:rPr lang="nb-NO" sz="1400"/>
              <a:t> </a:t>
            </a:r>
            <a:r>
              <a:rPr lang="nb-NO" sz="1400" err="1"/>
              <a:t>each</a:t>
            </a:r>
            <a:r>
              <a:rPr lang="nb-NO" sz="1400"/>
              <a:t> </a:t>
            </a:r>
            <a:r>
              <a:rPr lang="nb-NO" sz="1400" err="1"/>
              <a:t>comet</a:t>
            </a:r>
            <a:r>
              <a:rPr lang="nb-NO" sz="1400"/>
              <a:t> </a:t>
            </a:r>
            <a:r>
              <a:rPr lang="nb-NO" sz="1400" err="1"/>
              <a:t>based</a:t>
            </a:r>
            <a:r>
              <a:rPr lang="nb-NO" sz="1400"/>
              <a:t> </a:t>
            </a:r>
            <a:r>
              <a:rPr lang="nb-NO" sz="1400" err="1"/>
              <a:t>on</a:t>
            </a:r>
            <a:r>
              <a:rPr lang="nb-NO" sz="1400"/>
              <a:t> </a:t>
            </a:r>
            <a:r>
              <a:rPr lang="nb-NO" sz="1400" err="1"/>
              <a:t>levels</a:t>
            </a:r>
            <a:r>
              <a:rPr lang="nb-NO" sz="1400"/>
              <a:t> </a:t>
            </a:r>
            <a:r>
              <a:rPr lang="nb-NO" sz="1400" err="1"/>
              <a:t>observed</a:t>
            </a:r>
            <a:r>
              <a:rPr lang="nb-NO" sz="1400"/>
              <a:t> during scoring </a:t>
            </a:r>
            <a:r>
              <a:rPr lang="nb-NO" sz="1400" err="1"/>
              <a:t>of</a:t>
            </a:r>
            <a:r>
              <a:rPr lang="nb-NO" sz="1400"/>
              <a:t> «all </a:t>
            </a:r>
            <a:r>
              <a:rPr lang="nb-NO" sz="1400" err="1"/>
              <a:t>round</a:t>
            </a:r>
            <a:r>
              <a:rPr lang="nb-NO" sz="1400"/>
              <a:t> </a:t>
            </a:r>
            <a:r>
              <a:rPr lang="nb-NO" sz="1400" err="1"/>
              <a:t>nucleoids</a:t>
            </a:r>
            <a:r>
              <a:rPr lang="nb-NO" sz="1400"/>
              <a:t>»</a:t>
            </a:r>
          </a:p>
        </p:txBody>
      </p:sp>
    </p:spTree>
    <p:extLst>
      <p:ext uri="{BB962C8B-B14F-4D97-AF65-F5344CB8AC3E}">
        <p14:creationId xmlns:p14="http://schemas.microsoft.com/office/powerpoint/2010/main" val="335626503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2C84C151-CBD3-5CF4-021B-B2C0E7F40DAA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/>
              <a:t>PS (</a:t>
            </a:r>
            <a:r>
              <a:rPr lang="nb-NO" sz="4000" err="1"/>
              <a:t>treated</a:t>
            </a:r>
            <a:r>
              <a:rPr lang="nb-NO" sz="4000"/>
              <a:t>), </a:t>
            </a:r>
            <a:r>
              <a:rPr lang="en-US" sz="4000"/>
              <a:t>low damage (~20 % TI)</a:t>
            </a:r>
            <a:endParaRPr lang="en-GB" sz="4000"/>
          </a:p>
        </p:txBody>
      </p:sp>
      <p:pic>
        <p:nvPicPr>
          <p:cNvPr id="3" name="Picture 2" descr="A group of bright lights in the sky&#10;&#10;Description automatically generated">
            <a:extLst>
              <a:ext uri="{FF2B5EF4-FFF2-40B4-BE49-F238E27FC236}">
                <a16:creationId xmlns:a16="http://schemas.microsoft.com/office/drawing/2014/main" id="{A368E0E4-8F96-128E-F319-1115069B32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2150" y="884092"/>
            <a:ext cx="7727700" cy="5760000"/>
          </a:xfrm>
          <a:prstGeom prst="rect">
            <a:avLst/>
          </a:prstGeom>
        </p:spPr>
      </p:pic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3FF2D6A1-8BF5-AA17-2527-4AB302EBC893}"/>
              </a:ext>
            </a:extLst>
          </p:cNvPr>
          <p:cNvCxnSpPr>
            <a:cxnSpLocks/>
          </p:cNvCxnSpPr>
          <p:nvPr/>
        </p:nvCxnSpPr>
        <p:spPr>
          <a:xfrm>
            <a:off x="2930260" y="2470631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F7C1E8F4-9DDE-F03A-7CAA-13FAACC25E31}"/>
              </a:ext>
            </a:extLst>
          </p:cNvPr>
          <p:cNvCxnSpPr>
            <a:cxnSpLocks/>
          </p:cNvCxnSpPr>
          <p:nvPr/>
        </p:nvCxnSpPr>
        <p:spPr>
          <a:xfrm>
            <a:off x="3476525" y="4073801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44B43130-A3D6-D7D6-A50C-CD7F52B858F8}"/>
              </a:ext>
            </a:extLst>
          </p:cNvPr>
          <p:cNvCxnSpPr>
            <a:cxnSpLocks/>
          </p:cNvCxnSpPr>
          <p:nvPr/>
        </p:nvCxnSpPr>
        <p:spPr>
          <a:xfrm>
            <a:off x="3351006" y="6045158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20D44540-5685-2309-5FF5-A1DDFCC95ADB}"/>
              </a:ext>
            </a:extLst>
          </p:cNvPr>
          <p:cNvCxnSpPr>
            <a:cxnSpLocks/>
          </p:cNvCxnSpPr>
          <p:nvPr/>
        </p:nvCxnSpPr>
        <p:spPr>
          <a:xfrm>
            <a:off x="8202904" y="4441935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9757D73F-C567-8DA3-DC48-955A526D2ADC}"/>
              </a:ext>
            </a:extLst>
          </p:cNvPr>
          <p:cNvCxnSpPr>
            <a:cxnSpLocks/>
          </p:cNvCxnSpPr>
          <p:nvPr/>
        </p:nvCxnSpPr>
        <p:spPr>
          <a:xfrm>
            <a:off x="8202904" y="3100024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1" name="TekstSylinder 10">
            <a:extLst>
              <a:ext uri="{FF2B5EF4-FFF2-40B4-BE49-F238E27FC236}">
                <a16:creationId xmlns:a16="http://schemas.microsoft.com/office/drawing/2014/main" id="{1038AC3C-A916-555B-6307-BDD20FDBE5D9}"/>
              </a:ext>
            </a:extLst>
          </p:cNvPr>
          <p:cNvSpPr txBox="1"/>
          <p:nvPr/>
        </p:nvSpPr>
        <p:spPr>
          <a:xfrm>
            <a:off x="114300" y="2233246"/>
            <a:ext cx="1749669" cy="3077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>
                <a:solidFill>
                  <a:srgbClr val="00B050"/>
                </a:solidFill>
              </a:rPr>
              <a:t>Green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 = </a:t>
            </a:r>
            <a:r>
              <a:rPr lang="nb-NO" err="1"/>
              <a:t>scored</a:t>
            </a:r>
            <a:br>
              <a:rPr lang="nb-NO"/>
            </a:br>
            <a:endParaRPr lang="nb-NO"/>
          </a:p>
          <a:p>
            <a:r>
              <a:rPr lang="nb-NO" sz="1400" err="1"/>
              <a:t>Confirm</a:t>
            </a:r>
            <a:r>
              <a:rPr lang="nb-NO" sz="1400"/>
              <a:t> </a:t>
            </a:r>
            <a:r>
              <a:rPr lang="nb-NO" sz="1400" err="1"/>
              <a:t>each</a:t>
            </a:r>
            <a:r>
              <a:rPr lang="nb-NO" sz="1400"/>
              <a:t> </a:t>
            </a:r>
            <a:r>
              <a:rPr lang="nb-NO" sz="1400" err="1"/>
              <a:t>comet</a:t>
            </a:r>
            <a:r>
              <a:rPr lang="nb-NO" sz="1400"/>
              <a:t> as PS at scoring by </a:t>
            </a:r>
            <a:r>
              <a:rPr lang="nb-NO" sz="1400" err="1"/>
              <a:t>evaluating</a:t>
            </a:r>
            <a:r>
              <a:rPr lang="nb-NO" sz="1400"/>
              <a:t> </a:t>
            </a:r>
            <a:r>
              <a:rPr lang="nb-NO" sz="1400" err="1"/>
              <a:t>the</a:t>
            </a:r>
            <a:r>
              <a:rPr lang="nb-NO" sz="1400"/>
              <a:t> Total </a:t>
            </a:r>
            <a:r>
              <a:rPr lang="nb-NO" sz="1400" err="1"/>
              <a:t>Intensity</a:t>
            </a:r>
            <a:r>
              <a:rPr lang="nb-NO" sz="1400"/>
              <a:t> </a:t>
            </a:r>
            <a:r>
              <a:rPr lang="nb-NO" sz="1400" err="1"/>
              <a:t>of</a:t>
            </a:r>
            <a:r>
              <a:rPr lang="nb-NO" sz="1400"/>
              <a:t> </a:t>
            </a:r>
            <a:r>
              <a:rPr lang="nb-NO" sz="1400" err="1"/>
              <a:t>each</a:t>
            </a:r>
            <a:r>
              <a:rPr lang="nb-NO" sz="1400"/>
              <a:t> </a:t>
            </a:r>
            <a:r>
              <a:rPr lang="nb-NO" sz="1400" err="1"/>
              <a:t>comet</a:t>
            </a:r>
            <a:r>
              <a:rPr lang="nb-NO" sz="1400"/>
              <a:t> </a:t>
            </a:r>
            <a:r>
              <a:rPr lang="nb-NO" sz="1400" err="1"/>
              <a:t>based</a:t>
            </a:r>
            <a:r>
              <a:rPr lang="nb-NO" sz="1400"/>
              <a:t> </a:t>
            </a:r>
            <a:r>
              <a:rPr lang="nb-NO" sz="1400" err="1"/>
              <a:t>on</a:t>
            </a:r>
            <a:r>
              <a:rPr lang="nb-NO" sz="1400"/>
              <a:t> </a:t>
            </a:r>
            <a:r>
              <a:rPr lang="nb-NO" sz="1400" err="1"/>
              <a:t>levels</a:t>
            </a:r>
            <a:r>
              <a:rPr lang="nb-NO" sz="1400"/>
              <a:t> </a:t>
            </a:r>
            <a:r>
              <a:rPr lang="nb-NO" sz="1400" err="1"/>
              <a:t>observed</a:t>
            </a:r>
            <a:r>
              <a:rPr lang="nb-NO" sz="1400"/>
              <a:t> during scoring </a:t>
            </a:r>
            <a:r>
              <a:rPr lang="nb-NO" sz="1400" err="1"/>
              <a:t>of</a:t>
            </a:r>
            <a:r>
              <a:rPr lang="nb-NO" sz="1400"/>
              <a:t> «all </a:t>
            </a:r>
            <a:r>
              <a:rPr lang="nb-NO" sz="1400" err="1"/>
              <a:t>round</a:t>
            </a:r>
            <a:r>
              <a:rPr lang="nb-NO" sz="1400"/>
              <a:t> </a:t>
            </a:r>
            <a:r>
              <a:rPr lang="nb-NO" sz="1400" err="1"/>
              <a:t>nucleoids</a:t>
            </a:r>
            <a:r>
              <a:rPr lang="nb-NO" sz="1400"/>
              <a:t>»</a:t>
            </a:r>
          </a:p>
        </p:txBody>
      </p:sp>
    </p:spTree>
    <p:extLst>
      <p:ext uri="{BB962C8B-B14F-4D97-AF65-F5344CB8AC3E}">
        <p14:creationId xmlns:p14="http://schemas.microsoft.com/office/powerpoint/2010/main" val="112814141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2C84C151-CBD3-5CF4-021B-B2C0E7F40DAA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/>
              <a:t>PS (</a:t>
            </a:r>
            <a:r>
              <a:rPr lang="nb-NO" sz="4000" err="1"/>
              <a:t>treated</a:t>
            </a:r>
            <a:r>
              <a:rPr lang="nb-NO" sz="4000"/>
              <a:t>),</a:t>
            </a:r>
            <a:r>
              <a:rPr lang="en-US" sz="4000"/>
              <a:t> low damage (~20 % TI)</a:t>
            </a:r>
            <a:endParaRPr lang="en-GB" sz="4000"/>
          </a:p>
        </p:txBody>
      </p:sp>
      <p:pic>
        <p:nvPicPr>
          <p:cNvPr id="2" name="Picture 1" descr="A group of white lights in a black background&#10;&#10;Description automatically generated">
            <a:extLst>
              <a:ext uri="{FF2B5EF4-FFF2-40B4-BE49-F238E27FC236}">
                <a16:creationId xmlns:a16="http://schemas.microsoft.com/office/drawing/2014/main" id="{20EE38DA-2031-D6CD-C9F3-458CC6E2A2F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5457" y="932350"/>
            <a:ext cx="7727700" cy="5760000"/>
          </a:xfrm>
          <a:prstGeom prst="rect">
            <a:avLst/>
          </a:prstGeom>
        </p:spPr>
      </p:pic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A90EBD89-90AA-6A14-8A31-252C0F94E34E}"/>
              </a:ext>
            </a:extLst>
          </p:cNvPr>
          <p:cNvCxnSpPr>
            <a:cxnSpLocks/>
          </p:cNvCxnSpPr>
          <p:nvPr/>
        </p:nvCxnSpPr>
        <p:spPr>
          <a:xfrm>
            <a:off x="6682862" y="1520605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ED7C363C-FFFE-52CC-7DC6-646C12AB0F0F}"/>
              </a:ext>
            </a:extLst>
          </p:cNvPr>
          <p:cNvCxnSpPr>
            <a:cxnSpLocks/>
          </p:cNvCxnSpPr>
          <p:nvPr/>
        </p:nvCxnSpPr>
        <p:spPr>
          <a:xfrm>
            <a:off x="3571527" y="4145053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EA0A41C6-1FA6-FA97-CD6E-D2325FEFD8EE}"/>
              </a:ext>
            </a:extLst>
          </p:cNvPr>
          <p:cNvCxnSpPr>
            <a:cxnSpLocks/>
          </p:cNvCxnSpPr>
          <p:nvPr/>
        </p:nvCxnSpPr>
        <p:spPr>
          <a:xfrm>
            <a:off x="5860922" y="5023826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8" name="TekstSylinder 7">
            <a:extLst>
              <a:ext uri="{FF2B5EF4-FFF2-40B4-BE49-F238E27FC236}">
                <a16:creationId xmlns:a16="http://schemas.microsoft.com/office/drawing/2014/main" id="{E488F139-FBEA-D12B-DADF-E448815DF387}"/>
              </a:ext>
            </a:extLst>
          </p:cNvPr>
          <p:cNvSpPr txBox="1"/>
          <p:nvPr/>
        </p:nvSpPr>
        <p:spPr>
          <a:xfrm>
            <a:off x="114300" y="2233246"/>
            <a:ext cx="1749669" cy="3077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>
                <a:solidFill>
                  <a:srgbClr val="00B050"/>
                </a:solidFill>
              </a:rPr>
              <a:t>Green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 = </a:t>
            </a:r>
            <a:r>
              <a:rPr lang="nb-NO" err="1"/>
              <a:t>scored</a:t>
            </a:r>
            <a:br>
              <a:rPr lang="nb-NO"/>
            </a:br>
            <a:endParaRPr lang="nb-NO"/>
          </a:p>
          <a:p>
            <a:r>
              <a:rPr lang="nb-NO" sz="1400" err="1"/>
              <a:t>Confirm</a:t>
            </a:r>
            <a:r>
              <a:rPr lang="nb-NO" sz="1400"/>
              <a:t> </a:t>
            </a:r>
            <a:r>
              <a:rPr lang="nb-NO" sz="1400" err="1"/>
              <a:t>each</a:t>
            </a:r>
            <a:r>
              <a:rPr lang="nb-NO" sz="1400"/>
              <a:t> </a:t>
            </a:r>
            <a:r>
              <a:rPr lang="nb-NO" sz="1400" err="1"/>
              <a:t>comet</a:t>
            </a:r>
            <a:r>
              <a:rPr lang="nb-NO" sz="1400"/>
              <a:t> as PS at scoring by </a:t>
            </a:r>
            <a:r>
              <a:rPr lang="nb-NO" sz="1400" err="1"/>
              <a:t>evaluating</a:t>
            </a:r>
            <a:r>
              <a:rPr lang="nb-NO" sz="1400"/>
              <a:t> </a:t>
            </a:r>
            <a:r>
              <a:rPr lang="nb-NO" sz="1400" err="1"/>
              <a:t>the</a:t>
            </a:r>
            <a:r>
              <a:rPr lang="nb-NO" sz="1400"/>
              <a:t> Total </a:t>
            </a:r>
            <a:r>
              <a:rPr lang="nb-NO" sz="1400" err="1"/>
              <a:t>Intensity</a:t>
            </a:r>
            <a:r>
              <a:rPr lang="nb-NO" sz="1400"/>
              <a:t> </a:t>
            </a:r>
            <a:r>
              <a:rPr lang="nb-NO" sz="1400" err="1"/>
              <a:t>of</a:t>
            </a:r>
            <a:r>
              <a:rPr lang="nb-NO" sz="1400"/>
              <a:t> </a:t>
            </a:r>
            <a:r>
              <a:rPr lang="nb-NO" sz="1400" err="1"/>
              <a:t>each</a:t>
            </a:r>
            <a:r>
              <a:rPr lang="nb-NO" sz="1400"/>
              <a:t> </a:t>
            </a:r>
            <a:r>
              <a:rPr lang="nb-NO" sz="1400" err="1"/>
              <a:t>comet</a:t>
            </a:r>
            <a:r>
              <a:rPr lang="nb-NO" sz="1400"/>
              <a:t> </a:t>
            </a:r>
            <a:r>
              <a:rPr lang="nb-NO" sz="1400" err="1"/>
              <a:t>based</a:t>
            </a:r>
            <a:r>
              <a:rPr lang="nb-NO" sz="1400"/>
              <a:t> </a:t>
            </a:r>
            <a:r>
              <a:rPr lang="nb-NO" sz="1400" err="1"/>
              <a:t>on</a:t>
            </a:r>
            <a:r>
              <a:rPr lang="nb-NO" sz="1400"/>
              <a:t> </a:t>
            </a:r>
            <a:r>
              <a:rPr lang="nb-NO" sz="1400" err="1"/>
              <a:t>levels</a:t>
            </a:r>
            <a:r>
              <a:rPr lang="nb-NO" sz="1400"/>
              <a:t> </a:t>
            </a:r>
            <a:r>
              <a:rPr lang="nb-NO" sz="1400" err="1"/>
              <a:t>observed</a:t>
            </a:r>
            <a:r>
              <a:rPr lang="nb-NO" sz="1400"/>
              <a:t> during scoring </a:t>
            </a:r>
            <a:r>
              <a:rPr lang="nb-NO" sz="1400" err="1"/>
              <a:t>of</a:t>
            </a:r>
            <a:r>
              <a:rPr lang="nb-NO" sz="1400"/>
              <a:t> «all </a:t>
            </a:r>
            <a:r>
              <a:rPr lang="nb-NO" sz="1400" err="1"/>
              <a:t>round</a:t>
            </a:r>
            <a:r>
              <a:rPr lang="nb-NO" sz="1400"/>
              <a:t> </a:t>
            </a:r>
            <a:r>
              <a:rPr lang="nb-NO" sz="1400" err="1"/>
              <a:t>nucleoids</a:t>
            </a:r>
            <a:r>
              <a:rPr lang="nb-NO" sz="1400"/>
              <a:t>»</a:t>
            </a:r>
          </a:p>
        </p:txBody>
      </p:sp>
    </p:spTree>
    <p:extLst>
      <p:ext uri="{BB962C8B-B14F-4D97-AF65-F5344CB8AC3E}">
        <p14:creationId xmlns:p14="http://schemas.microsoft.com/office/powerpoint/2010/main" val="85226808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2C84C151-CBD3-5CF4-021B-B2C0E7F40DAA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/>
              <a:t>PS (</a:t>
            </a:r>
            <a:r>
              <a:rPr lang="nb-NO" sz="4000" err="1"/>
              <a:t>treated</a:t>
            </a:r>
            <a:r>
              <a:rPr lang="nb-NO" sz="4000"/>
              <a:t>)</a:t>
            </a:r>
            <a:r>
              <a:rPr lang="en-US" sz="4000"/>
              <a:t>, high damage (~60 % TI)</a:t>
            </a:r>
            <a:endParaRPr lang="en-GB" sz="4000"/>
          </a:p>
        </p:txBody>
      </p:sp>
      <p:pic>
        <p:nvPicPr>
          <p:cNvPr id="4" name="Picture 3" descr="A group of white ovals in a black background&#10;&#10;Description automatically generated">
            <a:extLst>
              <a:ext uri="{FF2B5EF4-FFF2-40B4-BE49-F238E27FC236}">
                <a16:creationId xmlns:a16="http://schemas.microsoft.com/office/drawing/2014/main" id="{77A90F17-2A71-90B5-D5C3-78BC88136E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7978" y="881984"/>
            <a:ext cx="7727700" cy="5760000"/>
          </a:xfrm>
          <a:prstGeom prst="rect">
            <a:avLst/>
          </a:prstGeom>
        </p:spPr>
      </p:pic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973161ED-FE6E-AFD6-E610-82A067B95CC8}"/>
              </a:ext>
            </a:extLst>
          </p:cNvPr>
          <p:cNvCxnSpPr>
            <a:cxnSpLocks/>
          </p:cNvCxnSpPr>
          <p:nvPr/>
        </p:nvCxnSpPr>
        <p:spPr>
          <a:xfrm>
            <a:off x="5046237" y="2111712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0146D846-97EB-27FC-F328-7D2488CBBD9A}"/>
              </a:ext>
            </a:extLst>
          </p:cNvPr>
          <p:cNvCxnSpPr>
            <a:cxnSpLocks/>
          </p:cNvCxnSpPr>
          <p:nvPr/>
        </p:nvCxnSpPr>
        <p:spPr>
          <a:xfrm>
            <a:off x="6290977" y="4228179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7" name="TekstSylinder 6">
            <a:extLst>
              <a:ext uri="{FF2B5EF4-FFF2-40B4-BE49-F238E27FC236}">
                <a16:creationId xmlns:a16="http://schemas.microsoft.com/office/drawing/2014/main" id="{869F259E-E239-7774-78C3-90985077DBAD}"/>
              </a:ext>
            </a:extLst>
          </p:cNvPr>
          <p:cNvSpPr txBox="1"/>
          <p:nvPr/>
        </p:nvSpPr>
        <p:spPr>
          <a:xfrm>
            <a:off x="114300" y="2233246"/>
            <a:ext cx="1749669" cy="3077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>
                <a:solidFill>
                  <a:srgbClr val="00B050"/>
                </a:solidFill>
              </a:rPr>
              <a:t>Green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 = </a:t>
            </a:r>
            <a:r>
              <a:rPr lang="nb-NO" err="1"/>
              <a:t>scored</a:t>
            </a:r>
            <a:br>
              <a:rPr lang="nb-NO"/>
            </a:br>
            <a:endParaRPr lang="nb-NO"/>
          </a:p>
          <a:p>
            <a:r>
              <a:rPr lang="nb-NO" sz="1400" err="1"/>
              <a:t>Confirm</a:t>
            </a:r>
            <a:r>
              <a:rPr lang="nb-NO" sz="1400"/>
              <a:t> </a:t>
            </a:r>
            <a:r>
              <a:rPr lang="nb-NO" sz="1400" err="1"/>
              <a:t>each</a:t>
            </a:r>
            <a:r>
              <a:rPr lang="nb-NO" sz="1400"/>
              <a:t> </a:t>
            </a:r>
            <a:r>
              <a:rPr lang="nb-NO" sz="1400" err="1"/>
              <a:t>comet</a:t>
            </a:r>
            <a:r>
              <a:rPr lang="nb-NO" sz="1400"/>
              <a:t> as PS at scoring by </a:t>
            </a:r>
            <a:r>
              <a:rPr lang="nb-NO" sz="1400" err="1"/>
              <a:t>evaluating</a:t>
            </a:r>
            <a:r>
              <a:rPr lang="nb-NO" sz="1400"/>
              <a:t> </a:t>
            </a:r>
            <a:r>
              <a:rPr lang="nb-NO" sz="1400" err="1"/>
              <a:t>the</a:t>
            </a:r>
            <a:r>
              <a:rPr lang="nb-NO" sz="1400"/>
              <a:t> Total </a:t>
            </a:r>
            <a:r>
              <a:rPr lang="nb-NO" sz="1400" err="1"/>
              <a:t>Intensity</a:t>
            </a:r>
            <a:r>
              <a:rPr lang="nb-NO" sz="1400"/>
              <a:t> </a:t>
            </a:r>
            <a:r>
              <a:rPr lang="nb-NO" sz="1400" err="1"/>
              <a:t>of</a:t>
            </a:r>
            <a:r>
              <a:rPr lang="nb-NO" sz="1400"/>
              <a:t> </a:t>
            </a:r>
            <a:r>
              <a:rPr lang="nb-NO" sz="1400" err="1"/>
              <a:t>each</a:t>
            </a:r>
            <a:r>
              <a:rPr lang="nb-NO" sz="1400"/>
              <a:t> </a:t>
            </a:r>
            <a:r>
              <a:rPr lang="nb-NO" sz="1400" err="1"/>
              <a:t>comet</a:t>
            </a:r>
            <a:r>
              <a:rPr lang="nb-NO" sz="1400"/>
              <a:t> </a:t>
            </a:r>
            <a:r>
              <a:rPr lang="nb-NO" sz="1400" err="1"/>
              <a:t>based</a:t>
            </a:r>
            <a:r>
              <a:rPr lang="nb-NO" sz="1400"/>
              <a:t> </a:t>
            </a:r>
            <a:r>
              <a:rPr lang="nb-NO" sz="1400" err="1"/>
              <a:t>on</a:t>
            </a:r>
            <a:r>
              <a:rPr lang="nb-NO" sz="1400"/>
              <a:t> </a:t>
            </a:r>
            <a:r>
              <a:rPr lang="nb-NO" sz="1400" err="1"/>
              <a:t>levels</a:t>
            </a:r>
            <a:r>
              <a:rPr lang="nb-NO" sz="1400"/>
              <a:t> </a:t>
            </a:r>
            <a:r>
              <a:rPr lang="nb-NO" sz="1400" err="1"/>
              <a:t>observed</a:t>
            </a:r>
            <a:r>
              <a:rPr lang="nb-NO" sz="1400"/>
              <a:t> during scoring </a:t>
            </a:r>
            <a:r>
              <a:rPr lang="nb-NO" sz="1400" err="1"/>
              <a:t>of</a:t>
            </a:r>
            <a:r>
              <a:rPr lang="nb-NO" sz="1400"/>
              <a:t> «all </a:t>
            </a:r>
            <a:r>
              <a:rPr lang="nb-NO" sz="1400" err="1"/>
              <a:t>round</a:t>
            </a:r>
            <a:r>
              <a:rPr lang="nb-NO" sz="1400"/>
              <a:t> </a:t>
            </a:r>
            <a:r>
              <a:rPr lang="nb-NO" sz="1400" err="1"/>
              <a:t>nucleoids</a:t>
            </a:r>
            <a:r>
              <a:rPr lang="nb-NO" sz="1400"/>
              <a:t>»</a:t>
            </a:r>
          </a:p>
        </p:txBody>
      </p:sp>
    </p:spTree>
    <p:extLst>
      <p:ext uri="{BB962C8B-B14F-4D97-AF65-F5344CB8AC3E}">
        <p14:creationId xmlns:p14="http://schemas.microsoft.com/office/powerpoint/2010/main" val="376693229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2C84C151-CBD3-5CF4-021B-B2C0E7F40DAA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/>
              <a:t>PS (</a:t>
            </a:r>
            <a:r>
              <a:rPr lang="nb-NO" sz="4000" err="1"/>
              <a:t>treated</a:t>
            </a:r>
            <a:r>
              <a:rPr lang="nb-NO" sz="4000"/>
              <a:t>)</a:t>
            </a:r>
            <a:r>
              <a:rPr lang="en-US" sz="4000"/>
              <a:t>, high damage (~60 % TI)</a:t>
            </a:r>
            <a:endParaRPr lang="en-GB" sz="4000"/>
          </a:p>
        </p:txBody>
      </p:sp>
      <p:pic>
        <p:nvPicPr>
          <p:cNvPr id="3" name="Picture 2" descr="A group of white ovals in the dark&#10;&#10;Description automatically generated">
            <a:extLst>
              <a:ext uri="{FF2B5EF4-FFF2-40B4-BE49-F238E27FC236}">
                <a16:creationId xmlns:a16="http://schemas.microsoft.com/office/drawing/2014/main" id="{A4F48F27-B059-9BA4-AF2C-6C15965A3B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4233" y="909204"/>
            <a:ext cx="7727703" cy="5760000"/>
          </a:xfrm>
          <a:prstGeom prst="rect">
            <a:avLst/>
          </a:prstGeom>
        </p:spPr>
      </p:pic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11CEC525-EB0F-CB4A-0032-C87691CEB377}"/>
              </a:ext>
            </a:extLst>
          </p:cNvPr>
          <p:cNvCxnSpPr>
            <a:cxnSpLocks/>
          </p:cNvCxnSpPr>
          <p:nvPr/>
        </p:nvCxnSpPr>
        <p:spPr>
          <a:xfrm>
            <a:off x="6135769" y="2946823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F7781B47-DBFD-A9D7-BE45-938B27F2DDA5}"/>
              </a:ext>
            </a:extLst>
          </p:cNvPr>
          <p:cNvCxnSpPr>
            <a:cxnSpLocks/>
          </p:cNvCxnSpPr>
          <p:nvPr/>
        </p:nvCxnSpPr>
        <p:spPr>
          <a:xfrm>
            <a:off x="7397989" y="2125064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DF2D8246-54EC-2741-73E8-61ACED8CC4B5}"/>
              </a:ext>
            </a:extLst>
          </p:cNvPr>
          <p:cNvCxnSpPr>
            <a:cxnSpLocks/>
          </p:cNvCxnSpPr>
          <p:nvPr/>
        </p:nvCxnSpPr>
        <p:spPr>
          <a:xfrm>
            <a:off x="7596491" y="3678089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8" name="TekstSylinder 7">
            <a:extLst>
              <a:ext uri="{FF2B5EF4-FFF2-40B4-BE49-F238E27FC236}">
                <a16:creationId xmlns:a16="http://schemas.microsoft.com/office/drawing/2014/main" id="{90C681D1-3B50-CBA5-6CAF-FD2182AC4D9D}"/>
              </a:ext>
            </a:extLst>
          </p:cNvPr>
          <p:cNvSpPr txBox="1"/>
          <p:nvPr/>
        </p:nvSpPr>
        <p:spPr>
          <a:xfrm>
            <a:off x="114300" y="2233246"/>
            <a:ext cx="1749669" cy="3077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>
                <a:solidFill>
                  <a:srgbClr val="00B050"/>
                </a:solidFill>
              </a:rPr>
              <a:t>Green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 = </a:t>
            </a:r>
            <a:r>
              <a:rPr lang="nb-NO" err="1"/>
              <a:t>scored</a:t>
            </a:r>
            <a:br>
              <a:rPr lang="nb-NO"/>
            </a:br>
            <a:endParaRPr lang="nb-NO"/>
          </a:p>
          <a:p>
            <a:r>
              <a:rPr lang="nb-NO" sz="1400" err="1"/>
              <a:t>Confirm</a:t>
            </a:r>
            <a:r>
              <a:rPr lang="nb-NO" sz="1400"/>
              <a:t> </a:t>
            </a:r>
            <a:r>
              <a:rPr lang="nb-NO" sz="1400" err="1"/>
              <a:t>each</a:t>
            </a:r>
            <a:r>
              <a:rPr lang="nb-NO" sz="1400"/>
              <a:t> </a:t>
            </a:r>
            <a:r>
              <a:rPr lang="nb-NO" sz="1400" err="1"/>
              <a:t>comet</a:t>
            </a:r>
            <a:r>
              <a:rPr lang="nb-NO" sz="1400"/>
              <a:t> as PS at scoring by </a:t>
            </a:r>
            <a:r>
              <a:rPr lang="nb-NO" sz="1400" err="1"/>
              <a:t>evaluating</a:t>
            </a:r>
            <a:r>
              <a:rPr lang="nb-NO" sz="1400"/>
              <a:t> </a:t>
            </a:r>
            <a:r>
              <a:rPr lang="nb-NO" sz="1400" err="1"/>
              <a:t>the</a:t>
            </a:r>
            <a:r>
              <a:rPr lang="nb-NO" sz="1400"/>
              <a:t> Total </a:t>
            </a:r>
            <a:r>
              <a:rPr lang="nb-NO" sz="1400" err="1"/>
              <a:t>Intensity</a:t>
            </a:r>
            <a:r>
              <a:rPr lang="nb-NO" sz="1400"/>
              <a:t> </a:t>
            </a:r>
            <a:r>
              <a:rPr lang="nb-NO" sz="1400" err="1"/>
              <a:t>of</a:t>
            </a:r>
            <a:r>
              <a:rPr lang="nb-NO" sz="1400"/>
              <a:t> </a:t>
            </a:r>
            <a:r>
              <a:rPr lang="nb-NO" sz="1400" err="1"/>
              <a:t>each</a:t>
            </a:r>
            <a:r>
              <a:rPr lang="nb-NO" sz="1400"/>
              <a:t> </a:t>
            </a:r>
            <a:r>
              <a:rPr lang="nb-NO" sz="1400" err="1"/>
              <a:t>comet</a:t>
            </a:r>
            <a:r>
              <a:rPr lang="nb-NO" sz="1400"/>
              <a:t> </a:t>
            </a:r>
            <a:r>
              <a:rPr lang="nb-NO" sz="1400" err="1"/>
              <a:t>based</a:t>
            </a:r>
            <a:r>
              <a:rPr lang="nb-NO" sz="1400"/>
              <a:t> </a:t>
            </a:r>
            <a:r>
              <a:rPr lang="nb-NO" sz="1400" err="1"/>
              <a:t>on</a:t>
            </a:r>
            <a:r>
              <a:rPr lang="nb-NO" sz="1400"/>
              <a:t> </a:t>
            </a:r>
            <a:r>
              <a:rPr lang="nb-NO" sz="1400" err="1"/>
              <a:t>levels</a:t>
            </a:r>
            <a:r>
              <a:rPr lang="nb-NO" sz="1400"/>
              <a:t> </a:t>
            </a:r>
            <a:r>
              <a:rPr lang="nb-NO" sz="1400" err="1"/>
              <a:t>observed</a:t>
            </a:r>
            <a:r>
              <a:rPr lang="nb-NO" sz="1400"/>
              <a:t> during scoring </a:t>
            </a:r>
            <a:r>
              <a:rPr lang="nb-NO" sz="1400" err="1"/>
              <a:t>of</a:t>
            </a:r>
            <a:r>
              <a:rPr lang="nb-NO" sz="1400"/>
              <a:t> «all </a:t>
            </a:r>
            <a:r>
              <a:rPr lang="nb-NO" sz="1400" err="1"/>
              <a:t>round</a:t>
            </a:r>
            <a:r>
              <a:rPr lang="nb-NO" sz="1400"/>
              <a:t> </a:t>
            </a:r>
            <a:r>
              <a:rPr lang="nb-NO" sz="1400" err="1"/>
              <a:t>nucleoids</a:t>
            </a:r>
            <a:r>
              <a:rPr lang="nb-NO" sz="1400"/>
              <a:t>»</a:t>
            </a:r>
          </a:p>
        </p:txBody>
      </p:sp>
    </p:spTree>
    <p:extLst>
      <p:ext uri="{BB962C8B-B14F-4D97-AF65-F5344CB8AC3E}">
        <p14:creationId xmlns:p14="http://schemas.microsoft.com/office/powerpoint/2010/main" val="3240163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8">
            <a:extLst>
              <a:ext uri="{FF2B5EF4-FFF2-40B4-BE49-F238E27FC236}">
                <a16:creationId xmlns:a16="http://schemas.microsoft.com/office/drawing/2014/main" id="{1E473976-37DD-73A6-C305-A08443EFA22A}"/>
              </a:ext>
            </a:extLst>
          </p:cNvPr>
          <p:cNvSpPr txBox="1"/>
          <p:nvPr/>
        </p:nvSpPr>
        <p:spPr>
          <a:xfrm>
            <a:off x="1881094" y="934889"/>
            <a:ext cx="3060970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Untreated</a:t>
            </a:r>
            <a:endParaRPr lang="en-US" dirty="0"/>
          </a:p>
        </p:txBody>
      </p:sp>
      <p:sp>
        <p:nvSpPr>
          <p:cNvPr id="6" name="TextBox 3">
            <a:extLst>
              <a:ext uri="{FF2B5EF4-FFF2-40B4-BE49-F238E27FC236}">
                <a16:creationId xmlns:a16="http://schemas.microsoft.com/office/drawing/2014/main" id="{7ECC5CA3-38FE-85B3-E77A-622D5E2D2088}"/>
              </a:ext>
            </a:extLst>
          </p:cNvPr>
          <p:cNvSpPr txBox="1"/>
          <p:nvPr/>
        </p:nvSpPr>
        <p:spPr>
          <a:xfrm>
            <a:off x="4435557" y="938956"/>
            <a:ext cx="351213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Treated, low damage (~20 % TI)</a:t>
            </a:r>
            <a:endParaRPr lang="en-US" dirty="0"/>
          </a:p>
        </p:txBody>
      </p:sp>
      <p:pic>
        <p:nvPicPr>
          <p:cNvPr id="8" name="Picture 7" descr="A group of white circles in the sky&#10;&#10;Description automatically generated">
            <a:extLst>
              <a:ext uri="{FF2B5EF4-FFF2-40B4-BE49-F238E27FC236}">
                <a16:creationId xmlns:a16="http://schemas.microsoft.com/office/drawing/2014/main" id="{F7CAA5AC-6E3D-603B-B040-64AF40C720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003" y="1273628"/>
            <a:ext cx="3370312" cy="2512131"/>
          </a:xfrm>
          <a:prstGeom prst="rect">
            <a:avLst/>
          </a:prstGeom>
        </p:spPr>
      </p:pic>
      <p:pic>
        <p:nvPicPr>
          <p:cNvPr id="10" name="Picture 9" descr="A group of white circles in a black background&#10;&#10;Description automatically generated">
            <a:extLst>
              <a:ext uri="{FF2B5EF4-FFF2-40B4-BE49-F238E27FC236}">
                <a16:creationId xmlns:a16="http://schemas.microsoft.com/office/drawing/2014/main" id="{51DE74BC-9860-65F8-A614-98FC3AD5538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003" y="3934715"/>
            <a:ext cx="3370312" cy="2512131"/>
          </a:xfrm>
          <a:prstGeom prst="rect">
            <a:avLst/>
          </a:prstGeom>
        </p:spPr>
      </p:pic>
      <p:pic>
        <p:nvPicPr>
          <p:cNvPr id="20" name="Picture 19" descr="A group of white dots on a black background&#10;&#10;Description automatically generated">
            <a:extLst>
              <a:ext uri="{FF2B5EF4-FFF2-40B4-BE49-F238E27FC236}">
                <a16:creationId xmlns:a16="http://schemas.microsoft.com/office/drawing/2014/main" id="{6A0B188C-6D8B-2103-2FE7-0940470DED7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0284" y="1273628"/>
            <a:ext cx="3370312" cy="2512131"/>
          </a:xfrm>
          <a:prstGeom prst="rect">
            <a:avLst/>
          </a:prstGeom>
        </p:spPr>
      </p:pic>
      <p:pic>
        <p:nvPicPr>
          <p:cNvPr id="30" name="Picture 29" descr="A group of ovals in a black background&#10;&#10;Description automatically generated">
            <a:extLst>
              <a:ext uri="{FF2B5EF4-FFF2-40B4-BE49-F238E27FC236}">
                <a16:creationId xmlns:a16="http://schemas.microsoft.com/office/drawing/2014/main" id="{BA106BDF-6FFD-6422-4192-582C03B7A1C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0284" y="3940223"/>
            <a:ext cx="3370312" cy="2512131"/>
          </a:xfrm>
          <a:prstGeom prst="rect">
            <a:avLst/>
          </a:prstGeom>
        </p:spPr>
      </p:pic>
      <p:pic>
        <p:nvPicPr>
          <p:cNvPr id="32" name="Picture 31" descr="A group of bright lights in the sky&#10;&#10;Description automatically generated">
            <a:extLst>
              <a:ext uri="{FF2B5EF4-FFF2-40B4-BE49-F238E27FC236}">
                <a16:creationId xmlns:a16="http://schemas.microsoft.com/office/drawing/2014/main" id="{A9F0FB47-4825-83D1-51C0-BEBF22F1D9F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5557" y="1272907"/>
            <a:ext cx="3370314" cy="2512132"/>
          </a:xfrm>
          <a:prstGeom prst="rect">
            <a:avLst/>
          </a:prstGeom>
        </p:spPr>
      </p:pic>
      <p:pic>
        <p:nvPicPr>
          <p:cNvPr id="36" name="Picture 35" descr="A group of white lights in the sky&#10;&#10;Description automatically generated">
            <a:extLst>
              <a:ext uri="{FF2B5EF4-FFF2-40B4-BE49-F238E27FC236}">
                <a16:creationId xmlns:a16="http://schemas.microsoft.com/office/drawing/2014/main" id="{CBBD497F-DA4D-539D-AED6-4FE3A1DC2CC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5558" y="3934715"/>
            <a:ext cx="3370312" cy="2512131"/>
          </a:xfrm>
          <a:prstGeom prst="rect">
            <a:avLst/>
          </a:prstGeom>
        </p:spPr>
      </p:pic>
      <p:sp>
        <p:nvSpPr>
          <p:cNvPr id="38" name="Title 1">
            <a:extLst>
              <a:ext uri="{FF2B5EF4-FFF2-40B4-BE49-F238E27FC236}">
                <a16:creationId xmlns:a16="http://schemas.microsoft.com/office/drawing/2014/main" id="{77099841-A197-450E-9468-1DB527C5D8F9}"/>
              </a:ext>
            </a:extLst>
          </p:cNvPr>
          <p:cNvSpPr>
            <a:spLocks noGrp="1"/>
          </p:cNvSpPr>
          <p:nvPr/>
        </p:nvSpPr>
        <p:spPr>
          <a:xfrm>
            <a:off x="694756" y="-103726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/>
              <a:t>All round nucleoids (</a:t>
            </a:r>
            <a:r>
              <a:rPr lang="nb-NO" sz="4000" err="1"/>
              <a:t>untreated</a:t>
            </a:r>
            <a:r>
              <a:rPr lang="nb-NO" sz="4000"/>
              <a:t>, </a:t>
            </a:r>
            <a:r>
              <a:rPr lang="nb-NO" sz="4000" err="1"/>
              <a:t>treated</a:t>
            </a:r>
            <a:r>
              <a:rPr lang="nb-NO" sz="4000"/>
              <a:t>)  </a:t>
            </a:r>
          </a:p>
          <a:p>
            <a:r>
              <a:rPr lang="nb-NO" sz="2800" err="1"/>
              <a:t>Overview</a:t>
            </a:r>
            <a:r>
              <a:rPr lang="nb-NO" sz="2800"/>
              <a:t>, </a:t>
            </a:r>
            <a:r>
              <a:rPr lang="nb-NO" sz="2800" err="1"/>
              <a:t>each</a:t>
            </a:r>
            <a:r>
              <a:rPr lang="nb-NO" sz="2800"/>
              <a:t> image is </a:t>
            </a:r>
            <a:r>
              <a:rPr lang="nb-NO" sz="2800" err="1"/>
              <a:t>displayed</a:t>
            </a:r>
            <a:r>
              <a:rPr lang="nb-NO" sz="2800"/>
              <a:t> in separate slides </a:t>
            </a:r>
            <a:r>
              <a:rPr lang="nb-NO" sz="2800" err="1"/>
              <a:t>below</a:t>
            </a:r>
            <a:endParaRPr lang="en-GB" sz="2800"/>
          </a:p>
        </p:txBody>
      </p:sp>
      <p:sp>
        <p:nvSpPr>
          <p:cNvPr id="2" name="TextBox 3">
            <a:extLst>
              <a:ext uri="{FF2B5EF4-FFF2-40B4-BE49-F238E27FC236}">
                <a16:creationId xmlns:a16="http://schemas.microsoft.com/office/drawing/2014/main" id="{6C21E296-5A5C-DCF8-CF3B-E65BE009DD67}"/>
              </a:ext>
            </a:extLst>
          </p:cNvPr>
          <p:cNvSpPr txBox="1"/>
          <p:nvPr/>
        </p:nvSpPr>
        <p:spPr>
          <a:xfrm>
            <a:off x="7985113" y="934498"/>
            <a:ext cx="351213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Treated, high damage (~60 % TI)</a:t>
            </a:r>
            <a:endParaRPr lang="en-US" dirty="0"/>
          </a:p>
        </p:txBody>
      </p:sp>
      <p:sp>
        <p:nvSpPr>
          <p:cNvPr id="3" name="Rektangel 2">
            <a:extLst>
              <a:ext uri="{FF2B5EF4-FFF2-40B4-BE49-F238E27FC236}">
                <a16:creationId xmlns:a16="http://schemas.microsoft.com/office/drawing/2014/main" id="{C7D504F2-A136-02D5-A423-51A34E6D4BC9}"/>
              </a:ext>
            </a:extLst>
          </p:cNvPr>
          <p:cNvSpPr/>
          <p:nvPr/>
        </p:nvSpPr>
        <p:spPr>
          <a:xfrm>
            <a:off x="808892" y="934498"/>
            <a:ext cx="3534069" cy="567731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7" name="Rektangel 6">
            <a:extLst>
              <a:ext uri="{FF2B5EF4-FFF2-40B4-BE49-F238E27FC236}">
                <a16:creationId xmlns:a16="http://schemas.microsoft.com/office/drawing/2014/main" id="{EC0C9142-DA3B-1671-02F1-F13892DEEF13}"/>
              </a:ext>
            </a:extLst>
          </p:cNvPr>
          <p:cNvSpPr/>
          <p:nvPr/>
        </p:nvSpPr>
        <p:spPr>
          <a:xfrm>
            <a:off x="4389008" y="934497"/>
            <a:ext cx="3534069" cy="567731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9" name="Rektangel 8">
            <a:extLst>
              <a:ext uri="{FF2B5EF4-FFF2-40B4-BE49-F238E27FC236}">
                <a16:creationId xmlns:a16="http://schemas.microsoft.com/office/drawing/2014/main" id="{0C23A8EA-C4DE-6D64-E548-41542E98DCE9}"/>
              </a:ext>
            </a:extLst>
          </p:cNvPr>
          <p:cNvSpPr/>
          <p:nvPr/>
        </p:nvSpPr>
        <p:spPr>
          <a:xfrm>
            <a:off x="7976093" y="934497"/>
            <a:ext cx="3534069" cy="567731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259521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2C84C151-CBD3-5CF4-021B-B2C0E7F40DAA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/>
              <a:t>All round nucleoids (untreated)</a:t>
            </a:r>
            <a:endParaRPr lang="en-GB" sz="4000"/>
          </a:p>
        </p:txBody>
      </p:sp>
      <p:pic>
        <p:nvPicPr>
          <p:cNvPr id="6" name="Picture 5" descr="A group of white circles in the sky&#10;&#10;Description automatically generated">
            <a:extLst>
              <a:ext uri="{FF2B5EF4-FFF2-40B4-BE49-F238E27FC236}">
                <a16:creationId xmlns:a16="http://schemas.microsoft.com/office/drawing/2014/main" id="{64FECE28-EBAE-4483-5E93-903ED8AFCB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0942" y="1032843"/>
            <a:ext cx="7727700" cy="5760000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659DC89E-F6BE-7499-C181-ED6E5F4EC8CF}"/>
              </a:ext>
            </a:extLst>
          </p:cNvPr>
          <p:cNvCxnSpPr/>
          <p:nvPr/>
        </p:nvCxnSpPr>
        <p:spPr>
          <a:xfrm>
            <a:off x="4723487" y="1909822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0A500ACE-200B-DBB0-2588-5C61AD62CD41}"/>
              </a:ext>
            </a:extLst>
          </p:cNvPr>
          <p:cNvCxnSpPr/>
          <p:nvPr/>
        </p:nvCxnSpPr>
        <p:spPr>
          <a:xfrm>
            <a:off x="2363358" y="2374738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8BC5AFF7-F75D-86E9-77D9-656BE28CAF48}"/>
              </a:ext>
            </a:extLst>
          </p:cNvPr>
          <p:cNvCxnSpPr/>
          <p:nvPr/>
        </p:nvCxnSpPr>
        <p:spPr>
          <a:xfrm>
            <a:off x="5398900" y="4448536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3ED11DAE-2D5E-38A1-A039-E23AC7E9EF8B}"/>
              </a:ext>
            </a:extLst>
          </p:cNvPr>
          <p:cNvCxnSpPr/>
          <p:nvPr/>
        </p:nvCxnSpPr>
        <p:spPr>
          <a:xfrm>
            <a:off x="7206479" y="5434313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8" name="TekstSylinder 7">
            <a:extLst>
              <a:ext uri="{FF2B5EF4-FFF2-40B4-BE49-F238E27FC236}">
                <a16:creationId xmlns:a16="http://schemas.microsoft.com/office/drawing/2014/main" id="{44C6B3E2-17F2-4BBE-F8DD-781434706FCC}"/>
              </a:ext>
            </a:extLst>
          </p:cNvPr>
          <p:cNvSpPr txBox="1"/>
          <p:nvPr/>
        </p:nvSpPr>
        <p:spPr>
          <a:xfrm>
            <a:off x="114300" y="2233246"/>
            <a:ext cx="174966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>
                <a:solidFill>
                  <a:srgbClr val="00B050"/>
                </a:solidFill>
              </a:rPr>
              <a:t>Green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 = </a:t>
            </a:r>
            <a:r>
              <a:rPr lang="nb-NO" err="1"/>
              <a:t>scored</a:t>
            </a:r>
            <a:endParaRPr lang="nb-NO"/>
          </a:p>
          <a:p>
            <a:endParaRPr lang="nb-NO"/>
          </a:p>
          <a:p>
            <a:r>
              <a:rPr lang="nb-NO">
                <a:solidFill>
                  <a:srgbClr val="FF0000"/>
                </a:solidFill>
              </a:rPr>
              <a:t>Red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= not </a:t>
            </a:r>
            <a:r>
              <a:rPr lang="nb-NO" err="1"/>
              <a:t>scored</a:t>
            </a:r>
            <a:endParaRPr lang="nb-NO"/>
          </a:p>
        </p:txBody>
      </p:sp>
      <p:cxnSp>
        <p:nvCxnSpPr>
          <p:cNvPr id="10" name="Straight Arrow Connector 6">
            <a:extLst>
              <a:ext uri="{FF2B5EF4-FFF2-40B4-BE49-F238E27FC236}">
                <a16:creationId xmlns:a16="http://schemas.microsoft.com/office/drawing/2014/main" id="{08B52B65-3521-2458-F8FE-CC01C3067A97}"/>
              </a:ext>
            </a:extLst>
          </p:cNvPr>
          <p:cNvCxnSpPr>
            <a:cxnSpLocks/>
          </p:cNvCxnSpPr>
          <p:nvPr/>
        </p:nvCxnSpPr>
        <p:spPr>
          <a:xfrm>
            <a:off x="1617785" y="6661719"/>
            <a:ext cx="745573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2" name="TekstSylinder 11">
            <a:extLst>
              <a:ext uri="{FF2B5EF4-FFF2-40B4-BE49-F238E27FC236}">
                <a16:creationId xmlns:a16="http://schemas.microsoft.com/office/drawing/2014/main" id="{631AE128-B824-6A55-B485-8AF9529980B1}"/>
              </a:ext>
            </a:extLst>
          </p:cNvPr>
          <p:cNvSpPr txBox="1"/>
          <p:nvPr/>
        </p:nvSpPr>
        <p:spPr>
          <a:xfrm>
            <a:off x="114300" y="6331178"/>
            <a:ext cx="17496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/>
              <a:t>Not </a:t>
            </a:r>
            <a:r>
              <a:rPr lang="nb-NO" sz="1200" err="1"/>
              <a:t>scorable</a:t>
            </a:r>
            <a:r>
              <a:rPr lang="nb-NO" sz="1200"/>
              <a:t> </a:t>
            </a:r>
          </a:p>
          <a:p>
            <a:r>
              <a:rPr lang="nb-NO" sz="1200"/>
              <a:t>– image </a:t>
            </a:r>
            <a:r>
              <a:rPr lang="nb-NO" sz="1200" err="1"/>
              <a:t>edge</a:t>
            </a:r>
            <a:endParaRPr lang="nb-NO" sz="1200"/>
          </a:p>
        </p:txBody>
      </p:sp>
      <p:sp>
        <p:nvSpPr>
          <p:cNvPr id="13" name="TekstSylinder 12">
            <a:extLst>
              <a:ext uri="{FF2B5EF4-FFF2-40B4-BE49-F238E27FC236}">
                <a16:creationId xmlns:a16="http://schemas.microsoft.com/office/drawing/2014/main" id="{64A6C2B8-E8F2-5B9C-6903-9097F78CBBA0}"/>
              </a:ext>
            </a:extLst>
          </p:cNvPr>
          <p:cNvSpPr txBox="1"/>
          <p:nvPr/>
        </p:nvSpPr>
        <p:spPr>
          <a:xfrm>
            <a:off x="9940430" y="2490609"/>
            <a:ext cx="1749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err="1"/>
              <a:t>Spermatozoa</a:t>
            </a:r>
            <a:endParaRPr lang="nb-NO" sz="1200"/>
          </a:p>
        </p:txBody>
      </p:sp>
      <p:cxnSp>
        <p:nvCxnSpPr>
          <p:cNvPr id="14" name="Straight Arrow Connector 6">
            <a:extLst>
              <a:ext uri="{FF2B5EF4-FFF2-40B4-BE49-F238E27FC236}">
                <a16:creationId xmlns:a16="http://schemas.microsoft.com/office/drawing/2014/main" id="{B0EC6BB0-EA07-280D-1E9F-7075998894D4}"/>
              </a:ext>
            </a:extLst>
          </p:cNvPr>
          <p:cNvCxnSpPr>
            <a:cxnSpLocks/>
            <a:stCxn id="13" idx="1"/>
          </p:cNvCxnSpPr>
          <p:nvPr/>
        </p:nvCxnSpPr>
        <p:spPr>
          <a:xfrm flipH="1">
            <a:off x="8581292" y="2629109"/>
            <a:ext cx="1359138" cy="92332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6">
            <a:extLst>
              <a:ext uri="{FF2B5EF4-FFF2-40B4-BE49-F238E27FC236}">
                <a16:creationId xmlns:a16="http://schemas.microsoft.com/office/drawing/2014/main" id="{44132A9C-789F-32EB-EE04-1ADE7641DDE2}"/>
              </a:ext>
            </a:extLst>
          </p:cNvPr>
          <p:cNvCxnSpPr>
            <a:cxnSpLocks/>
          </p:cNvCxnSpPr>
          <p:nvPr/>
        </p:nvCxnSpPr>
        <p:spPr>
          <a:xfrm flipH="1">
            <a:off x="9346223" y="2810755"/>
            <a:ext cx="643516" cy="98314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1472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2C84C151-CBD3-5CF4-021B-B2C0E7F40DAA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/>
              <a:t>All round nucleoids (untreated)</a:t>
            </a:r>
            <a:endParaRPr lang="en-GB" sz="4000"/>
          </a:p>
        </p:txBody>
      </p:sp>
      <p:pic>
        <p:nvPicPr>
          <p:cNvPr id="2" name="Picture 1" descr="A group of white circles in a black background&#10;&#10;Description automatically generated">
            <a:extLst>
              <a:ext uri="{FF2B5EF4-FFF2-40B4-BE49-F238E27FC236}">
                <a16:creationId xmlns:a16="http://schemas.microsoft.com/office/drawing/2014/main" id="{FD894C57-F724-2E1A-B5D3-9532765DC5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6089" y="952028"/>
            <a:ext cx="7727701" cy="5760000"/>
          </a:xfrm>
          <a:prstGeom prst="rect">
            <a:avLst/>
          </a:prstGeom>
        </p:spPr>
      </p:pic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B6D2C0EA-6C7C-7304-2FB7-2410C32547EA}"/>
              </a:ext>
            </a:extLst>
          </p:cNvPr>
          <p:cNvCxnSpPr/>
          <p:nvPr/>
        </p:nvCxnSpPr>
        <p:spPr>
          <a:xfrm>
            <a:off x="4901189" y="4112870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25BC948F-FE15-70FC-C74A-E15351FE00C3}"/>
              </a:ext>
            </a:extLst>
          </p:cNvPr>
          <p:cNvCxnSpPr/>
          <p:nvPr/>
        </p:nvCxnSpPr>
        <p:spPr>
          <a:xfrm>
            <a:off x="3317386" y="5445887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2EE6CFD3-08CB-D262-7ED5-54416BB57B69}"/>
              </a:ext>
            </a:extLst>
          </p:cNvPr>
          <p:cNvCxnSpPr/>
          <p:nvPr/>
        </p:nvCxnSpPr>
        <p:spPr>
          <a:xfrm>
            <a:off x="5597599" y="1579944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C2669E5D-32DE-52F5-23D0-BDA82A2939EB}"/>
              </a:ext>
            </a:extLst>
          </p:cNvPr>
          <p:cNvCxnSpPr/>
          <p:nvPr/>
        </p:nvCxnSpPr>
        <p:spPr>
          <a:xfrm>
            <a:off x="6768571" y="3814665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C10C5C62-71B7-7463-4A91-FFF88D4A2373}"/>
              </a:ext>
            </a:extLst>
          </p:cNvPr>
          <p:cNvCxnSpPr/>
          <p:nvPr/>
        </p:nvCxnSpPr>
        <p:spPr>
          <a:xfrm>
            <a:off x="2348210" y="1539432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27E92E11-D752-4206-2C40-CF237BEB9920}"/>
              </a:ext>
            </a:extLst>
          </p:cNvPr>
          <p:cNvCxnSpPr/>
          <p:nvPr/>
        </p:nvCxnSpPr>
        <p:spPr>
          <a:xfrm>
            <a:off x="2694282" y="2944897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16EBB680-E7C5-B4F8-DDB6-B39644C3DECF}"/>
              </a:ext>
            </a:extLst>
          </p:cNvPr>
          <p:cNvCxnSpPr/>
          <p:nvPr/>
        </p:nvCxnSpPr>
        <p:spPr>
          <a:xfrm>
            <a:off x="7879741" y="5150732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6">
            <a:extLst>
              <a:ext uri="{FF2B5EF4-FFF2-40B4-BE49-F238E27FC236}">
                <a16:creationId xmlns:a16="http://schemas.microsoft.com/office/drawing/2014/main" id="{526F8041-E242-C593-4E01-44D2A8EFF802}"/>
              </a:ext>
            </a:extLst>
          </p:cNvPr>
          <p:cNvCxnSpPr>
            <a:cxnSpLocks/>
          </p:cNvCxnSpPr>
          <p:nvPr/>
        </p:nvCxnSpPr>
        <p:spPr>
          <a:xfrm flipH="1" flipV="1">
            <a:off x="8940300" y="5041433"/>
            <a:ext cx="1241192" cy="97250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6">
            <a:extLst>
              <a:ext uri="{FF2B5EF4-FFF2-40B4-BE49-F238E27FC236}">
                <a16:creationId xmlns:a16="http://schemas.microsoft.com/office/drawing/2014/main" id="{17B44379-B32F-D74B-3222-8AFCDFF615EE}"/>
              </a:ext>
            </a:extLst>
          </p:cNvPr>
          <p:cNvCxnSpPr>
            <a:cxnSpLocks/>
          </p:cNvCxnSpPr>
          <p:nvPr/>
        </p:nvCxnSpPr>
        <p:spPr>
          <a:xfrm flipH="1">
            <a:off x="9928571" y="4148039"/>
            <a:ext cx="419975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4" name="TekstSylinder 13">
            <a:extLst>
              <a:ext uri="{FF2B5EF4-FFF2-40B4-BE49-F238E27FC236}">
                <a16:creationId xmlns:a16="http://schemas.microsoft.com/office/drawing/2014/main" id="{740A6FD8-EA06-7921-7A0E-FBE1E374BC56}"/>
              </a:ext>
            </a:extLst>
          </p:cNvPr>
          <p:cNvSpPr txBox="1"/>
          <p:nvPr/>
        </p:nvSpPr>
        <p:spPr>
          <a:xfrm>
            <a:off x="10181492" y="5928193"/>
            <a:ext cx="1749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err="1"/>
              <a:t>Spermatozoa</a:t>
            </a:r>
            <a:endParaRPr lang="nb-NO" sz="1200"/>
          </a:p>
        </p:txBody>
      </p:sp>
      <p:sp>
        <p:nvSpPr>
          <p:cNvPr id="15" name="TekstSylinder 14">
            <a:extLst>
              <a:ext uri="{FF2B5EF4-FFF2-40B4-BE49-F238E27FC236}">
                <a16:creationId xmlns:a16="http://schemas.microsoft.com/office/drawing/2014/main" id="{16F94796-5AF2-C186-7C66-C6F986ADD5BE}"/>
              </a:ext>
            </a:extLst>
          </p:cNvPr>
          <p:cNvSpPr txBox="1"/>
          <p:nvPr/>
        </p:nvSpPr>
        <p:spPr>
          <a:xfrm>
            <a:off x="10348546" y="3917206"/>
            <a:ext cx="17496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/>
              <a:t>Not </a:t>
            </a:r>
            <a:r>
              <a:rPr lang="nb-NO" sz="1200" err="1"/>
              <a:t>scorable</a:t>
            </a:r>
            <a:r>
              <a:rPr lang="nb-NO" sz="1200"/>
              <a:t> </a:t>
            </a:r>
          </a:p>
          <a:p>
            <a:r>
              <a:rPr lang="nb-NO" sz="1200"/>
              <a:t>– image </a:t>
            </a:r>
            <a:r>
              <a:rPr lang="nb-NO" sz="1200" err="1"/>
              <a:t>edge</a:t>
            </a:r>
            <a:endParaRPr lang="nb-NO" sz="1200"/>
          </a:p>
        </p:txBody>
      </p:sp>
      <p:cxnSp>
        <p:nvCxnSpPr>
          <p:cNvPr id="16" name="Straight Arrow Connector 6">
            <a:extLst>
              <a:ext uri="{FF2B5EF4-FFF2-40B4-BE49-F238E27FC236}">
                <a16:creationId xmlns:a16="http://schemas.microsoft.com/office/drawing/2014/main" id="{8C96A97A-8D3A-1A16-E4EF-01D7C8179C01}"/>
              </a:ext>
            </a:extLst>
          </p:cNvPr>
          <p:cNvCxnSpPr>
            <a:cxnSpLocks/>
          </p:cNvCxnSpPr>
          <p:nvPr/>
        </p:nvCxnSpPr>
        <p:spPr>
          <a:xfrm flipH="1">
            <a:off x="4999573" y="1310105"/>
            <a:ext cx="4971152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8" name="TekstSylinder 17">
            <a:extLst>
              <a:ext uri="{FF2B5EF4-FFF2-40B4-BE49-F238E27FC236}">
                <a16:creationId xmlns:a16="http://schemas.microsoft.com/office/drawing/2014/main" id="{6181CBE9-64E5-EC95-EB22-A7372F312E84}"/>
              </a:ext>
            </a:extLst>
          </p:cNvPr>
          <p:cNvSpPr txBox="1"/>
          <p:nvPr/>
        </p:nvSpPr>
        <p:spPr>
          <a:xfrm>
            <a:off x="9928571" y="1164527"/>
            <a:ext cx="1749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err="1"/>
              <a:t>Spermatozoa</a:t>
            </a:r>
            <a:endParaRPr lang="nb-NO" sz="1200"/>
          </a:p>
        </p:txBody>
      </p:sp>
      <p:cxnSp>
        <p:nvCxnSpPr>
          <p:cNvPr id="20" name="Straight Arrow Connector 6">
            <a:extLst>
              <a:ext uri="{FF2B5EF4-FFF2-40B4-BE49-F238E27FC236}">
                <a16:creationId xmlns:a16="http://schemas.microsoft.com/office/drawing/2014/main" id="{D79DBA88-95E5-E49E-02E1-86EBAF53A24C}"/>
              </a:ext>
            </a:extLst>
          </p:cNvPr>
          <p:cNvCxnSpPr>
            <a:cxnSpLocks/>
          </p:cNvCxnSpPr>
          <p:nvPr/>
        </p:nvCxnSpPr>
        <p:spPr>
          <a:xfrm flipH="1">
            <a:off x="6749242" y="6119446"/>
            <a:ext cx="3432250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6">
            <a:extLst>
              <a:ext uri="{FF2B5EF4-FFF2-40B4-BE49-F238E27FC236}">
                <a16:creationId xmlns:a16="http://schemas.microsoft.com/office/drawing/2014/main" id="{8181860C-191B-BFC4-1D28-F69769EDA43A}"/>
              </a:ext>
            </a:extLst>
          </p:cNvPr>
          <p:cNvCxnSpPr>
            <a:cxnSpLocks/>
          </p:cNvCxnSpPr>
          <p:nvPr/>
        </p:nvCxnSpPr>
        <p:spPr>
          <a:xfrm flipH="1" flipV="1">
            <a:off x="9733085" y="1960685"/>
            <a:ext cx="615461" cy="2097048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7" name="TekstSylinder 26">
            <a:extLst>
              <a:ext uri="{FF2B5EF4-FFF2-40B4-BE49-F238E27FC236}">
                <a16:creationId xmlns:a16="http://schemas.microsoft.com/office/drawing/2014/main" id="{E060D945-FC2C-C391-3732-D463AE3B742F}"/>
              </a:ext>
            </a:extLst>
          </p:cNvPr>
          <p:cNvSpPr txBox="1"/>
          <p:nvPr/>
        </p:nvSpPr>
        <p:spPr>
          <a:xfrm>
            <a:off x="114300" y="2233246"/>
            <a:ext cx="174966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>
                <a:solidFill>
                  <a:srgbClr val="00B050"/>
                </a:solidFill>
              </a:rPr>
              <a:t>Green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 = </a:t>
            </a:r>
            <a:r>
              <a:rPr lang="nb-NO" err="1"/>
              <a:t>scored</a:t>
            </a:r>
            <a:endParaRPr lang="nb-NO"/>
          </a:p>
          <a:p>
            <a:endParaRPr lang="nb-NO"/>
          </a:p>
          <a:p>
            <a:r>
              <a:rPr lang="nb-NO">
                <a:solidFill>
                  <a:srgbClr val="FF0000"/>
                </a:solidFill>
              </a:rPr>
              <a:t>Red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= not </a:t>
            </a:r>
            <a:r>
              <a:rPr lang="nb-NO" err="1"/>
              <a:t>scored</a:t>
            </a:r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807946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2C84C151-CBD3-5CF4-021B-B2C0E7F40DAA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3600"/>
              <a:t>All round nucleoids (</a:t>
            </a:r>
            <a:r>
              <a:rPr lang="nb-NO" sz="3600" err="1"/>
              <a:t>treated</a:t>
            </a:r>
            <a:r>
              <a:rPr lang="nb-NO" sz="3600"/>
              <a:t>)</a:t>
            </a:r>
            <a:r>
              <a:rPr lang="en-US" sz="3600"/>
              <a:t>, low damage (~20 % TI)</a:t>
            </a:r>
            <a:endParaRPr lang="en-GB" sz="3600"/>
          </a:p>
        </p:txBody>
      </p:sp>
      <p:pic>
        <p:nvPicPr>
          <p:cNvPr id="2" name="Picture 1" descr="A group of bright lights in the sky&#10;&#10;Description automatically generated">
            <a:extLst>
              <a:ext uri="{FF2B5EF4-FFF2-40B4-BE49-F238E27FC236}">
                <a16:creationId xmlns:a16="http://schemas.microsoft.com/office/drawing/2014/main" id="{4B6AEE55-85B2-9BE1-2B17-E6A430E6E99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7155" y="958049"/>
            <a:ext cx="7727702" cy="5760000"/>
          </a:xfrm>
          <a:prstGeom prst="rect">
            <a:avLst/>
          </a:prstGeom>
        </p:spPr>
      </p:pic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25A747DD-12FC-19F6-B0E9-FD4EEEC8C121}"/>
              </a:ext>
            </a:extLst>
          </p:cNvPr>
          <p:cNvCxnSpPr/>
          <p:nvPr/>
        </p:nvCxnSpPr>
        <p:spPr>
          <a:xfrm>
            <a:off x="3548880" y="3824046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6CBCCB34-8185-1576-0503-79CEF9808F06}"/>
              </a:ext>
            </a:extLst>
          </p:cNvPr>
          <p:cNvCxnSpPr/>
          <p:nvPr/>
        </p:nvCxnSpPr>
        <p:spPr>
          <a:xfrm>
            <a:off x="3774094" y="2142259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826A6DAA-9F2F-6273-9CF1-592785134EEF}"/>
              </a:ext>
            </a:extLst>
          </p:cNvPr>
          <p:cNvCxnSpPr/>
          <p:nvPr/>
        </p:nvCxnSpPr>
        <p:spPr>
          <a:xfrm>
            <a:off x="7171756" y="3307466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A4E6092C-D08B-1CAF-F051-CE69E3205405}"/>
              </a:ext>
            </a:extLst>
          </p:cNvPr>
          <p:cNvCxnSpPr/>
          <p:nvPr/>
        </p:nvCxnSpPr>
        <p:spPr>
          <a:xfrm>
            <a:off x="8308004" y="5022448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5199E2EF-C57C-1126-1DCD-BDD83EFCADD5}"/>
              </a:ext>
            </a:extLst>
          </p:cNvPr>
          <p:cNvCxnSpPr/>
          <p:nvPr/>
        </p:nvCxnSpPr>
        <p:spPr>
          <a:xfrm>
            <a:off x="6001006" y="6110469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6">
            <a:extLst>
              <a:ext uri="{FF2B5EF4-FFF2-40B4-BE49-F238E27FC236}">
                <a16:creationId xmlns:a16="http://schemas.microsoft.com/office/drawing/2014/main" id="{2835CAA3-EFBD-07C7-3805-291D99A77ACC}"/>
              </a:ext>
            </a:extLst>
          </p:cNvPr>
          <p:cNvCxnSpPr>
            <a:cxnSpLocks/>
          </p:cNvCxnSpPr>
          <p:nvPr/>
        </p:nvCxnSpPr>
        <p:spPr>
          <a:xfrm flipH="1">
            <a:off x="2470358" y="1450054"/>
            <a:ext cx="7458213" cy="69220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4" name="TekstSylinder 13">
            <a:extLst>
              <a:ext uri="{FF2B5EF4-FFF2-40B4-BE49-F238E27FC236}">
                <a16:creationId xmlns:a16="http://schemas.microsoft.com/office/drawing/2014/main" id="{F68CCA7B-57F7-6C8C-19D9-00635EB0CAED}"/>
              </a:ext>
            </a:extLst>
          </p:cNvPr>
          <p:cNvSpPr txBox="1"/>
          <p:nvPr/>
        </p:nvSpPr>
        <p:spPr>
          <a:xfrm>
            <a:off x="10080971" y="1316927"/>
            <a:ext cx="1749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err="1"/>
              <a:t>Spermatozoa</a:t>
            </a:r>
            <a:endParaRPr lang="nb-NO" sz="1200"/>
          </a:p>
        </p:txBody>
      </p:sp>
      <p:cxnSp>
        <p:nvCxnSpPr>
          <p:cNvPr id="15" name="Straight Arrow Connector 6">
            <a:extLst>
              <a:ext uri="{FF2B5EF4-FFF2-40B4-BE49-F238E27FC236}">
                <a16:creationId xmlns:a16="http://schemas.microsoft.com/office/drawing/2014/main" id="{E565092D-B126-42FC-5044-6EB372148E62}"/>
              </a:ext>
            </a:extLst>
          </p:cNvPr>
          <p:cNvCxnSpPr>
            <a:cxnSpLocks/>
          </p:cNvCxnSpPr>
          <p:nvPr/>
        </p:nvCxnSpPr>
        <p:spPr>
          <a:xfrm flipH="1">
            <a:off x="8833131" y="1638715"/>
            <a:ext cx="1131485" cy="133319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6">
            <a:extLst>
              <a:ext uri="{FF2B5EF4-FFF2-40B4-BE49-F238E27FC236}">
                <a16:creationId xmlns:a16="http://schemas.microsoft.com/office/drawing/2014/main" id="{35AA4A48-A578-B8F7-3D0C-FEF6C1D316CF}"/>
              </a:ext>
            </a:extLst>
          </p:cNvPr>
          <p:cNvCxnSpPr>
            <a:cxnSpLocks/>
          </p:cNvCxnSpPr>
          <p:nvPr/>
        </p:nvCxnSpPr>
        <p:spPr>
          <a:xfrm flipH="1">
            <a:off x="5591619" y="1564681"/>
            <a:ext cx="4372997" cy="717142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0" name="TekstSylinder 19">
            <a:extLst>
              <a:ext uri="{FF2B5EF4-FFF2-40B4-BE49-F238E27FC236}">
                <a16:creationId xmlns:a16="http://schemas.microsoft.com/office/drawing/2014/main" id="{EEE44A4D-EAFF-DF24-0FBD-7CB229353D24}"/>
              </a:ext>
            </a:extLst>
          </p:cNvPr>
          <p:cNvSpPr txBox="1"/>
          <p:nvPr/>
        </p:nvSpPr>
        <p:spPr>
          <a:xfrm>
            <a:off x="8332367" y="474632"/>
            <a:ext cx="1749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err="1"/>
              <a:t>Spermatozoa</a:t>
            </a:r>
            <a:endParaRPr lang="nb-NO" sz="1200"/>
          </a:p>
        </p:txBody>
      </p:sp>
      <p:cxnSp>
        <p:nvCxnSpPr>
          <p:cNvPr id="21" name="Straight Arrow Connector 6">
            <a:extLst>
              <a:ext uri="{FF2B5EF4-FFF2-40B4-BE49-F238E27FC236}">
                <a16:creationId xmlns:a16="http://schemas.microsoft.com/office/drawing/2014/main" id="{32E47DD6-E701-4BEF-81F6-C1EEEC8C33CA}"/>
              </a:ext>
            </a:extLst>
          </p:cNvPr>
          <p:cNvCxnSpPr>
            <a:cxnSpLocks/>
          </p:cNvCxnSpPr>
          <p:nvPr/>
        </p:nvCxnSpPr>
        <p:spPr>
          <a:xfrm flipH="1" flipV="1">
            <a:off x="8136881" y="1270790"/>
            <a:ext cx="1829883" cy="4613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6">
            <a:extLst>
              <a:ext uri="{FF2B5EF4-FFF2-40B4-BE49-F238E27FC236}">
                <a16:creationId xmlns:a16="http://schemas.microsoft.com/office/drawing/2014/main" id="{464FCEC5-9637-2ABD-99A8-6F358AFFBFEE}"/>
              </a:ext>
            </a:extLst>
          </p:cNvPr>
          <p:cNvCxnSpPr>
            <a:cxnSpLocks/>
          </p:cNvCxnSpPr>
          <p:nvPr/>
        </p:nvCxnSpPr>
        <p:spPr>
          <a:xfrm>
            <a:off x="2137155" y="6112061"/>
            <a:ext cx="3471072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9" name="TekstSylinder 28">
            <a:extLst>
              <a:ext uri="{FF2B5EF4-FFF2-40B4-BE49-F238E27FC236}">
                <a16:creationId xmlns:a16="http://schemas.microsoft.com/office/drawing/2014/main" id="{B3286F22-1409-262E-A2FD-DA23856F4CC5}"/>
              </a:ext>
            </a:extLst>
          </p:cNvPr>
          <p:cNvSpPr txBox="1"/>
          <p:nvPr/>
        </p:nvSpPr>
        <p:spPr>
          <a:xfrm>
            <a:off x="1046206" y="5955004"/>
            <a:ext cx="1749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err="1"/>
              <a:t>Spermatozoa</a:t>
            </a:r>
            <a:endParaRPr lang="nb-NO" sz="1200"/>
          </a:p>
        </p:txBody>
      </p:sp>
      <p:cxnSp>
        <p:nvCxnSpPr>
          <p:cNvPr id="30" name="Straight Arrow Connector 3">
            <a:extLst>
              <a:ext uri="{FF2B5EF4-FFF2-40B4-BE49-F238E27FC236}">
                <a16:creationId xmlns:a16="http://schemas.microsoft.com/office/drawing/2014/main" id="{6ACE0CB0-D694-467F-39CD-DBCCB45DA053}"/>
              </a:ext>
            </a:extLst>
          </p:cNvPr>
          <p:cNvCxnSpPr/>
          <p:nvPr/>
        </p:nvCxnSpPr>
        <p:spPr>
          <a:xfrm>
            <a:off x="5058989" y="3594981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31" name="TekstSylinder 30">
            <a:extLst>
              <a:ext uri="{FF2B5EF4-FFF2-40B4-BE49-F238E27FC236}">
                <a16:creationId xmlns:a16="http://schemas.microsoft.com/office/drawing/2014/main" id="{EABD1E2E-8F16-449E-F8D5-FA1B5BE082C0}"/>
              </a:ext>
            </a:extLst>
          </p:cNvPr>
          <p:cNvSpPr txBox="1"/>
          <p:nvPr/>
        </p:nvSpPr>
        <p:spPr>
          <a:xfrm>
            <a:off x="114300" y="2233246"/>
            <a:ext cx="174966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>
                <a:solidFill>
                  <a:srgbClr val="00B050"/>
                </a:solidFill>
              </a:rPr>
              <a:t>Green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 = </a:t>
            </a:r>
            <a:r>
              <a:rPr lang="nb-NO" err="1"/>
              <a:t>scored</a:t>
            </a:r>
            <a:endParaRPr lang="nb-NO"/>
          </a:p>
          <a:p>
            <a:endParaRPr lang="nb-NO"/>
          </a:p>
          <a:p>
            <a:r>
              <a:rPr lang="nb-NO">
                <a:solidFill>
                  <a:srgbClr val="FF0000"/>
                </a:solidFill>
              </a:rPr>
              <a:t>Red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= not </a:t>
            </a:r>
            <a:r>
              <a:rPr lang="nb-NO" err="1"/>
              <a:t>scored</a:t>
            </a:r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620404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white lights in the sky&#10;&#10;Description automatically generated">
            <a:extLst>
              <a:ext uri="{FF2B5EF4-FFF2-40B4-BE49-F238E27FC236}">
                <a16:creationId xmlns:a16="http://schemas.microsoft.com/office/drawing/2014/main" id="{B9AA0672-07E9-7BA5-8320-9C3D9634DC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9912" y="934445"/>
            <a:ext cx="7727701" cy="5760000"/>
          </a:xfrm>
          <a:prstGeom prst="rect">
            <a:avLst/>
          </a:prstGeom>
        </p:spPr>
      </p:pic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F232B626-AE71-9336-0CAD-A4AD5BE34A4C}"/>
              </a:ext>
            </a:extLst>
          </p:cNvPr>
          <p:cNvCxnSpPr/>
          <p:nvPr/>
        </p:nvCxnSpPr>
        <p:spPr>
          <a:xfrm>
            <a:off x="6569872" y="3307466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42267BB1-D40D-0A74-AA32-2FAD1B2E8EF5}"/>
              </a:ext>
            </a:extLst>
          </p:cNvPr>
          <p:cNvCxnSpPr/>
          <p:nvPr/>
        </p:nvCxnSpPr>
        <p:spPr>
          <a:xfrm>
            <a:off x="7824204" y="1530121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4B228ADC-FACE-B002-0148-85626EAA4D93}"/>
              </a:ext>
            </a:extLst>
          </p:cNvPr>
          <p:cNvCxnSpPr/>
          <p:nvPr/>
        </p:nvCxnSpPr>
        <p:spPr>
          <a:xfrm>
            <a:off x="5622129" y="3429000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8B7FFCBF-A590-E8F8-B6B8-63ED05B5DFDC}"/>
              </a:ext>
            </a:extLst>
          </p:cNvPr>
          <p:cNvCxnSpPr/>
          <p:nvPr/>
        </p:nvCxnSpPr>
        <p:spPr>
          <a:xfrm>
            <a:off x="3724281" y="2928284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9" name="Title 1">
            <a:extLst>
              <a:ext uri="{FF2B5EF4-FFF2-40B4-BE49-F238E27FC236}">
                <a16:creationId xmlns:a16="http://schemas.microsoft.com/office/drawing/2014/main" id="{4A4AC419-7889-2E82-D27C-1359813FF55B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3600"/>
              <a:t>All round nucleoids (</a:t>
            </a:r>
            <a:r>
              <a:rPr lang="nb-NO" sz="3600" err="1"/>
              <a:t>treated</a:t>
            </a:r>
            <a:r>
              <a:rPr lang="nb-NO" sz="3600"/>
              <a:t>)</a:t>
            </a:r>
            <a:r>
              <a:rPr lang="en-US" sz="3600"/>
              <a:t>, low damage (~20 % TI)</a:t>
            </a:r>
            <a:endParaRPr lang="en-GB" sz="3600"/>
          </a:p>
        </p:txBody>
      </p:sp>
      <p:sp>
        <p:nvSpPr>
          <p:cNvPr id="11" name="TekstSylinder 10">
            <a:extLst>
              <a:ext uri="{FF2B5EF4-FFF2-40B4-BE49-F238E27FC236}">
                <a16:creationId xmlns:a16="http://schemas.microsoft.com/office/drawing/2014/main" id="{F15659B0-C9EB-78FB-FF0A-8B7859570E41}"/>
              </a:ext>
            </a:extLst>
          </p:cNvPr>
          <p:cNvSpPr txBox="1"/>
          <p:nvPr/>
        </p:nvSpPr>
        <p:spPr>
          <a:xfrm>
            <a:off x="10037613" y="2302103"/>
            <a:ext cx="1749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err="1"/>
              <a:t>Spermatozoa</a:t>
            </a:r>
            <a:endParaRPr lang="nb-NO" sz="1200"/>
          </a:p>
        </p:txBody>
      </p:sp>
      <p:sp>
        <p:nvSpPr>
          <p:cNvPr id="12" name="TekstSylinder 11">
            <a:extLst>
              <a:ext uri="{FF2B5EF4-FFF2-40B4-BE49-F238E27FC236}">
                <a16:creationId xmlns:a16="http://schemas.microsoft.com/office/drawing/2014/main" id="{4CC747DD-078C-27CF-E22E-618A92C41BC6}"/>
              </a:ext>
            </a:extLst>
          </p:cNvPr>
          <p:cNvSpPr txBox="1"/>
          <p:nvPr/>
        </p:nvSpPr>
        <p:spPr>
          <a:xfrm>
            <a:off x="989134" y="6232780"/>
            <a:ext cx="17496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/>
              <a:t>Not </a:t>
            </a:r>
            <a:r>
              <a:rPr lang="nb-NO" sz="1200" err="1"/>
              <a:t>scorable</a:t>
            </a:r>
            <a:r>
              <a:rPr lang="nb-NO" sz="1200"/>
              <a:t> </a:t>
            </a:r>
          </a:p>
          <a:p>
            <a:r>
              <a:rPr lang="nb-NO" sz="1200"/>
              <a:t>– image </a:t>
            </a:r>
            <a:r>
              <a:rPr lang="nb-NO" sz="1200" err="1"/>
              <a:t>edge</a:t>
            </a:r>
            <a:endParaRPr lang="nb-NO" sz="1200"/>
          </a:p>
        </p:txBody>
      </p:sp>
      <p:cxnSp>
        <p:nvCxnSpPr>
          <p:cNvPr id="13" name="Straight Arrow Connector 6">
            <a:extLst>
              <a:ext uri="{FF2B5EF4-FFF2-40B4-BE49-F238E27FC236}">
                <a16:creationId xmlns:a16="http://schemas.microsoft.com/office/drawing/2014/main" id="{8EEDB214-7959-CC6F-80C4-6A70DE040F60}"/>
              </a:ext>
            </a:extLst>
          </p:cNvPr>
          <p:cNvCxnSpPr>
            <a:cxnSpLocks/>
            <a:stCxn id="11" idx="1"/>
          </p:cNvCxnSpPr>
          <p:nvPr/>
        </p:nvCxnSpPr>
        <p:spPr>
          <a:xfrm flipH="1">
            <a:off x="8414238" y="2440603"/>
            <a:ext cx="1623375" cy="170743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4" name="TekstSylinder 13">
            <a:extLst>
              <a:ext uri="{FF2B5EF4-FFF2-40B4-BE49-F238E27FC236}">
                <a16:creationId xmlns:a16="http://schemas.microsoft.com/office/drawing/2014/main" id="{31205C76-D215-4096-3E5E-CA4E75335B37}"/>
              </a:ext>
            </a:extLst>
          </p:cNvPr>
          <p:cNvSpPr txBox="1"/>
          <p:nvPr/>
        </p:nvSpPr>
        <p:spPr>
          <a:xfrm>
            <a:off x="114300" y="2233246"/>
            <a:ext cx="174966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>
                <a:solidFill>
                  <a:srgbClr val="00B050"/>
                </a:solidFill>
              </a:rPr>
              <a:t>Green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 = </a:t>
            </a:r>
            <a:r>
              <a:rPr lang="nb-NO" err="1"/>
              <a:t>scored</a:t>
            </a:r>
            <a:endParaRPr lang="nb-NO"/>
          </a:p>
          <a:p>
            <a:endParaRPr lang="nb-NO"/>
          </a:p>
          <a:p>
            <a:r>
              <a:rPr lang="nb-NO">
                <a:solidFill>
                  <a:srgbClr val="FF0000"/>
                </a:solidFill>
              </a:rPr>
              <a:t>Red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= not </a:t>
            </a:r>
            <a:r>
              <a:rPr lang="nb-NO" err="1"/>
              <a:t>scored</a:t>
            </a:r>
            <a:endParaRPr lang="nb-NO"/>
          </a:p>
        </p:txBody>
      </p:sp>
      <p:cxnSp>
        <p:nvCxnSpPr>
          <p:cNvPr id="17" name="Straight Arrow Connector 6">
            <a:extLst>
              <a:ext uri="{FF2B5EF4-FFF2-40B4-BE49-F238E27FC236}">
                <a16:creationId xmlns:a16="http://schemas.microsoft.com/office/drawing/2014/main" id="{9A9C0B94-BA4E-8532-E880-01877B874BE1}"/>
              </a:ext>
            </a:extLst>
          </p:cNvPr>
          <p:cNvCxnSpPr>
            <a:cxnSpLocks/>
            <a:stCxn id="11" idx="1"/>
          </p:cNvCxnSpPr>
          <p:nvPr/>
        </p:nvCxnSpPr>
        <p:spPr>
          <a:xfrm flipH="1" flipV="1">
            <a:off x="3934396" y="2130199"/>
            <a:ext cx="6103217" cy="310404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6">
            <a:extLst>
              <a:ext uri="{FF2B5EF4-FFF2-40B4-BE49-F238E27FC236}">
                <a16:creationId xmlns:a16="http://schemas.microsoft.com/office/drawing/2014/main" id="{05B972C7-2BE0-2855-76AD-0EF71D348A02}"/>
              </a:ext>
            </a:extLst>
          </p:cNvPr>
          <p:cNvCxnSpPr>
            <a:cxnSpLocks/>
          </p:cNvCxnSpPr>
          <p:nvPr/>
        </p:nvCxnSpPr>
        <p:spPr>
          <a:xfrm>
            <a:off x="2083777" y="6507309"/>
            <a:ext cx="927200" cy="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8" name="TekstSylinder 27">
            <a:extLst>
              <a:ext uri="{FF2B5EF4-FFF2-40B4-BE49-F238E27FC236}">
                <a16:creationId xmlns:a16="http://schemas.microsoft.com/office/drawing/2014/main" id="{1732C616-2F55-A0AC-7913-43DAF30A71D3}"/>
              </a:ext>
            </a:extLst>
          </p:cNvPr>
          <p:cNvSpPr txBox="1"/>
          <p:nvPr/>
        </p:nvSpPr>
        <p:spPr>
          <a:xfrm>
            <a:off x="10127021" y="4843698"/>
            <a:ext cx="174966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err="1"/>
              <a:t>Elongating</a:t>
            </a:r>
            <a:r>
              <a:rPr lang="nb-NO" sz="1200"/>
              <a:t>/</a:t>
            </a:r>
            <a:r>
              <a:rPr lang="nb-NO" sz="1200" err="1"/>
              <a:t>elongated</a:t>
            </a:r>
            <a:r>
              <a:rPr lang="nb-NO" sz="1200"/>
              <a:t> </a:t>
            </a:r>
            <a:r>
              <a:rPr lang="nb-NO" sz="1200" err="1"/>
              <a:t>spermatid</a:t>
            </a:r>
            <a:endParaRPr lang="nb-NO" sz="1200"/>
          </a:p>
          <a:p>
            <a:r>
              <a:rPr lang="nb-NO" sz="1200" err="1"/>
              <a:t>Condensation</a:t>
            </a:r>
            <a:r>
              <a:rPr lang="nb-NO" sz="1200"/>
              <a:t> </a:t>
            </a:r>
            <a:r>
              <a:rPr lang="nb-NO" sz="1200" err="1"/>
              <a:t>of</a:t>
            </a:r>
            <a:r>
              <a:rPr lang="nb-NO" sz="1200"/>
              <a:t> DNA in </a:t>
            </a:r>
            <a:r>
              <a:rPr lang="nb-NO" sz="1200" err="1"/>
              <a:t>one</a:t>
            </a:r>
            <a:r>
              <a:rPr lang="nb-NO" sz="1200"/>
              <a:t> </a:t>
            </a:r>
            <a:r>
              <a:rPr lang="nb-NO" sz="1200" err="1"/>
              <a:t>direction</a:t>
            </a:r>
            <a:endParaRPr lang="nb-NO" sz="1200"/>
          </a:p>
        </p:txBody>
      </p:sp>
      <p:cxnSp>
        <p:nvCxnSpPr>
          <p:cNvPr id="29" name="Straight Arrow Connector 6">
            <a:extLst>
              <a:ext uri="{FF2B5EF4-FFF2-40B4-BE49-F238E27FC236}">
                <a16:creationId xmlns:a16="http://schemas.microsoft.com/office/drawing/2014/main" id="{1C5E15BF-FD1F-9492-20CD-8FCFD8C7CD2B}"/>
              </a:ext>
            </a:extLst>
          </p:cNvPr>
          <p:cNvCxnSpPr>
            <a:cxnSpLocks/>
          </p:cNvCxnSpPr>
          <p:nvPr/>
        </p:nvCxnSpPr>
        <p:spPr>
          <a:xfrm flipH="1" flipV="1">
            <a:off x="4923692" y="4325815"/>
            <a:ext cx="5020408" cy="83527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5">
            <a:extLst>
              <a:ext uri="{FF2B5EF4-FFF2-40B4-BE49-F238E27FC236}">
                <a16:creationId xmlns:a16="http://schemas.microsoft.com/office/drawing/2014/main" id="{2EFFED49-350B-0922-8128-17F631DC4EEE}"/>
              </a:ext>
            </a:extLst>
          </p:cNvPr>
          <p:cNvCxnSpPr/>
          <p:nvPr/>
        </p:nvCxnSpPr>
        <p:spPr>
          <a:xfrm>
            <a:off x="9225925" y="5431627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867889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oup of white dots on a black background&#10;&#10;Description automatically generated">
            <a:extLst>
              <a:ext uri="{FF2B5EF4-FFF2-40B4-BE49-F238E27FC236}">
                <a16:creationId xmlns:a16="http://schemas.microsoft.com/office/drawing/2014/main" id="{B471BEA3-40A4-D260-3169-EBA7DF82A0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2364" y="885262"/>
            <a:ext cx="7727701" cy="5760000"/>
          </a:xfrm>
          <a:prstGeom prst="rect">
            <a:avLst/>
          </a:prstGeom>
        </p:spPr>
      </p:pic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63D1A29E-8D25-3523-F210-CD46BD9C0027}"/>
              </a:ext>
            </a:extLst>
          </p:cNvPr>
          <p:cNvCxnSpPr/>
          <p:nvPr/>
        </p:nvCxnSpPr>
        <p:spPr>
          <a:xfrm>
            <a:off x="2414308" y="1159260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19AF75ED-6B27-BC1E-C49B-E971ED291B82}"/>
              </a:ext>
            </a:extLst>
          </p:cNvPr>
          <p:cNvCxnSpPr/>
          <p:nvPr/>
        </p:nvCxnSpPr>
        <p:spPr>
          <a:xfrm>
            <a:off x="7176468" y="2238490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B9AEA240-5DD1-6705-5C51-21326417623A}"/>
              </a:ext>
            </a:extLst>
          </p:cNvPr>
          <p:cNvCxnSpPr/>
          <p:nvPr/>
        </p:nvCxnSpPr>
        <p:spPr>
          <a:xfrm>
            <a:off x="3309670" y="3307466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03E839F1-6F7B-4EA1-DC56-94733D6B8574}"/>
              </a:ext>
            </a:extLst>
          </p:cNvPr>
          <p:cNvCxnSpPr/>
          <p:nvPr/>
        </p:nvCxnSpPr>
        <p:spPr>
          <a:xfrm>
            <a:off x="5751075" y="3567844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D47CD758-E68A-E4CE-B789-63F0C79A3AEC}"/>
              </a:ext>
            </a:extLst>
          </p:cNvPr>
          <p:cNvCxnSpPr/>
          <p:nvPr/>
        </p:nvCxnSpPr>
        <p:spPr>
          <a:xfrm>
            <a:off x="3786161" y="5729670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6BBA8295-39CF-0950-03AC-21302CE02649}"/>
              </a:ext>
            </a:extLst>
          </p:cNvPr>
          <p:cNvCxnSpPr>
            <a:cxnSpLocks/>
          </p:cNvCxnSpPr>
          <p:nvPr/>
        </p:nvCxnSpPr>
        <p:spPr>
          <a:xfrm>
            <a:off x="7576179" y="3307466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D6B546CB-1F8F-4898-822C-9B0F7D3A17C9}"/>
              </a:ext>
            </a:extLst>
          </p:cNvPr>
          <p:cNvCxnSpPr/>
          <p:nvPr/>
        </p:nvCxnSpPr>
        <p:spPr>
          <a:xfrm>
            <a:off x="8521097" y="3567844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FA93A584-3EB3-3D7F-1781-DE0C651DF55B}"/>
              </a:ext>
            </a:extLst>
          </p:cNvPr>
          <p:cNvCxnSpPr/>
          <p:nvPr/>
        </p:nvCxnSpPr>
        <p:spPr>
          <a:xfrm>
            <a:off x="7477794" y="5228010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0" name="Title 1">
            <a:extLst>
              <a:ext uri="{FF2B5EF4-FFF2-40B4-BE49-F238E27FC236}">
                <a16:creationId xmlns:a16="http://schemas.microsoft.com/office/drawing/2014/main" id="{C2FF1584-BB45-C738-08B6-F64052D10D19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3600"/>
              <a:t>All round nucleoids (</a:t>
            </a:r>
            <a:r>
              <a:rPr lang="nb-NO" sz="3600" err="1"/>
              <a:t>treated</a:t>
            </a:r>
            <a:r>
              <a:rPr lang="nb-NO" sz="3600"/>
              <a:t>)</a:t>
            </a:r>
            <a:r>
              <a:rPr lang="en-US" sz="3600"/>
              <a:t>, low damage (~60 % TI)</a:t>
            </a:r>
            <a:endParaRPr lang="en-GB" sz="3600"/>
          </a:p>
        </p:txBody>
      </p:sp>
      <p:sp>
        <p:nvSpPr>
          <p:cNvPr id="13" name="TekstSylinder 12">
            <a:extLst>
              <a:ext uri="{FF2B5EF4-FFF2-40B4-BE49-F238E27FC236}">
                <a16:creationId xmlns:a16="http://schemas.microsoft.com/office/drawing/2014/main" id="{2CD14473-3AC9-FF2A-F838-6044A2C8CD95}"/>
              </a:ext>
            </a:extLst>
          </p:cNvPr>
          <p:cNvSpPr txBox="1"/>
          <p:nvPr/>
        </p:nvSpPr>
        <p:spPr>
          <a:xfrm>
            <a:off x="114300" y="2233246"/>
            <a:ext cx="174966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>
                <a:solidFill>
                  <a:srgbClr val="00B050"/>
                </a:solidFill>
              </a:rPr>
              <a:t>Green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 = </a:t>
            </a:r>
            <a:r>
              <a:rPr lang="nb-NO" err="1"/>
              <a:t>scored</a:t>
            </a:r>
            <a:endParaRPr lang="nb-NO"/>
          </a:p>
          <a:p>
            <a:endParaRPr lang="nb-NO"/>
          </a:p>
          <a:p>
            <a:r>
              <a:rPr lang="nb-NO">
                <a:solidFill>
                  <a:srgbClr val="FF0000"/>
                </a:solidFill>
              </a:rPr>
              <a:t>Red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= not </a:t>
            </a:r>
            <a:r>
              <a:rPr lang="nb-NO" err="1"/>
              <a:t>scored</a:t>
            </a:r>
            <a:endParaRPr lang="nb-NO"/>
          </a:p>
        </p:txBody>
      </p:sp>
      <p:sp>
        <p:nvSpPr>
          <p:cNvPr id="14" name="TekstSylinder 13">
            <a:extLst>
              <a:ext uri="{FF2B5EF4-FFF2-40B4-BE49-F238E27FC236}">
                <a16:creationId xmlns:a16="http://schemas.microsoft.com/office/drawing/2014/main" id="{D1E7810B-8B51-35C4-A8D4-4BD06AD60525}"/>
              </a:ext>
            </a:extLst>
          </p:cNvPr>
          <p:cNvSpPr txBox="1"/>
          <p:nvPr/>
        </p:nvSpPr>
        <p:spPr>
          <a:xfrm>
            <a:off x="1240969" y="3926810"/>
            <a:ext cx="1749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err="1"/>
              <a:t>Spermatozoa</a:t>
            </a:r>
            <a:endParaRPr lang="nb-NO" sz="1200"/>
          </a:p>
        </p:txBody>
      </p:sp>
      <p:cxnSp>
        <p:nvCxnSpPr>
          <p:cNvPr id="15" name="Straight Arrow Connector 6">
            <a:extLst>
              <a:ext uri="{FF2B5EF4-FFF2-40B4-BE49-F238E27FC236}">
                <a16:creationId xmlns:a16="http://schemas.microsoft.com/office/drawing/2014/main" id="{99D295D9-73EF-8F87-2E96-BC8B1F87698A}"/>
              </a:ext>
            </a:extLst>
          </p:cNvPr>
          <p:cNvCxnSpPr>
            <a:cxnSpLocks/>
          </p:cNvCxnSpPr>
          <p:nvPr/>
        </p:nvCxnSpPr>
        <p:spPr>
          <a:xfrm flipV="1">
            <a:off x="2322364" y="1402327"/>
            <a:ext cx="1557665" cy="269342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8" name="TekstSylinder 17">
            <a:extLst>
              <a:ext uri="{FF2B5EF4-FFF2-40B4-BE49-F238E27FC236}">
                <a16:creationId xmlns:a16="http://schemas.microsoft.com/office/drawing/2014/main" id="{A13B7EE5-9C59-F6FF-1306-E4941B9175EF}"/>
              </a:ext>
            </a:extLst>
          </p:cNvPr>
          <p:cNvSpPr txBox="1"/>
          <p:nvPr/>
        </p:nvSpPr>
        <p:spPr>
          <a:xfrm>
            <a:off x="742509" y="4707529"/>
            <a:ext cx="174966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err="1"/>
              <a:t>Elongating</a:t>
            </a:r>
            <a:r>
              <a:rPr lang="nb-NO" sz="1200"/>
              <a:t>/</a:t>
            </a:r>
            <a:r>
              <a:rPr lang="nb-NO" sz="1200" err="1"/>
              <a:t>elongated</a:t>
            </a:r>
            <a:r>
              <a:rPr lang="nb-NO" sz="1200"/>
              <a:t> </a:t>
            </a:r>
            <a:r>
              <a:rPr lang="nb-NO" sz="1200" err="1"/>
              <a:t>spermatid</a:t>
            </a:r>
            <a:endParaRPr lang="nb-NO" sz="1200"/>
          </a:p>
          <a:p>
            <a:r>
              <a:rPr lang="nb-NO" sz="1200" err="1"/>
              <a:t>Condensation</a:t>
            </a:r>
            <a:r>
              <a:rPr lang="nb-NO" sz="1200"/>
              <a:t> </a:t>
            </a:r>
            <a:r>
              <a:rPr lang="nb-NO" sz="1200" err="1"/>
              <a:t>of</a:t>
            </a:r>
            <a:r>
              <a:rPr lang="nb-NO" sz="1200"/>
              <a:t> DNA in </a:t>
            </a:r>
            <a:r>
              <a:rPr lang="nb-NO" sz="1200" err="1"/>
              <a:t>one</a:t>
            </a:r>
            <a:r>
              <a:rPr lang="nb-NO" sz="1200"/>
              <a:t> </a:t>
            </a:r>
            <a:r>
              <a:rPr lang="nb-NO" sz="1200" err="1"/>
              <a:t>direction</a:t>
            </a:r>
            <a:endParaRPr lang="nb-NO" sz="1200"/>
          </a:p>
        </p:txBody>
      </p:sp>
      <p:cxnSp>
        <p:nvCxnSpPr>
          <p:cNvPr id="19" name="Straight Arrow Connector 6">
            <a:extLst>
              <a:ext uri="{FF2B5EF4-FFF2-40B4-BE49-F238E27FC236}">
                <a16:creationId xmlns:a16="http://schemas.microsoft.com/office/drawing/2014/main" id="{EF087DE5-52DA-9F4C-CE81-A20E63B08016}"/>
              </a:ext>
            </a:extLst>
          </p:cNvPr>
          <p:cNvCxnSpPr>
            <a:cxnSpLocks/>
          </p:cNvCxnSpPr>
          <p:nvPr/>
        </p:nvCxnSpPr>
        <p:spPr>
          <a:xfrm flipV="1">
            <a:off x="2322364" y="4742819"/>
            <a:ext cx="2114858" cy="41910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">
            <a:extLst>
              <a:ext uri="{FF2B5EF4-FFF2-40B4-BE49-F238E27FC236}">
                <a16:creationId xmlns:a16="http://schemas.microsoft.com/office/drawing/2014/main" id="{FFE3FF29-CFAD-9AA6-1EB2-A854AD34335A}"/>
              </a:ext>
            </a:extLst>
          </p:cNvPr>
          <p:cNvCxnSpPr/>
          <p:nvPr/>
        </p:nvCxnSpPr>
        <p:spPr>
          <a:xfrm>
            <a:off x="3183024" y="930044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6">
            <a:extLst>
              <a:ext uri="{FF2B5EF4-FFF2-40B4-BE49-F238E27FC236}">
                <a16:creationId xmlns:a16="http://schemas.microsoft.com/office/drawing/2014/main" id="{A836B1C6-26D8-40DC-903D-7D37F92501AA}"/>
              </a:ext>
            </a:extLst>
          </p:cNvPr>
          <p:cNvCxnSpPr>
            <a:cxnSpLocks/>
          </p:cNvCxnSpPr>
          <p:nvPr/>
        </p:nvCxnSpPr>
        <p:spPr>
          <a:xfrm flipV="1">
            <a:off x="2322364" y="1631543"/>
            <a:ext cx="4854104" cy="351988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417409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oup of ovals in a black background&#10;&#10;Description automatically generated">
            <a:extLst>
              <a:ext uri="{FF2B5EF4-FFF2-40B4-BE49-F238E27FC236}">
                <a16:creationId xmlns:a16="http://schemas.microsoft.com/office/drawing/2014/main" id="{119A14BE-7F68-17CC-A711-4B8FE157B2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2149" y="951664"/>
            <a:ext cx="7727701" cy="5760000"/>
          </a:xfrm>
          <a:prstGeom prst="rect">
            <a:avLst/>
          </a:prstGeom>
        </p:spPr>
      </p:pic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C6EE94CF-728C-0F4C-7142-3EC7A776D448}"/>
              </a:ext>
            </a:extLst>
          </p:cNvPr>
          <p:cNvCxnSpPr/>
          <p:nvPr/>
        </p:nvCxnSpPr>
        <p:spPr>
          <a:xfrm>
            <a:off x="3279063" y="4054034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572D39FE-C43A-B9FB-2478-FD9A2394FF96}"/>
              </a:ext>
            </a:extLst>
          </p:cNvPr>
          <p:cNvCxnSpPr/>
          <p:nvPr/>
        </p:nvCxnSpPr>
        <p:spPr>
          <a:xfrm>
            <a:off x="5780679" y="3307466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49A9DD30-C1E5-B3CA-C8BE-D4B11376D84F}"/>
              </a:ext>
            </a:extLst>
          </p:cNvPr>
          <p:cNvCxnSpPr/>
          <p:nvPr/>
        </p:nvCxnSpPr>
        <p:spPr>
          <a:xfrm>
            <a:off x="2530416" y="5159415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5B813329-D45D-44DD-04F5-2FAFD8091CA4}"/>
              </a:ext>
            </a:extLst>
          </p:cNvPr>
          <p:cNvCxnSpPr/>
          <p:nvPr/>
        </p:nvCxnSpPr>
        <p:spPr>
          <a:xfrm>
            <a:off x="2432031" y="4297102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04053D32-A876-05F2-E433-A68B0FC544A1}"/>
              </a:ext>
            </a:extLst>
          </p:cNvPr>
          <p:cNvCxnSpPr/>
          <p:nvPr/>
        </p:nvCxnSpPr>
        <p:spPr>
          <a:xfrm>
            <a:off x="7106611" y="3932500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B16901BA-ABB6-7BFD-1845-44B1BC4D5D76}"/>
              </a:ext>
            </a:extLst>
          </p:cNvPr>
          <p:cNvCxnSpPr/>
          <p:nvPr/>
        </p:nvCxnSpPr>
        <p:spPr>
          <a:xfrm>
            <a:off x="7685346" y="2801661"/>
            <a:ext cx="196769" cy="243068"/>
          </a:xfrm>
          <a:prstGeom prst="straightConnector1">
            <a:avLst/>
          </a:prstGeom>
          <a:ln w="38100">
            <a:solidFill>
              <a:srgbClr val="00B05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0" name="Title 1">
            <a:extLst>
              <a:ext uri="{FF2B5EF4-FFF2-40B4-BE49-F238E27FC236}">
                <a16:creationId xmlns:a16="http://schemas.microsoft.com/office/drawing/2014/main" id="{624902DE-CB30-2CA3-9CAA-C8DD6F11DD5F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3600"/>
              <a:t>All round nucleoids (</a:t>
            </a:r>
            <a:r>
              <a:rPr lang="nb-NO" sz="3600" err="1"/>
              <a:t>treated</a:t>
            </a:r>
            <a:r>
              <a:rPr lang="nb-NO" sz="3600"/>
              <a:t>)</a:t>
            </a:r>
            <a:r>
              <a:rPr lang="en-US" sz="3600"/>
              <a:t>, low damage (~60 % TI)</a:t>
            </a:r>
            <a:endParaRPr lang="en-GB" sz="3600"/>
          </a:p>
        </p:txBody>
      </p:sp>
      <p:sp>
        <p:nvSpPr>
          <p:cNvPr id="11" name="TekstSylinder 10">
            <a:extLst>
              <a:ext uri="{FF2B5EF4-FFF2-40B4-BE49-F238E27FC236}">
                <a16:creationId xmlns:a16="http://schemas.microsoft.com/office/drawing/2014/main" id="{570485B7-A055-091F-55AC-AD4B5B4FFCAE}"/>
              </a:ext>
            </a:extLst>
          </p:cNvPr>
          <p:cNvSpPr txBox="1"/>
          <p:nvPr/>
        </p:nvSpPr>
        <p:spPr>
          <a:xfrm>
            <a:off x="114300" y="2233246"/>
            <a:ext cx="174966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>
                <a:solidFill>
                  <a:srgbClr val="00B050"/>
                </a:solidFill>
              </a:rPr>
              <a:t>Green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 = </a:t>
            </a:r>
            <a:r>
              <a:rPr lang="nb-NO" err="1"/>
              <a:t>scored</a:t>
            </a:r>
            <a:endParaRPr lang="nb-NO"/>
          </a:p>
          <a:p>
            <a:endParaRPr lang="nb-NO"/>
          </a:p>
          <a:p>
            <a:r>
              <a:rPr lang="nb-NO">
                <a:solidFill>
                  <a:srgbClr val="FF0000"/>
                </a:solidFill>
              </a:rPr>
              <a:t>Red</a:t>
            </a:r>
            <a:r>
              <a:rPr lang="nb-NO"/>
              <a:t> </a:t>
            </a:r>
            <a:r>
              <a:rPr lang="nb-NO" err="1"/>
              <a:t>arrow</a:t>
            </a:r>
            <a:r>
              <a:rPr lang="nb-NO"/>
              <a:t>= not </a:t>
            </a:r>
            <a:r>
              <a:rPr lang="nb-NO" err="1"/>
              <a:t>scored</a:t>
            </a:r>
            <a:endParaRPr lang="nb-NO"/>
          </a:p>
        </p:txBody>
      </p:sp>
      <p:sp>
        <p:nvSpPr>
          <p:cNvPr id="12" name="TekstSylinder 11">
            <a:extLst>
              <a:ext uri="{FF2B5EF4-FFF2-40B4-BE49-F238E27FC236}">
                <a16:creationId xmlns:a16="http://schemas.microsoft.com/office/drawing/2014/main" id="{A71572DA-6238-0223-1760-46E720FAAE9F}"/>
              </a:ext>
            </a:extLst>
          </p:cNvPr>
          <p:cNvSpPr txBox="1"/>
          <p:nvPr/>
        </p:nvSpPr>
        <p:spPr>
          <a:xfrm>
            <a:off x="1240969" y="3926810"/>
            <a:ext cx="1749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err="1"/>
              <a:t>Spermatozoa</a:t>
            </a:r>
            <a:endParaRPr lang="nb-NO" sz="1200"/>
          </a:p>
        </p:txBody>
      </p:sp>
      <p:cxnSp>
        <p:nvCxnSpPr>
          <p:cNvPr id="13" name="Straight Arrow Connector 6">
            <a:extLst>
              <a:ext uri="{FF2B5EF4-FFF2-40B4-BE49-F238E27FC236}">
                <a16:creationId xmlns:a16="http://schemas.microsoft.com/office/drawing/2014/main" id="{7B8FF335-6F50-019A-BE95-8351BAEA8ACB}"/>
              </a:ext>
            </a:extLst>
          </p:cNvPr>
          <p:cNvCxnSpPr>
            <a:cxnSpLocks/>
          </p:cNvCxnSpPr>
          <p:nvPr/>
        </p:nvCxnSpPr>
        <p:spPr>
          <a:xfrm flipV="1">
            <a:off x="2230897" y="3166718"/>
            <a:ext cx="91467" cy="94182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6">
            <a:extLst>
              <a:ext uri="{FF2B5EF4-FFF2-40B4-BE49-F238E27FC236}">
                <a16:creationId xmlns:a16="http://schemas.microsoft.com/office/drawing/2014/main" id="{43B08221-405B-1AAA-00DB-B03BBAA5BC4F}"/>
              </a:ext>
            </a:extLst>
          </p:cNvPr>
          <p:cNvCxnSpPr>
            <a:cxnSpLocks/>
          </p:cNvCxnSpPr>
          <p:nvPr/>
        </p:nvCxnSpPr>
        <p:spPr>
          <a:xfrm flipV="1">
            <a:off x="2230897" y="1562784"/>
            <a:ext cx="1625736" cy="250252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6">
            <a:extLst>
              <a:ext uri="{FF2B5EF4-FFF2-40B4-BE49-F238E27FC236}">
                <a16:creationId xmlns:a16="http://schemas.microsoft.com/office/drawing/2014/main" id="{7D72F2F9-C5E1-25F5-AEEA-9BBD9B0B992E}"/>
              </a:ext>
            </a:extLst>
          </p:cNvPr>
          <p:cNvCxnSpPr>
            <a:cxnSpLocks/>
          </p:cNvCxnSpPr>
          <p:nvPr/>
        </p:nvCxnSpPr>
        <p:spPr>
          <a:xfrm flipV="1">
            <a:off x="2208216" y="1688123"/>
            <a:ext cx="2386924" cy="2420415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6">
            <a:extLst>
              <a:ext uri="{FF2B5EF4-FFF2-40B4-BE49-F238E27FC236}">
                <a16:creationId xmlns:a16="http://schemas.microsoft.com/office/drawing/2014/main" id="{F348DD65-8632-0F0D-2C43-8E3D78AE99E8}"/>
              </a:ext>
            </a:extLst>
          </p:cNvPr>
          <p:cNvCxnSpPr>
            <a:cxnSpLocks/>
          </p:cNvCxnSpPr>
          <p:nvPr/>
        </p:nvCxnSpPr>
        <p:spPr>
          <a:xfrm flipV="1">
            <a:off x="2230897" y="3783790"/>
            <a:ext cx="637521" cy="32268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3537810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8">
            <a:extLst>
              <a:ext uri="{FF2B5EF4-FFF2-40B4-BE49-F238E27FC236}">
                <a16:creationId xmlns:a16="http://schemas.microsoft.com/office/drawing/2014/main" id="{1E473976-37DD-73A6-C305-A08443EFA22A}"/>
              </a:ext>
            </a:extLst>
          </p:cNvPr>
          <p:cNvSpPr txBox="1"/>
          <p:nvPr/>
        </p:nvSpPr>
        <p:spPr>
          <a:xfrm>
            <a:off x="1881094" y="961265"/>
            <a:ext cx="3060970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/>
              <a:t>Untreated</a:t>
            </a:r>
            <a:endParaRPr lang="en-US"/>
          </a:p>
        </p:txBody>
      </p:sp>
      <p:pic>
        <p:nvPicPr>
          <p:cNvPr id="18" name="Picture 17" descr="A group of white dots in the sky with Gallery Arcturus in the background&#10;&#10;Description automatically generated">
            <a:extLst>
              <a:ext uri="{FF2B5EF4-FFF2-40B4-BE49-F238E27FC236}">
                <a16:creationId xmlns:a16="http://schemas.microsoft.com/office/drawing/2014/main" id="{E188B93C-8639-C203-22E8-813D7E69E2C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4573" y="1303499"/>
            <a:ext cx="3371209" cy="2512800"/>
          </a:xfrm>
          <a:prstGeom prst="rect">
            <a:avLst/>
          </a:prstGeom>
        </p:spPr>
      </p:pic>
      <p:pic>
        <p:nvPicPr>
          <p:cNvPr id="39" name="Picture 38" descr="A group of bright lights in the sky&#10;&#10;Description automatically generated">
            <a:extLst>
              <a:ext uri="{FF2B5EF4-FFF2-40B4-BE49-F238E27FC236}">
                <a16:creationId xmlns:a16="http://schemas.microsoft.com/office/drawing/2014/main" id="{8AE92749-A7B0-923A-9A1F-F602FFB7296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0394" y="1312355"/>
            <a:ext cx="3371212" cy="2512802"/>
          </a:xfrm>
          <a:prstGeom prst="rect">
            <a:avLst/>
          </a:prstGeom>
        </p:spPr>
      </p:pic>
      <p:pic>
        <p:nvPicPr>
          <p:cNvPr id="45" name="Picture 44" descr="A group of white ovals in the dark&#10;&#10;Description automatically generated">
            <a:extLst>
              <a:ext uri="{FF2B5EF4-FFF2-40B4-BE49-F238E27FC236}">
                <a16:creationId xmlns:a16="http://schemas.microsoft.com/office/drawing/2014/main" id="{550BA22F-EB1B-179D-B689-96A1BED9A6B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6217" y="4150115"/>
            <a:ext cx="3371209" cy="2512799"/>
          </a:xfrm>
          <a:prstGeom prst="rect">
            <a:avLst/>
          </a:prstGeom>
        </p:spPr>
      </p:pic>
      <p:pic>
        <p:nvPicPr>
          <p:cNvPr id="63" name="Picture 62" descr="A group of white lights in a black background&#10;&#10;Description automatically generated">
            <a:extLst>
              <a:ext uri="{FF2B5EF4-FFF2-40B4-BE49-F238E27FC236}">
                <a16:creationId xmlns:a16="http://schemas.microsoft.com/office/drawing/2014/main" id="{26C553A4-39C3-B683-43A8-AAFAFA7534D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0394" y="4150112"/>
            <a:ext cx="3371212" cy="2512802"/>
          </a:xfrm>
          <a:prstGeom prst="rect">
            <a:avLst/>
          </a:prstGeom>
        </p:spPr>
      </p:pic>
      <p:pic>
        <p:nvPicPr>
          <p:cNvPr id="65" name="Picture 64" descr="A group of white ovals in a black background&#10;&#10;Description automatically generated">
            <a:extLst>
              <a:ext uri="{FF2B5EF4-FFF2-40B4-BE49-F238E27FC236}">
                <a16:creationId xmlns:a16="http://schemas.microsoft.com/office/drawing/2014/main" id="{7BD70376-81BE-9EE6-EFBE-681C78819EB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6217" y="1344189"/>
            <a:ext cx="3371209" cy="2512800"/>
          </a:xfrm>
          <a:prstGeom prst="rect">
            <a:avLst/>
          </a:prstGeom>
        </p:spPr>
      </p:pic>
      <p:pic>
        <p:nvPicPr>
          <p:cNvPr id="2" name="Picture 1" descr="A group of white dots in the sky&#10;&#10;Description automatically generated">
            <a:extLst>
              <a:ext uri="{FF2B5EF4-FFF2-40B4-BE49-F238E27FC236}">
                <a16:creationId xmlns:a16="http://schemas.microsoft.com/office/drawing/2014/main" id="{81BC95FC-534C-FD01-FA1B-9F61FC40072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4573" y="4134186"/>
            <a:ext cx="3371209" cy="2512799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id="{60C9ED75-5526-F871-634C-4AFC160FC079}"/>
              </a:ext>
            </a:extLst>
          </p:cNvPr>
          <p:cNvSpPr>
            <a:spLocks noGrp="1"/>
          </p:cNvSpPr>
          <p:nvPr/>
        </p:nvSpPr>
        <p:spPr>
          <a:xfrm>
            <a:off x="694756" y="-103726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 err="1"/>
              <a:t>Primary</a:t>
            </a:r>
            <a:r>
              <a:rPr lang="nb-NO" sz="4000"/>
              <a:t> </a:t>
            </a:r>
            <a:r>
              <a:rPr lang="nb-NO" sz="4000" err="1"/>
              <a:t>spermatocytes</a:t>
            </a:r>
            <a:r>
              <a:rPr lang="nb-NO" sz="4000"/>
              <a:t> (PS)(</a:t>
            </a:r>
            <a:r>
              <a:rPr lang="nb-NO" sz="4000" err="1"/>
              <a:t>untreated</a:t>
            </a:r>
            <a:r>
              <a:rPr lang="nb-NO" sz="4000"/>
              <a:t>, </a:t>
            </a:r>
            <a:r>
              <a:rPr lang="nb-NO" sz="4000" err="1"/>
              <a:t>treated</a:t>
            </a:r>
            <a:r>
              <a:rPr lang="nb-NO" sz="4000"/>
              <a:t>)  </a:t>
            </a:r>
          </a:p>
          <a:p>
            <a:r>
              <a:rPr lang="nb-NO" sz="2800" err="1"/>
              <a:t>Overview</a:t>
            </a:r>
            <a:r>
              <a:rPr lang="nb-NO" sz="2800"/>
              <a:t>, </a:t>
            </a:r>
            <a:r>
              <a:rPr lang="nb-NO" sz="2800" err="1"/>
              <a:t>each</a:t>
            </a:r>
            <a:r>
              <a:rPr lang="nb-NO" sz="2800"/>
              <a:t> image is </a:t>
            </a:r>
            <a:r>
              <a:rPr lang="nb-NO" sz="2800" err="1"/>
              <a:t>displayed</a:t>
            </a:r>
            <a:r>
              <a:rPr lang="nb-NO" sz="2800"/>
              <a:t> in separate slides </a:t>
            </a:r>
            <a:r>
              <a:rPr lang="nb-NO" sz="2800" err="1"/>
              <a:t>below</a:t>
            </a:r>
            <a:endParaRPr lang="en-GB" sz="2800"/>
          </a:p>
        </p:txBody>
      </p:sp>
      <p:sp>
        <p:nvSpPr>
          <p:cNvPr id="7" name="TextBox 3">
            <a:extLst>
              <a:ext uri="{FF2B5EF4-FFF2-40B4-BE49-F238E27FC236}">
                <a16:creationId xmlns:a16="http://schemas.microsoft.com/office/drawing/2014/main" id="{2082B54C-974C-B8DD-C0C2-86BCB12BDB40}"/>
              </a:ext>
            </a:extLst>
          </p:cNvPr>
          <p:cNvSpPr txBox="1"/>
          <p:nvPr/>
        </p:nvSpPr>
        <p:spPr>
          <a:xfrm>
            <a:off x="4435557" y="965332"/>
            <a:ext cx="351213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/>
              <a:t>Treated, low damage (~20 % TI)</a:t>
            </a:r>
            <a:endParaRPr lang="en-US"/>
          </a:p>
        </p:txBody>
      </p:sp>
      <p:sp>
        <p:nvSpPr>
          <p:cNvPr id="8" name="TextBox 3">
            <a:extLst>
              <a:ext uri="{FF2B5EF4-FFF2-40B4-BE49-F238E27FC236}">
                <a16:creationId xmlns:a16="http://schemas.microsoft.com/office/drawing/2014/main" id="{D5B1E0FA-FDB3-BA54-9B0D-107641607020}"/>
              </a:ext>
            </a:extLst>
          </p:cNvPr>
          <p:cNvSpPr txBox="1"/>
          <p:nvPr/>
        </p:nvSpPr>
        <p:spPr>
          <a:xfrm>
            <a:off x="7985113" y="969666"/>
            <a:ext cx="351213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/>
              <a:t>Treated, high damage ( ~60 % TI)</a:t>
            </a:r>
            <a:endParaRPr lang="en-US"/>
          </a:p>
        </p:txBody>
      </p:sp>
      <p:sp>
        <p:nvSpPr>
          <p:cNvPr id="9" name="Rektangel 8">
            <a:extLst>
              <a:ext uri="{FF2B5EF4-FFF2-40B4-BE49-F238E27FC236}">
                <a16:creationId xmlns:a16="http://schemas.microsoft.com/office/drawing/2014/main" id="{E0937644-BCE8-290B-19D3-4F32566054DC}"/>
              </a:ext>
            </a:extLst>
          </p:cNvPr>
          <p:cNvSpPr/>
          <p:nvPr/>
        </p:nvSpPr>
        <p:spPr>
          <a:xfrm>
            <a:off x="672818" y="1018330"/>
            <a:ext cx="3534069" cy="567731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0" name="Rektangel 9">
            <a:extLst>
              <a:ext uri="{FF2B5EF4-FFF2-40B4-BE49-F238E27FC236}">
                <a16:creationId xmlns:a16="http://schemas.microsoft.com/office/drawing/2014/main" id="{DFACFA11-CFC5-F062-8D06-30B1AF853E13}"/>
              </a:ext>
            </a:extLst>
          </p:cNvPr>
          <p:cNvSpPr/>
          <p:nvPr/>
        </p:nvSpPr>
        <p:spPr>
          <a:xfrm>
            <a:off x="4308738" y="1018330"/>
            <a:ext cx="3534069" cy="567731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" name="Rektangel 10">
            <a:extLst>
              <a:ext uri="{FF2B5EF4-FFF2-40B4-BE49-F238E27FC236}">
                <a16:creationId xmlns:a16="http://schemas.microsoft.com/office/drawing/2014/main" id="{0E84237E-2E15-7AE9-1D85-A654314886FF}"/>
              </a:ext>
            </a:extLst>
          </p:cNvPr>
          <p:cNvSpPr/>
          <p:nvPr/>
        </p:nvSpPr>
        <p:spPr>
          <a:xfrm>
            <a:off x="8010276" y="1018330"/>
            <a:ext cx="3534069" cy="567731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04879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2</Words>
  <Application>Microsoft Office PowerPoint</Application>
  <PresentationFormat>Widescreen</PresentationFormat>
  <Paragraphs>74</Paragraphs>
  <Slides>15</Slides>
  <Notes>2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5</vt:i4>
      </vt:variant>
    </vt:vector>
  </HeadingPairs>
  <TitlesOfParts>
    <vt:vector size="19" baseType="lpstr">
      <vt:lpstr>Aptos</vt:lpstr>
      <vt:lpstr>Aptos Display</vt:lpstr>
      <vt:lpstr>Arial</vt:lpstr>
      <vt:lpstr>Office Theme</vt:lpstr>
      <vt:lpstr>Training to select which testicular comets to score - with results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ongying Zheng</dc:creator>
  <cp:lastModifiedBy>Ann-Karin Hardie Olsen</cp:lastModifiedBy>
  <cp:revision>1</cp:revision>
  <dcterms:created xsi:type="dcterms:W3CDTF">2024-09-10T16:37:13Z</dcterms:created>
  <dcterms:modified xsi:type="dcterms:W3CDTF">2024-12-22T09:07:14Z</dcterms:modified>
</cp:coreProperties>
</file>